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9144000" cy="6858000" type="screen4x3"/>
  <p:notesSz cx="6864350" cy="999648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54351" autoAdjust="0"/>
  </p:normalViewPr>
  <p:slideViewPr>
    <p:cSldViewPr>
      <p:cViewPr varScale="1">
        <p:scale>
          <a:sx n="45" d="100"/>
          <a:sy n="45" d="100"/>
        </p:scale>
        <p:origin x="-1650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24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4552" cy="499824"/>
          </a:xfrm>
          <a:prstGeom prst="rect">
            <a:avLst/>
          </a:prstGeom>
        </p:spPr>
        <p:txBody>
          <a:bodyPr vert="horz" lIns="96341" tIns="48171" rIns="96341" bIns="48171" rtlCol="0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8210" y="0"/>
            <a:ext cx="2974552" cy="499824"/>
          </a:xfrm>
          <a:prstGeom prst="rect">
            <a:avLst/>
          </a:prstGeom>
        </p:spPr>
        <p:txBody>
          <a:bodyPr vert="horz" lIns="96341" tIns="48171" rIns="96341" bIns="48171" rtlCol="0"/>
          <a:lstStyle>
            <a:lvl1pPr algn="r">
              <a:defRPr sz="1300"/>
            </a:lvl1pPr>
          </a:lstStyle>
          <a:p>
            <a:fld id="{1E76C440-4AF6-427F-9ED0-892C622C3835}" type="datetimeFigureOut">
              <a:rPr lang="en-GB" smtClean="0"/>
              <a:t>08/05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33450" y="749300"/>
            <a:ext cx="4997450" cy="37496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341" tIns="48171" rIns="96341" bIns="48171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6435" y="4748332"/>
            <a:ext cx="5491480" cy="4498420"/>
          </a:xfrm>
          <a:prstGeom prst="rect">
            <a:avLst/>
          </a:prstGeom>
        </p:spPr>
        <p:txBody>
          <a:bodyPr vert="horz" lIns="96341" tIns="48171" rIns="96341" bIns="48171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94929"/>
            <a:ext cx="2974552" cy="499824"/>
          </a:xfrm>
          <a:prstGeom prst="rect">
            <a:avLst/>
          </a:prstGeom>
        </p:spPr>
        <p:txBody>
          <a:bodyPr vert="horz" lIns="96341" tIns="48171" rIns="96341" bIns="48171" rtlCol="0" anchor="b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8210" y="9494929"/>
            <a:ext cx="2974552" cy="499824"/>
          </a:xfrm>
          <a:prstGeom prst="rect">
            <a:avLst/>
          </a:prstGeom>
        </p:spPr>
        <p:txBody>
          <a:bodyPr vert="horz" lIns="96341" tIns="48171" rIns="96341" bIns="48171" rtlCol="0" anchor="b"/>
          <a:lstStyle>
            <a:lvl1pPr algn="r">
              <a:defRPr sz="1300"/>
            </a:lvl1pPr>
          </a:lstStyle>
          <a:p>
            <a:fld id="{B4B4170D-CA64-4317-901C-67BAA808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08363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3" Type="http://schemas.openxmlformats.org/officeDocument/2006/relationships/hyperlink" Target="#_ENREF_16"/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Relationship Id="rId4" Type="http://schemas.openxmlformats.org/officeDocument/2006/relationships/hyperlink" Target="#_ENREF_47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6. Schematic diagram to compare conventional 4C (A) and q4C (B) protocol. </a:t>
            </a:r>
          </a:p>
          <a:p>
            <a:r>
              <a:rPr lang="en-GB" sz="1200" b="0" i="0" u="none" strike="noStrike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fter digesting the </a:t>
            </a:r>
            <a:r>
              <a:rPr lang="en-GB" sz="1200" b="0" i="0" u="none" strike="noStrike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crosslinked</a:t>
            </a:r>
            <a:r>
              <a:rPr lang="en-GB" sz="1200" b="0" i="0" u="none" strike="noStrike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chromatins with the first restriction enzyme (1st RE) and ligating the free ends, the DNA was digested by a secondary restriction enzyme (2</a:t>
            </a:r>
            <a:r>
              <a:rPr lang="en-GB" sz="1200" b="0" i="0" u="none" strike="noStrike" kern="1200" baseline="300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nd</a:t>
            </a:r>
            <a:r>
              <a:rPr lang="en-GB" sz="1200" b="0" i="0" u="none" strike="noStrike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RE) followed by </a:t>
            </a:r>
            <a:r>
              <a:rPr lang="en-GB" sz="1200" b="0" i="0" u="none" strike="noStrike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religation</a:t>
            </a:r>
            <a:r>
              <a:rPr lang="en-GB" sz="1200" b="0" i="0" u="none" strike="noStrike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n-GB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inverse PCR to amplify viewpoint</a:t>
            </a:r>
            <a:r>
              <a:rPr lang="en-GB" sz="1200" b="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VP) </a:t>
            </a:r>
            <a:r>
              <a:rPr lang="en-GB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linked genomic regions in conventional 4C. In q4C, we modified</a:t>
            </a:r>
            <a:r>
              <a:rPr lang="en-GB" sz="1200" b="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he 4C protocol by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[</a:t>
            </a:r>
            <a:r>
              <a:rPr lang="en-GB" sz="120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3" action="ppaction://hlinkfile" tooltip="van de Werken, 2012 #2090"/>
              </a:rPr>
              <a:t>16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] by</a:t>
            </a:r>
            <a:r>
              <a:rPr lang="en-GB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pplying our LM-PCR protocol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[</a:t>
            </a:r>
            <a:r>
              <a:rPr lang="en-GB" sz="120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4" action="ppaction://hlinkfile" tooltip="Gillet, 2011 #2046"/>
              </a:rPr>
              <a:t>47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] for</a:t>
            </a:r>
            <a:r>
              <a:rPr lang="en-GB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terming</a:t>
            </a:r>
            <a:r>
              <a:rPr lang="en-GB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viral</a:t>
            </a:r>
            <a:r>
              <a:rPr lang="en-GB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tegration sites. I</a:t>
            </a:r>
            <a:r>
              <a:rPr lang="en-GB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stead of the</a:t>
            </a:r>
            <a:r>
              <a:rPr lang="en-GB" sz="1200" b="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econdary</a:t>
            </a:r>
            <a:r>
              <a:rPr lang="en-GB" sz="1200" b="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estriction enzyme, sonication is used to process DNA circles. Linkers with a 6bp specific tag was added to </a:t>
            </a:r>
            <a:r>
              <a:rPr lang="en-GB" sz="1200" b="0" i="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onicated</a:t>
            </a:r>
            <a:r>
              <a:rPr lang="en-GB" sz="1200" b="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NA. </a:t>
            </a:r>
            <a:r>
              <a:rPr lang="en-GB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end of the VP and a fragment of genomic DNA were amplified by LM-PCR. </a:t>
            </a:r>
          </a:p>
          <a:p>
            <a:endParaRPr lang="en-GB" sz="1200" b="0" i="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GB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 this example, 3 ligation events occurred between the VP (red) and a genomic</a:t>
            </a:r>
            <a:r>
              <a:rPr lang="en-GB" sz="1200" b="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egion (green) at the ligation site I and one event at the ligation site II (yellow). </a:t>
            </a:r>
            <a:r>
              <a:rPr lang="en-GB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ecause the DNA shear site is random, the </a:t>
            </a:r>
            <a:r>
              <a:rPr lang="en-GB" sz="1200" b="0" i="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mplicon</a:t>
            </a:r>
            <a:r>
              <a:rPr lang="en-GB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rom each cell has a different shear site. The abundance of each unique</a:t>
            </a:r>
            <a:r>
              <a:rPr lang="en-GB" sz="1200" b="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ligation site </a:t>
            </a:r>
            <a:r>
              <a:rPr lang="en-GB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s quantified by counting the number of different shear sites for quantify the frequency</a:t>
            </a:r>
            <a:r>
              <a:rPr lang="en-GB" sz="1200" b="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 ligation events.</a:t>
            </a:r>
            <a:endParaRPr lang="en-GB" sz="1200" b="0" i="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GB" sz="1200" b="0" i="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4B4170D-CA64-4317-901C-67BAA808401C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37191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6BCE3-EB08-4A2E-9D0B-64A71647254B}" type="datetimeFigureOut">
              <a:rPr lang="en-GB" smtClean="0"/>
              <a:t>08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7850C-1F8C-4F11-A3DF-0F198F04E6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74518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6BCE3-EB08-4A2E-9D0B-64A71647254B}" type="datetimeFigureOut">
              <a:rPr lang="en-GB" smtClean="0"/>
              <a:t>08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7850C-1F8C-4F11-A3DF-0F198F04E6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3246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6BCE3-EB08-4A2E-9D0B-64A71647254B}" type="datetimeFigureOut">
              <a:rPr lang="en-GB" smtClean="0"/>
              <a:t>08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7850C-1F8C-4F11-A3DF-0F198F04E6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9136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6BCE3-EB08-4A2E-9D0B-64A71647254B}" type="datetimeFigureOut">
              <a:rPr lang="en-GB" smtClean="0"/>
              <a:t>08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7850C-1F8C-4F11-A3DF-0F198F04E6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39703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6BCE3-EB08-4A2E-9D0B-64A71647254B}" type="datetimeFigureOut">
              <a:rPr lang="en-GB" smtClean="0"/>
              <a:t>08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7850C-1F8C-4F11-A3DF-0F198F04E6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4310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6BCE3-EB08-4A2E-9D0B-64A71647254B}" type="datetimeFigureOut">
              <a:rPr lang="en-GB" smtClean="0"/>
              <a:t>08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7850C-1F8C-4F11-A3DF-0F198F04E6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651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6BCE3-EB08-4A2E-9D0B-64A71647254B}" type="datetimeFigureOut">
              <a:rPr lang="en-GB" smtClean="0"/>
              <a:t>08/05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7850C-1F8C-4F11-A3DF-0F198F04E6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9839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6BCE3-EB08-4A2E-9D0B-64A71647254B}" type="datetimeFigureOut">
              <a:rPr lang="en-GB" smtClean="0"/>
              <a:t>08/05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7850C-1F8C-4F11-A3DF-0F198F04E6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91505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6BCE3-EB08-4A2E-9D0B-64A71647254B}" type="datetimeFigureOut">
              <a:rPr lang="en-GB" smtClean="0"/>
              <a:t>08/05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7850C-1F8C-4F11-A3DF-0F198F04E6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989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6BCE3-EB08-4A2E-9D0B-64A71647254B}" type="datetimeFigureOut">
              <a:rPr lang="en-GB" smtClean="0"/>
              <a:t>08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7850C-1F8C-4F11-A3DF-0F198F04E6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18446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6BCE3-EB08-4A2E-9D0B-64A71647254B}" type="datetimeFigureOut">
              <a:rPr lang="en-GB" smtClean="0"/>
              <a:t>08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7850C-1F8C-4F11-A3DF-0F198F04E6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79521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86BCE3-EB08-4A2E-9D0B-64A71647254B}" type="datetimeFigureOut">
              <a:rPr lang="en-GB" smtClean="0"/>
              <a:t>08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27850C-1F8C-4F11-A3DF-0F198F04E6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57209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Arc 95"/>
          <p:cNvSpPr/>
          <p:nvPr/>
        </p:nvSpPr>
        <p:spPr>
          <a:xfrm rot="10800000" flipV="1">
            <a:off x="2283648" y="622743"/>
            <a:ext cx="1910157" cy="453550"/>
          </a:xfrm>
          <a:prstGeom prst="arc">
            <a:avLst>
              <a:gd name="adj1" fmla="val 10618282"/>
              <a:gd name="adj2" fmla="val 36087"/>
            </a:avLst>
          </a:prstGeom>
          <a:noFill/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3200"/>
          </a:p>
        </p:txBody>
      </p:sp>
      <p:sp>
        <p:nvSpPr>
          <p:cNvPr id="255" name="Rectangle 97"/>
          <p:cNvSpPr>
            <a:spLocks noChangeArrowheads="1"/>
          </p:cNvSpPr>
          <p:nvPr/>
        </p:nvSpPr>
        <p:spPr bwMode="auto">
          <a:xfrm>
            <a:off x="7313758" y="1444458"/>
            <a:ext cx="1763688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kumimoji="0" lang="en-GB" altLang="ja-JP" sz="1400" b="1" dirty="0" smtClean="0">
                <a:latin typeface="Calibri" pitchFamily="127" charset="0"/>
              </a:rPr>
              <a:t>Ligation events counted</a:t>
            </a:r>
            <a:endParaRPr kumimoji="0" lang="en-GB" altLang="ja-JP" sz="1400" b="1" dirty="0">
              <a:latin typeface="Calibri" pitchFamily="127" charset="0"/>
            </a:endParaRPr>
          </a:p>
        </p:txBody>
      </p:sp>
      <p:sp>
        <p:nvSpPr>
          <p:cNvPr id="100" name="Arc 99"/>
          <p:cNvSpPr/>
          <p:nvPr/>
        </p:nvSpPr>
        <p:spPr>
          <a:xfrm>
            <a:off x="2247304" y="689425"/>
            <a:ext cx="983232" cy="407830"/>
          </a:xfrm>
          <a:prstGeom prst="arc">
            <a:avLst>
              <a:gd name="adj1" fmla="val 10618282"/>
              <a:gd name="adj2" fmla="val 0"/>
            </a:avLst>
          </a:prstGeom>
          <a:noFill/>
          <a:ln w="3810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2400"/>
          </a:p>
        </p:txBody>
      </p:sp>
      <p:sp>
        <p:nvSpPr>
          <p:cNvPr id="109" name="Title 1"/>
          <p:cNvSpPr txBox="1">
            <a:spLocks/>
          </p:cNvSpPr>
          <p:nvPr/>
        </p:nvSpPr>
        <p:spPr bwMode="auto">
          <a:xfrm>
            <a:off x="1785920" y="1097255"/>
            <a:ext cx="678085" cy="3374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rtl="0" fontAlgn="base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ＭＳ Ｐゴシック" pitchFamily="127" charset="-128"/>
                <a:cs typeface="ＭＳ Ｐゴシック" pitchFamily="127" charset="-128"/>
              </a:defRPr>
            </a:lvl1pPr>
            <a:lvl2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2pPr>
            <a:lvl3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3pPr>
            <a:lvl4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4pPr>
            <a:lvl5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5pPr>
            <a:lvl6pPr marL="4572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6pPr>
            <a:lvl7pPr marL="9144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7pPr>
            <a:lvl8pPr marL="13716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8pPr>
            <a:lvl9pPr marL="18288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9pPr>
          </a:lstStyle>
          <a:p>
            <a:r>
              <a:rPr kumimoji="0" lang="en-GB" sz="1600" b="1" dirty="0" smtClean="0">
                <a:solidFill>
                  <a:srgbClr val="FF0000"/>
                </a:solidFill>
                <a:latin typeface="+mn-lt"/>
              </a:rPr>
              <a:t>VP</a:t>
            </a:r>
            <a:endParaRPr kumimoji="0" lang="en-GB" sz="1600" b="1" dirty="0">
              <a:solidFill>
                <a:srgbClr val="FF0000"/>
              </a:solidFill>
              <a:latin typeface="+mn-lt"/>
            </a:endParaRPr>
          </a:p>
        </p:txBody>
      </p:sp>
      <p:sp>
        <p:nvSpPr>
          <p:cNvPr id="110" name="Rectangle 109"/>
          <p:cNvSpPr/>
          <p:nvPr/>
        </p:nvSpPr>
        <p:spPr>
          <a:xfrm>
            <a:off x="547868" y="950615"/>
            <a:ext cx="3733794" cy="83190"/>
          </a:xfrm>
          <a:prstGeom prst="rect">
            <a:avLst/>
          </a:prstGeom>
          <a:solidFill>
            <a:schemeClr val="bg2">
              <a:lumMod val="50000"/>
            </a:schemeClr>
          </a:solidFill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2400"/>
          </a:p>
        </p:txBody>
      </p:sp>
      <p:sp>
        <p:nvSpPr>
          <p:cNvPr id="111" name="Rectangle 110"/>
          <p:cNvSpPr/>
          <p:nvPr/>
        </p:nvSpPr>
        <p:spPr>
          <a:xfrm>
            <a:off x="2103683" y="949480"/>
            <a:ext cx="193011" cy="84325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2400" dirty="0"/>
          </a:p>
        </p:txBody>
      </p:sp>
      <p:sp>
        <p:nvSpPr>
          <p:cNvPr id="112" name="Rectangle 111"/>
          <p:cNvSpPr/>
          <p:nvPr/>
        </p:nvSpPr>
        <p:spPr>
          <a:xfrm>
            <a:off x="2992269" y="937605"/>
            <a:ext cx="364220" cy="84325"/>
          </a:xfrm>
          <a:prstGeom prst="rect">
            <a:avLst/>
          </a:prstGeom>
          <a:solidFill>
            <a:srgbClr val="92D050"/>
          </a:solidFill>
          <a:ln w="6350"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2400" dirty="0">
              <a:solidFill>
                <a:srgbClr val="FFC000"/>
              </a:solidFill>
            </a:endParaRPr>
          </a:p>
        </p:txBody>
      </p:sp>
      <p:sp>
        <p:nvSpPr>
          <p:cNvPr id="113" name="Rectangle 112"/>
          <p:cNvSpPr/>
          <p:nvPr/>
        </p:nvSpPr>
        <p:spPr>
          <a:xfrm>
            <a:off x="3906626" y="949480"/>
            <a:ext cx="279120" cy="84325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2400" dirty="0">
              <a:solidFill>
                <a:srgbClr val="FFC000"/>
              </a:solidFill>
            </a:endParaRPr>
          </a:p>
        </p:txBody>
      </p:sp>
      <p:cxnSp>
        <p:nvCxnSpPr>
          <p:cNvPr id="427" name="Straight Connector 426"/>
          <p:cNvCxnSpPr/>
          <p:nvPr/>
        </p:nvCxnSpPr>
        <p:spPr bwMode="auto">
          <a:xfrm>
            <a:off x="2988042" y="874867"/>
            <a:ext cx="0" cy="191918"/>
          </a:xfrm>
          <a:prstGeom prst="line">
            <a:avLst/>
          </a:prstGeom>
          <a:ln w="28575">
            <a:solidFill>
              <a:schemeClr val="bg2">
                <a:lumMod val="1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8" name="Title 1"/>
          <p:cNvSpPr txBox="1">
            <a:spLocks/>
          </p:cNvSpPr>
          <p:nvPr/>
        </p:nvSpPr>
        <p:spPr bwMode="auto">
          <a:xfrm>
            <a:off x="1336891" y="388318"/>
            <a:ext cx="1503410" cy="3374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rtl="0" fontAlgn="base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ＭＳ Ｐゴシック" pitchFamily="127" charset="-128"/>
                <a:cs typeface="ＭＳ Ｐゴシック" pitchFamily="127" charset="-128"/>
              </a:defRPr>
            </a:lvl1pPr>
            <a:lvl2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2pPr>
            <a:lvl3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3pPr>
            <a:lvl4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4pPr>
            <a:lvl5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5pPr>
            <a:lvl6pPr marL="4572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6pPr>
            <a:lvl7pPr marL="9144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7pPr>
            <a:lvl8pPr marL="13716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8pPr>
            <a:lvl9pPr marL="18288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9pPr>
          </a:lstStyle>
          <a:p>
            <a:r>
              <a:rPr kumimoji="0" lang="en-GB" sz="1400" b="1" dirty="0" smtClean="0">
                <a:latin typeface="+mn-lt"/>
              </a:rPr>
              <a:t>3 </a:t>
            </a:r>
            <a:r>
              <a:rPr kumimoji="0" lang="en-GB" sz="1400" b="1" dirty="0" smtClean="0">
                <a:latin typeface="+mn-lt"/>
              </a:rPr>
              <a:t>events</a:t>
            </a:r>
            <a:endParaRPr kumimoji="0" lang="en-GB" sz="1400" b="1" dirty="0">
              <a:latin typeface="+mn-lt"/>
            </a:endParaRPr>
          </a:p>
        </p:txBody>
      </p:sp>
      <p:cxnSp>
        <p:nvCxnSpPr>
          <p:cNvPr id="430" name="Straight Connector 429"/>
          <p:cNvCxnSpPr/>
          <p:nvPr/>
        </p:nvCxnSpPr>
        <p:spPr bwMode="auto">
          <a:xfrm>
            <a:off x="3361309" y="889387"/>
            <a:ext cx="0" cy="191918"/>
          </a:xfrm>
          <a:prstGeom prst="line">
            <a:avLst/>
          </a:prstGeom>
          <a:ln w="28575">
            <a:solidFill>
              <a:schemeClr val="bg2">
                <a:lumMod val="1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1" name="Straight Connector 430"/>
          <p:cNvCxnSpPr/>
          <p:nvPr/>
        </p:nvCxnSpPr>
        <p:spPr bwMode="auto">
          <a:xfrm>
            <a:off x="3675066" y="889387"/>
            <a:ext cx="0" cy="191918"/>
          </a:xfrm>
          <a:prstGeom prst="line">
            <a:avLst/>
          </a:prstGeom>
          <a:ln w="28575">
            <a:solidFill>
              <a:schemeClr val="bg2">
                <a:lumMod val="1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2" name="Straight Connector 431"/>
          <p:cNvCxnSpPr/>
          <p:nvPr/>
        </p:nvCxnSpPr>
        <p:spPr bwMode="auto">
          <a:xfrm>
            <a:off x="3911597" y="889387"/>
            <a:ext cx="0" cy="191918"/>
          </a:xfrm>
          <a:prstGeom prst="line">
            <a:avLst/>
          </a:prstGeom>
          <a:ln w="28575">
            <a:solidFill>
              <a:schemeClr val="bg2">
                <a:lumMod val="1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3" name="Straight Connector 432"/>
          <p:cNvCxnSpPr/>
          <p:nvPr/>
        </p:nvCxnSpPr>
        <p:spPr bwMode="auto">
          <a:xfrm>
            <a:off x="4186337" y="889387"/>
            <a:ext cx="0" cy="191918"/>
          </a:xfrm>
          <a:prstGeom prst="line">
            <a:avLst/>
          </a:prstGeom>
          <a:ln w="28575">
            <a:solidFill>
              <a:schemeClr val="bg2">
                <a:lumMod val="1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4" name="Straight Connector 433"/>
          <p:cNvCxnSpPr/>
          <p:nvPr/>
        </p:nvCxnSpPr>
        <p:spPr bwMode="auto">
          <a:xfrm>
            <a:off x="2315965" y="889387"/>
            <a:ext cx="0" cy="191918"/>
          </a:xfrm>
          <a:prstGeom prst="line">
            <a:avLst/>
          </a:prstGeom>
          <a:ln w="28575">
            <a:solidFill>
              <a:schemeClr val="bg2">
                <a:lumMod val="1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5" name="Straight Connector 434"/>
          <p:cNvCxnSpPr/>
          <p:nvPr/>
        </p:nvCxnSpPr>
        <p:spPr bwMode="auto">
          <a:xfrm>
            <a:off x="2078486" y="841887"/>
            <a:ext cx="0" cy="191918"/>
          </a:xfrm>
          <a:prstGeom prst="line">
            <a:avLst/>
          </a:prstGeom>
          <a:ln w="28575">
            <a:solidFill>
              <a:schemeClr val="bg2">
                <a:lumMod val="1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6" name="Straight Connector 435"/>
          <p:cNvCxnSpPr/>
          <p:nvPr/>
        </p:nvCxnSpPr>
        <p:spPr bwMode="auto">
          <a:xfrm>
            <a:off x="1789407" y="890817"/>
            <a:ext cx="0" cy="191918"/>
          </a:xfrm>
          <a:prstGeom prst="line">
            <a:avLst/>
          </a:prstGeom>
          <a:ln w="28575">
            <a:solidFill>
              <a:schemeClr val="bg2">
                <a:lumMod val="1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7" name="Straight Connector 436"/>
          <p:cNvCxnSpPr/>
          <p:nvPr/>
        </p:nvCxnSpPr>
        <p:spPr bwMode="auto">
          <a:xfrm>
            <a:off x="1117330" y="905337"/>
            <a:ext cx="0" cy="191918"/>
          </a:xfrm>
          <a:prstGeom prst="line">
            <a:avLst/>
          </a:prstGeom>
          <a:ln w="28575">
            <a:solidFill>
              <a:schemeClr val="bg2">
                <a:lumMod val="1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8" name="Straight Connector 437"/>
          <p:cNvCxnSpPr/>
          <p:nvPr/>
        </p:nvCxnSpPr>
        <p:spPr bwMode="auto">
          <a:xfrm>
            <a:off x="879851" y="905337"/>
            <a:ext cx="0" cy="191918"/>
          </a:xfrm>
          <a:prstGeom prst="line">
            <a:avLst/>
          </a:prstGeom>
          <a:ln w="28575">
            <a:solidFill>
              <a:schemeClr val="bg2">
                <a:lumMod val="1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3" name="Rectangle 97"/>
          <p:cNvSpPr>
            <a:spLocks noChangeArrowheads="1"/>
          </p:cNvSpPr>
          <p:nvPr/>
        </p:nvSpPr>
        <p:spPr bwMode="auto">
          <a:xfrm>
            <a:off x="287224" y="4022076"/>
            <a:ext cx="111524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kumimoji="0" lang="en-US" altLang="ja-JP" b="1" u="sng" dirty="0" smtClean="0">
                <a:latin typeface="Calibri" pitchFamily="127" charset="0"/>
              </a:rPr>
              <a:t>B. </a:t>
            </a:r>
            <a:r>
              <a:rPr kumimoji="0" lang="en-US" altLang="ja-JP" b="1" u="sng" dirty="0" smtClean="0">
                <a:latin typeface="Calibri" pitchFamily="127" charset="0"/>
              </a:rPr>
              <a:t>q4C</a:t>
            </a:r>
            <a:endParaRPr kumimoji="0" lang="en-GB" altLang="ja-JP" b="1" u="sng" dirty="0">
              <a:latin typeface="Calibri" pitchFamily="127" charset="0"/>
            </a:endParaRPr>
          </a:p>
        </p:txBody>
      </p:sp>
      <p:sp>
        <p:nvSpPr>
          <p:cNvPr id="527" name="Rectangle 97"/>
          <p:cNvSpPr>
            <a:spLocks noChangeArrowheads="1"/>
          </p:cNvSpPr>
          <p:nvPr/>
        </p:nvSpPr>
        <p:spPr bwMode="auto">
          <a:xfrm>
            <a:off x="5714756" y="1484784"/>
            <a:ext cx="112871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kumimoji="0" lang="en-GB" altLang="ja-JP" sz="1400" b="1" dirty="0" smtClean="0">
                <a:latin typeface="Calibri" pitchFamily="127" charset="0"/>
              </a:rPr>
              <a:t>4C library</a:t>
            </a:r>
          </a:p>
        </p:txBody>
      </p:sp>
      <p:cxnSp>
        <p:nvCxnSpPr>
          <p:cNvPr id="290" name="Straight Connector 289"/>
          <p:cNvCxnSpPr/>
          <p:nvPr/>
        </p:nvCxnSpPr>
        <p:spPr bwMode="auto">
          <a:xfrm>
            <a:off x="3879938" y="4706264"/>
            <a:ext cx="1410418" cy="0"/>
          </a:xfrm>
          <a:prstGeom prst="line">
            <a:avLst/>
          </a:prstGeom>
          <a:ln w="5715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" name="Group 2"/>
          <p:cNvGrpSpPr/>
          <p:nvPr/>
        </p:nvGrpSpPr>
        <p:grpSpPr>
          <a:xfrm>
            <a:off x="741739" y="6134203"/>
            <a:ext cx="605165" cy="436538"/>
            <a:chOff x="1318670" y="2187357"/>
            <a:chExt cx="758733" cy="667458"/>
          </a:xfrm>
        </p:grpSpPr>
        <p:sp>
          <p:nvSpPr>
            <p:cNvPr id="141" name="Freeform 140"/>
            <p:cNvSpPr/>
            <p:nvPr/>
          </p:nvSpPr>
          <p:spPr bwMode="auto">
            <a:xfrm rot="5628367">
              <a:off x="1383867" y="2161279"/>
              <a:ext cx="628339" cy="758733"/>
            </a:xfrm>
            <a:custGeom>
              <a:avLst/>
              <a:gdLst>
                <a:gd name="connsiteX0" fmla="*/ 0 w 1068979"/>
                <a:gd name="connsiteY0" fmla="*/ 330200 h 1241237"/>
                <a:gd name="connsiteX1" fmla="*/ 177800 w 1068979"/>
                <a:gd name="connsiteY1" fmla="*/ 88900 h 1241237"/>
                <a:gd name="connsiteX2" fmla="*/ 457200 w 1068979"/>
                <a:gd name="connsiteY2" fmla="*/ 0 h 1241237"/>
                <a:gd name="connsiteX3" fmla="*/ 762000 w 1068979"/>
                <a:gd name="connsiteY3" fmla="*/ 0 h 1241237"/>
                <a:gd name="connsiteX4" fmla="*/ 889000 w 1068979"/>
                <a:gd name="connsiteY4" fmla="*/ 88900 h 1241237"/>
                <a:gd name="connsiteX5" fmla="*/ 1028700 w 1068979"/>
                <a:gd name="connsiteY5" fmla="*/ 317500 h 1241237"/>
                <a:gd name="connsiteX6" fmla="*/ 1066800 w 1068979"/>
                <a:gd name="connsiteY6" fmla="*/ 622300 h 1241237"/>
                <a:gd name="connsiteX7" fmla="*/ 977900 w 1068979"/>
                <a:gd name="connsiteY7" fmla="*/ 1016000 h 1241237"/>
                <a:gd name="connsiteX8" fmla="*/ 711200 w 1068979"/>
                <a:gd name="connsiteY8" fmla="*/ 1231900 h 1241237"/>
                <a:gd name="connsiteX9" fmla="*/ 203200 w 1068979"/>
                <a:gd name="connsiteY9" fmla="*/ 1193800 h 1241237"/>
                <a:gd name="connsiteX10" fmla="*/ 114300 w 1068979"/>
                <a:gd name="connsiteY10" fmla="*/ 1117600 h 1241237"/>
                <a:gd name="connsiteX11" fmla="*/ 114300 w 1068979"/>
                <a:gd name="connsiteY11" fmla="*/ 1092200 h 12412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</a:cxnLst>
              <a:rect l="l" t="t" r="r" b="b"/>
              <a:pathLst>
                <a:path w="1068979" h="1241237">
                  <a:moveTo>
                    <a:pt x="0" y="330200"/>
                  </a:moveTo>
                  <a:cubicBezTo>
                    <a:pt x="50800" y="237066"/>
                    <a:pt x="101600" y="143933"/>
                    <a:pt x="177800" y="88900"/>
                  </a:cubicBezTo>
                  <a:cubicBezTo>
                    <a:pt x="254000" y="33867"/>
                    <a:pt x="359833" y="14817"/>
                    <a:pt x="457200" y="0"/>
                  </a:cubicBezTo>
                  <a:cubicBezTo>
                    <a:pt x="554567" y="-14817"/>
                    <a:pt x="690033" y="-14817"/>
                    <a:pt x="762000" y="0"/>
                  </a:cubicBezTo>
                  <a:cubicBezTo>
                    <a:pt x="833967" y="14817"/>
                    <a:pt x="844550" y="35983"/>
                    <a:pt x="889000" y="88900"/>
                  </a:cubicBezTo>
                  <a:cubicBezTo>
                    <a:pt x="933450" y="141817"/>
                    <a:pt x="999067" y="228600"/>
                    <a:pt x="1028700" y="317500"/>
                  </a:cubicBezTo>
                  <a:cubicBezTo>
                    <a:pt x="1058333" y="406400"/>
                    <a:pt x="1075267" y="505883"/>
                    <a:pt x="1066800" y="622300"/>
                  </a:cubicBezTo>
                  <a:cubicBezTo>
                    <a:pt x="1058333" y="738717"/>
                    <a:pt x="1037167" y="914400"/>
                    <a:pt x="977900" y="1016000"/>
                  </a:cubicBezTo>
                  <a:cubicBezTo>
                    <a:pt x="918633" y="1117600"/>
                    <a:pt x="840317" y="1202267"/>
                    <a:pt x="711200" y="1231900"/>
                  </a:cubicBezTo>
                  <a:cubicBezTo>
                    <a:pt x="582083" y="1261533"/>
                    <a:pt x="302683" y="1212850"/>
                    <a:pt x="203200" y="1193800"/>
                  </a:cubicBezTo>
                  <a:cubicBezTo>
                    <a:pt x="103717" y="1174750"/>
                    <a:pt x="129117" y="1134533"/>
                    <a:pt x="114300" y="1117600"/>
                  </a:cubicBezTo>
                  <a:cubicBezTo>
                    <a:pt x="99483" y="1100667"/>
                    <a:pt x="106891" y="1096433"/>
                    <a:pt x="114300" y="1092200"/>
                  </a:cubicBezTo>
                </a:path>
              </a:pathLst>
            </a:custGeom>
            <a:noFill/>
            <a:ln w="57150" cap="flat" cmpd="sng" algn="ctr">
              <a:solidFill>
                <a:srgbClr val="FFC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0000" tIns="46800" rIns="90000" bIns="46800" numCol="1" rtlCol="0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GB" sz="2000" b="0" i="0" u="none" strike="noStrike" cap="none" normalizeH="0" baseline="0" dirty="0" smtClean="0">
                <a:ln>
                  <a:noFill/>
                </a:ln>
                <a:solidFill>
                  <a:srgbClr val="000066"/>
                </a:solidFill>
                <a:effectLst/>
                <a:latin typeface="Arial" charset="0"/>
              </a:endParaRPr>
            </a:p>
          </p:txBody>
        </p:sp>
        <p:sp>
          <p:nvSpPr>
            <p:cNvPr id="142" name="Freeform 141"/>
            <p:cNvSpPr/>
            <p:nvPr/>
          </p:nvSpPr>
          <p:spPr bwMode="auto">
            <a:xfrm rot="5453253">
              <a:off x="1580735" y="1987580"/>
              <a:ext cx="105051" cy="504605"/>
            </a:xfrm>
            <a:custGeom>
              <a:avLst/>
              <a:gdLst>
                <a:gd name="connsiteX0" fmla="*/ 89821 w 178721"/>
                <a:gd name="connsiteY0" fmla="*/ 0 h 825500"/>
                <a:gd name="connsiteX1" fmla="*/ 921 w 178721"/>
                <a:gd name="connsiteY1" fmla="*/ 317500 h 825500"/>
                <a:gd name="connsiteX2" fmla="*/ 51721 w 178721"/>
                <a:gd name="connsiteY2" fmla="*/ 558800 h 825500"/>
                <a:gd name="connsiteX3" fmla="*/ 178721 w 178721"/>
                <a:gd name="connsiteY3" fmla="*/ 825500 h 8255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78721" h="825500">
                  <a:moveTo>
                    <a:pt x="89821" y="0"/>
                  </a:moveTo>
                  <a:cubicBezTo>
                    <a:pt x="48546" y="112183"/>
                    <a:pt x="7271" y="224367"/>
                    <a:pt x="921" y="317500"/>
                  </a:cubicBezTo>
                  <a:cubicBezTo>
                    <a:pt x="-5429" y="410633"/>
                    <a:pt x="22088" y="474133"/>
                    <a:pt x="51721" y="558800"/>
                  </a:cubicBezTo>
                  <a:cubicBezTo>
                    <a:pt x="81354" y="643467"/>
                    <a:pt x="130037" y="734483"/>
                    <a:pt x="178721" y="825500"/>
                  </a:cubicBezTo>
                </a:path>
              </a:pathLst>
            </a:custGeom>
            <a:noFill/>
            <a:ln w="57150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0000" tIns="46800" rIns="90000" bIns="46800" numCol="1" rtlCol="0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GB" sz="2000" b="0" i="0" u="none" strike="noStrike" cap="none" normalizeH="0" baseline="0" dirty="0" smtClean="0">
                <a:ln>
                  <a:noFill/>
                </a:ln>
                <a:solidFill>
                  <a:srgbClr val="000066"/>
                </a:solidFill>
                <a:effectLst/>
                <a:latin typeface="Arial" charset="0"/>
              </a:endParaRPr>
            </a:p>
          </p:txBody>
        </p:sp>
      </p:grpSp>
      <p:grpSp>
        <p:nvGrpSpPr>
          <p:cNvPr id="21" name="Group 20"/>
          <p:cNvGrpSpPr/>
          <p:nvPr/>
        </p:nvGrpSpPr>
        <p:grpSpPr>
          <a:xfrm>
            <a:off x="683568" y="4561057"/>
            <a:ext cx="605165" cy="436539"/>
            <a:chOff x="357039" y="3416751"/>
            <a:chExt cx="605165" cy="436539"/>
          </a:xfrm>
        </p:grpSpPr>
        <p:sp>
          <p:nvSpPr>
            <p:cNvPr id="160" name="Freeform 159"/>
            <p:cNvSpPr/>
            <p:nvPr/>
          </p:nvSpPr>
          <p:spPr bwMode="auto">
            <a:xfrm rot="5628367">
              <a:off x="454145" y="3345230"/>
              <a:ext cx="410954" cy="605165"/>
            </a:xfrm>
            <a:custGeom>
              <a:avLst/>
              <a:gdLst>
                <a:gd name="connsiteX0" fmla="*/ 0 w 1068979"/>
                <a:gd name="connsiteY0" fmla="*/ 330200 h 1241237"/>
                <a:gd name="connsiteX1" fmla="*/ 177800 w 1068979"/>
                <a:gd name="connsiteY1" fmla="*/ 88900 h 1241237"/>
                <a:gd name="connsiteX2" fmla="*/ 457200 w 1068979"/>
                <a:gd name="connsiteY2" fmla="*/ 0 h 1241237"/>
                <a:gd name="connsiteX3" fmla="*/ 762000 w 1068979"/>
                <a:gd name="connsiteY3" fmla="*/ 0 h 1241237"/>
                <a:gd name="connsiteX4" fmla="*/ 889000 w 1068979"/>
                <a:gd name="connsiteY4" fmla="*/ 88900 h 1241237"/>
                <a:gd name="connsiteX5" fmla="*/ 1028700 w 1068979"/>
                <a:gd name="connsiteY5" fmla="*/ 317500 h 1241237"/>
                <a:gd name="connsiteX6" fmla="*/ 1066800 w 1068979"/>
                <a:gd name="connsiteY6" fmla="*/ 622300 h 1241237"/>
                <a:gd name="connsiteX7" fmla="*/ 977900 w 1068979"/>
                <a:gd name="connsiteY7" fmla="*/ 1016000 h 1241237"/>
                <a:gd name="connsiteX8" fmla="*/ 711200 w 1068979"/>
                <a:gd name="connsiteY8" fmla="*/ 1231900 h 1241237"/>
                <a:gd name="connsiteX9" fmla="*/ 203200 w 1068979"/>
                <a:gd name="connsiteY9" fmla="*/ 1193800 h 1241237"/>
                <a:gd name="connsiteX10" fmla="*/ 114300 w 1068979"/>
                <a:gd name="connsiteY10" fmla="*/ 1117600 h 1241237"/>
                <a:gd name="connsiteX11" fmla="*/ 114300 w 1068979"/>
                <a:gd name="connsiteY11" fmla="*/ 1092200 h 12412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</a:cxnLst>
              <a:rect l="l" t="t" r="r" b="b"/>
              <a:pathLst>
                <a:path w="1068979" h="1241237">
                  <a:moveTo>
                    <a:pt x="0" y="330200"/>
                  </a:moveTo>
                  <a:cubicBezTo>
                    <a:pt x="50800" y="237066"/>
                    <a:pt x="101600" y="143933"/>
                    <a:pt x="177800" y="88900"/>
                  </a:cubicBezTo>
                  <a:cubicBezTo>
                    <a:pt x="254000" y="33867"/>
                    <a:pt x="359833" y="14817"/>
                    <a:pt x="457200" y="0"/>
                  </a:cubicBezTo>
                  <a:cubicBezTo>
                    <a:pt x="554567" y="-14817"/>
                    <a:pt x="690033" y="-14817"/>
                    <a:pt x="762000" y="0"/>
                  </a:cubicBezTo>
                  <a:cubicBezTo>
                    <a:pt x="833967" y="14817"/>
                    <a:pt x="844550" y="35983"/>
                    <a:pt x="889000" y="88900"/>
                  </a:cubicBezTo>
                  <a:cubicBezTo>
                    <a:pt x="933450" y="141817"/>
                    <a:pt x="999067" y="228600"/>
                    <a:pt x="1028700" y="317500"/>
                  </a:cubicBezTo>
                  <a:cubicBezTo>
                    <a:pt x="1058333" y="406400"/>
                    <a:pt x="1075267" y="505883"/>
                    <a:pt x="1066800" y="622300"/>
                  </a:cubicBezTo>
                  <a:cubicBezTo>
                    <a:pt x="1058333" y="738717"/>
                    <a:pt x="1037167" y="914400"/>
                    <a:pt x="977900" y="1016000"/>
                  </a:cubicBezTo>
                  <a:cubicBezTo>
                    <a:pt x="918633" y="1117600"/>
                    <a:pt x="840317" y="1202267"/>
                    <a:pt x="711200" y="1231900"/>
                  </a:cubicBezTo>
                  <a:cubicBezTo>
                    <a:pt x="582083" y="1261533"/>
                    <a:pt x="302683" y="1212850"/>
                    <a:pt x="203200" y="1193800"/>
                  </a:cubicBezTo>
                  <a:cubicBezTo>
                    <a:pt x="103717" y="1174750"/>
                    <a:pt x="129117" y="1134533"/>
                    <a:pt x="114300" y="1117600"/>
                  </a:cubicBezTo>
                  <a:cubicBezTo>
                    <a:pt x="99483" y="1100667"/>
                    <a:pt x="106891" y="1096433"/>
                    <a:pt x="114300" y="1092200"/>
                  </a:cubicBezTo>
                </a:path>
              </a:pathLst>
            </a:custGeom>
            <a:noFill/>
            <a:ln w="57150" cap="flat" cmpd="sng" algn="ctr">
              <a:solidFill>
                <a:srgbClr val="92D05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0000" tIns="46800" rIns="90000" bIns="46800" numCol="1" rtlCol="0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GB" sz="2000" b="0" i="0" u="none" strike="noStrike" cap="none" normalizeH="0" baseline="0" dirty="0" smtClean="0">
                <a:ln>
                  <a:noFill/>
                </a:ln>
                <a:solidFill>
                  <a:srgbClr val="000066"/>
                </a:solidFill>
                <a:effectLst/>
                <a:latin typeface="Arial" charset="0"/>
              </a:endParaRPr>
            </a:p>
          </p:txBody>
        </p:sp>
        <p:sp>
          <p:nvSpPr>
            <p:cNvPr id="161" name="Freeform 160"/>
            <p:cNvSpPr/>
            <p:nvPr/>
          </p:nvSpPr>
          <p:spPr bwMode="auto">
            <a:xfrm rot="5453253">
              <a:off x="573603" y="3249867"/>
              <a:ext cx="68706" cy="402473"/>
            </a:xfrm>
            <a:custGeom>
              <a:avLst/>
              <a:gdLst>
                <a:gd name="connsiteX0" fmla="*/ 89821 w 178721"/>
                <a:gd name="connsiteY0" fmla="*/ 0 h 825500"/>
                <a:gd name="connsiteX1" fmla="*/ 921 w 178721"/>
                <a:gd name="connsiteY1" fmla="*/ 317500 h 825500"/>
                <a:gd name="connsiteX2" fmla="*/ 51721 w 178721"/>
                <a:gd name="connsiteY2" fmla="*/ 558800 h 825500"/>
                <a:gd name="connsiteX3" fmla="*/ 178721 w 178721"/>
                <a:gd name="connsiteY3" fmla="*/ 825500 h 8255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78721" h="825500">
                  <a:moveTo>
                    <a:pt x="89821" y="0"/>
                  </a:moveTo>
                  <a:cubicBezTo>
                    <a:pt x="48546" y="112183"/>
                    <a:pt x="7271" y="224367"/>
                    <a:pt x="921" y="317500"/>
                  </a:cubicBezTo>
                  <a:cubicBezTo>
                    <a:pt x="-5429" y="410633"/>
                    <a:pt x="22088" y="474133"/>
                    <a:pt x="51721" y="558800"/>
                  </a:cubicBezTo>
                  <a:cubicBezTo>
                    <a:pt x="81354" y="643467"/>
                    <a:pt x="130037" y="734483"/>
                    <a:pt x="178721" y="825500"/>
                  </a:cubicBezTo>
                </a:path>
              </a:pathLst>
            </a:custGeom>
            <a:noFill/>
            <a:ln w="57150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0000" tIns="46800" rIns="90000" bIns="46800" numCol="1" rtlCol="0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GB" sz="2000" b="0" i="0" u="none" strike="noStrike" cap="none" normalizeH="0" baseline="0" dirty="0" smtClean="0">
                <a:ln>
                  <a:noFill/>
                </a:ln>
                <a:solidFill>
                  <a:srgbClr val="000066"/>
                </a:solidFill>
                <a:effectLst/>
                <a:latin typeface="Arial" charset="0"/>
              </a:endParaRPr>
            </a:p>
          </p:txBody>
        </p:sp>
      </p:grpSp>
      <p:sp>
        <p:nvSpPr>
          <p:cNvPr id="253" name="Rectangle 97"/>
          <p:cNvSpPr>
            <a:spLocks noChangeArrowheads="1"/>
          </p:cNvSpPr>
          <p:nvPr/>
        </p:nvSpPr>
        <p:spPr bwMode="auto">
          <a:xfrm>
            <a:off x="4404987" y="4221088"/>
            <a:ext cx="112871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kumimoji="0" lang="en-GB" altLang="ja-JP" sz="1400" b="1" dirty="0" smtClean="0">
                <a:latin typeface="Calibri" pitchFamily="127" charset="0"/>
              </a:rPr>
              <a:t>LM-PCR</a:t>
            </a:r>
          </a:p>
        </p:txBody>
      </p:sp>
      <p:sp>
        <p:nvSpPr>
          <p:cNvPr id="254" name="Rectangle 97"/>
          <p:cNvSpPr>
            <a:spLocks noChangeArrowheads="1"/>
          </p:cNvSpPr>
          <p:nvPr/>
        </p:nvSpPr>
        <p:spPr bwMode="auto">
          <a:xfrm>
            <a:off x="2812105" y="4986557"/>
            <a:ext cx="111524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kumimoji="0" lang="en-US" altLang="ja-JP" sz="1400" b="1" dirty="0" smtClean="0">
                <a:latin typeface="Calibri" pitchFamily="127" charset="0"/>
              </a:rPr>
              <a:t>Sonication</a:t>
            </a:r>
            <a:endParaRPr kumimoji="0" lang="en-GB" altLang="ja-JP" sz="1400" b="1" dirty="0">
              <a:latin typeface="Calibri" pitchFamily="127" charset="0"/>
            </a:endParaRPr>
          </a:p>
        </p:txBody>
      </p:sp>
      <p:cxnSp>
        <p:nvCxnSpPr>
          <p:cNvPr id="273" name="Straight Connector 272"/>
          <p:cNvCxnSpPr/>
          <p:nvPr/>
        </p:nvCxnSpPr>
        <p:spPr bwMode="auto">
          <a:xfrm>
            <a:off x="4206248" y="4692636"/>
            <a:ext cx="355076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5" name="Rectangle 97"/>
          <p:cNvSpPr>
            <a:spLocks noChangeArrowheads="1"/>
          </p:cNvSpPr>
          <p:nvPr/>
        </p:nvSpPr>
        <p:spPr bwMode="auto">
          <a:xfrm>
            <a:off x="7665583" y="5032188"/>
            <a:ext cx="1563687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kumimoji="0" lang="en-GB" altLang="ja-JP" sz="1600" b="1" dirty="0" smtClean="0">
                <a:solidFill>
                  <a:srgbClr val="002060"/>
                </a:solidFill>
                <a:latin typeface="Calibri" pitchFamily="127" charset="0"/>
              </a:rPr>
              <a:t>3 events</a:t>
            </a:r>
            <a:endParaRPr kumimoji="0" lang="en-GB" altLang="ja-JP" sz="1600" b="1" dirty="0">
              <a:solidFill>
                <a:srgbClr val="002060"/>
              </a:solidFill>
              <a:latin typeface="Calibri" pitchFamily="127" charset="0"/>
            </a:endParaRPr>
          </a:p>
        </p:txBody>
      </p:sp>
      <p:sp>
        <p:nvSpPr>
          <p:cNvPr id="337" name="Rectangle 97"/>
          <p:cNvSpPr>
            <a:spLocks noChangeArrowheads="1"/>
          </p:cNvSpPr>
          <p:nvPr/>
        </p:nvSpPr>
        <p:spPr bwMode="auto">
          <a:xfrm>
            <a:off x="7665583" y="6299050"/>
            <a:ext cx="1563847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kumimoji="0" lang="en-GB" altLang="ja-JP" sz="1600" b="1" dirty="0">
                <a:solidFill>
                  <a:srgbClr val="002060"/>
                </a:solidFill>
                <a:latin typeface="Calibri" pitchFamily="127" charset="0"/>
              </a:rPr>
              <a:t>1 event</a:t>
            </a:r>
          </a:p>
        </p:txBody>
      </p:sp>
      <p:cxnSp>
        <p:nvCxnSpPr>
          <p:cNvPr id="341" name="Straight Connector 340"/>
          <p:cNvCxnSpPr/>
          <p:nvPr/>
        </p:nvCxnSpPr>
        <p:spPr bwMode="auto">
          <a:xfrm>
            <a:off x="7357380" y="6461437"/>
            <a:ext cx="22701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3" name="Right Bracket 342"/>
          <p:cNvSpPr/>
          <p:nvPr/>
        </p:nvSpPr>
        <p:spPr bwMode="auto">
          <a:xfrm>
            <a:off x="7358757" y="4630410"/>
            <a:ext cx="147280" cy="1211493"/>
          </a:xfrm>
          <a:prstGeom prst="righ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grpSp>
        <p:nvGrpSpPr>
          <p:cNvPr id="216" name="Group 215"/>
          <p:cNvGrpSpPr/>
          <p:nvPr/>
        </p:nvGrpSpPr>
        <p:grpSpPr>
          <a:xfrm>
            <a:off x="2125403" y="4493540"/>
            <a:ext cx="605166" cy="436538"/>
            <a:chOff x="1318670" y="2187357"/>
            <a:chExt cx="758733" cy="667458"/>
          </a:xfrm>
        </p:grpSpPr>
        <p:sp>
          <p:nvSpPr>
            <p:cNvPr id="217" name="Freeform 216"/>
            <p:cNvSpPr/>
            <p:nvPr/>
          </p:nvSpPr>
          <p:spPr bwMode="auto">
            <a:xfrm rot="5628367">
              <a:off x="1383867" y="2161279"/>
              <a:ext cx="628339" cy="758733"/>
            </a:xfrm>
            <a:custGeom>
              <a:avLst/>
              <a:gdLst>
                <a:gd name="connsiteX0" fmla="*/ 0 w 1068979"/>
                <a:gd name="connsiteY0" fmla="*/ 330200 h 1241237"/>
                <a:gd name="connsiteX1" fmla="*/ 177800 w 1068979"/>
                <a:gd name="connsiteY1" fmla="*/ 88900 h 1241237"/>
                <a:gd name="connsiteX2" fmla="*/ 457200 w 1068979"/>
                <a:gd name="connsiteY2" fmla="*/ 0 h 1241237"/>
                <a:gd name="connsiteX3" fmla="*/ 762000 w 1068979"/>
                <a:gd name="connsiteY3" fmla="*/ 0 h 1241237"/>
                <a:gd name="connsiteX4" fmla="*/ 889000 w 1068979"/>
                <a:gd name="connsiteY4" fmla="*/ 88900 h 1241237"/>
                <a:gd name="connsiteX5" fmla="*/ 1028700 w 1068979"/>
                <a:gd name="connsiteY5" fmla="*/ 317500 h 1241237"/>
                <a:gd name="connsiteX6" fmla="*/ 1066800 w 1068979"/>
                <a:gd name="connsiteY6" fmla="*/ 622300 h 1241237"/>
                <a:gd name="connsiteX7" fmla="*/ 977900 w 1068979"/>
                <a:gd name="connsiteY7" fmla="*/ 1016000 h 1241237"/>
                <a:gd name="connsiteX8" fmla="*/ 711200 w 1068979"/>
                <a:gd name="connsiteY8" fmla="*/ 1231900 h 1241237"/>
                <a:gd name="connsiteX9" fmla="*/ 203200 w 1068979"/>
                <a:gd name="connsiteY9" fmla="*/ 1193800 h 1241237"/>
                <a:gd name="connsiteX10" fmla="*/ 114300 w 1068979"/>
                <a:gd name="connsiteY10" fmla="*/ 1117600 h 1241237"/>
                <a:gd name="connsiteX11" fmla="*/ 114300 w 1068979"/>
                <a:gd name="connsiteY11" fmla="*/ 1092200 h 12412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</a:cxnLst>
              <a:rect l="l" t="t" r="r" b="b"/>
              <a:pathLst>
                <a:path w="1068979" h="1241237">
                  <a:moveTo>
                    <a:pt x="0" y="330200"/>
                  </a:moveTo>
                  <a:cubicBezTo>
                    <a:pt x="50800" y="237066"/>
                    <a:pt x="101600" y="143933"/>
                    <a:pt x="177800" y="88900"/>
                  </a:cubicBezTo>
                  <a:cubicBezTo>
                    <a:pt x="254000" y="33867"/>
                    <a:pt x="359833" y="14817"/>
                    <a:pt x="457200" y="0"/>
                  </a:cubicBezTo>
                  <a:cubicBezTo>
                    <a:pt x="554567" y="-14817"/>
                    <a:pt x="690033" y="-14817"/>
                    <a:pt x="762000" y="0"/>
                  </a:cubicBezTo>
                  <a:cubicBezTo>
                    <a:pt x="833967" y="14817"/>
                    <a:pt x="844550" y="35983"/>
                    <a:pt x="889000" y="88900"/>
                  </a:cubicBezTo>
                  <a:cubicBezTo>
                    <a:pt x="933450" y="141817"/>
                    <a:pt x="999067" y="228600"/>
                    <a:pt x="1028700" y="317500"/>
                  </a:cubicBezTo>
                  <a:cubicBezTo>
                    <a:pt x="1058333" y="406400"/>
                    <a:pt x="1075267" y="505883"/>
                    <a:pt x="1066800" y="622300"/>
                  </a:cubicBezTo>
                  <a:cubicBezTo>
                    <a:pt x="1058333" y="738717"/>
                    <a:pt x="1037167" y="914400"/>
                    <a:pt x="977900" y="1016000"/>
                  </a:cubicBezTo>
                  <a:cubicBezTo>
                    <a:pt x="918633" y="1117600"/>
                    <a:pt x="840317" y="1202267"/>
                    <a:pt x="711200" y="1231900"/>
                  </a:cubicBezTo>
                  <a:cubicBezTo>
                    <a:pt x="582083" y="1261533"/>
                    <a:pt x="302683" y="1212850"/>
                    <a:pt x="203200" y="1193800"/>
                  </a:cubicBezTo>
                  <a:cubicBezTo>
                    <a:pt x="103717" y="1174750"/>
                    <a:pt x="129117" y="1134533"/>
                    <a:pt x="114300" y="1117600"/>
                  </a:cubicBezTo>
                  <a:cubicBezTo>
                    <a:pt x="99483" y="1100667"/>
                    <a:pt x="106891" y="1096433"/>
                    <a:pt x="114300" y="1092200"/>
                  </a:cubicBezTo>
                </a:path>
              </a:pathLst>
            </a:custGeom>
            <a:noFill/>
            <a:ln w="57150" cap="flat" cmpd="sng" algn="ctr">
              <a:solidFill>
                <a:srgbClr val="92D05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0000" tIns="46800" rIns="90000" bIns="46800" numCol="1" rtlCol="0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GB" sz="2000" b="0" i="0" u="none" strike="noStrike" cap="none" normalizeH="0" baseline="0" dirty="0" smtClean="0">
                <a:ln>
                  <a:noFill/>
                </a:ln>
                <a:solidFill>
                  <a:srgbClr val="000066"/>
                </a:solidFill>
                <a:effectLst/>
                <a:latin typeface="Arial" charset="0"/>
              </a:endParaRPr>
            </a:p>
          </p:txBody>
        </p:sp>
        <p:sp>
          <p:nvSpPr>
            <p:cNvPr id="218" name="Freeform 217"/>
            <p:cNvSpPr/>
            <p:nvPr/>
          </p:nvSpPr>
          <p:spPr bwMode="auto">
            <a:xfrm rot="5453253">
              <a:off x="1580735" y="1987580"/>
              <a:ext cx="105051" cy="504605"/>
            </a:xfrm>
            <a:custGeom>
              <a:avLst/>
              <a:gdLst>
                <a:gd name="connsiteX0" fmla="*/ 89821 w 178721"/>
                <a:gd name="connsiteY0" fmla="*/ 0 h 825500"/>
                <a:gd name="connsiteX1" fmla="*/ 921 w 178721"/>
                <a:gd name="connsiteY1" fmla="*/ 317500 h 825500"/>
                <a:gd name="connsiteX2" fmla="*/ 51721 w 178721"/>
                <a:gd name="connsiteY2" fmla="*/ 558800 h 825500"/>
                <a:gd name="connsiteX3" fmla="*/ 178721 w 178721"/>
                <a:gd name="connsiteY3" fmla="*/ 825500 h 8255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78721" h="825500">
                  <a:moveTo>
                    <a:pt x="89821" y="0"/>
                  </a:moveTo>
                  <a:cubicBezTo>
                    <a:pt x="48546" y="112183"/>
                    <a:pt x="7271" y="224367"/>
                    <a:pt x="921" y="317500"/>
                  </a:cubicBezTo>
                  <a:cubicBezTo>
                    <a:pt x="-5429" y="410633"/>
                    <a:pt x="22088" y="474133"/>
                    <a:pt x="51721" y="558800"/>
                  </a:cubicBezTo>
                  <a:cubicBezTo>
                    <a:pt x="81354" y="643467"/>
                    <a:pt x="130037" y="734483"/>
                    <a:pt x="178721" y="825500"/>
                  </a:cubicBezTo>
                </a:path>
              </a:pathLst>
            </a:custGeom>
            <a:noFill/>
            <a:ln w="57150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0000" tIns="46800" rIns="90000" bIns="46800" numCol="1" rtlCol="0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GB" sz="2000" b="0" i="0" u="none" strike="noStrike" cap="none" normalizeH="0" baseline="0" dirty="0" smtClean="0">
                <a:ln>
                  <a:noFill/>
                </a:ln>
                <a:solidFill>
                  <a:srgbClr val="000066"/>
                </a:solidFill>
                <a:effectLst/>
                <a:latin typeface="Arial" charset="0"/>
              </a:endParaRPr>
            </a:p>
          </p:txBody>
        </p:sp>
      </p:grpSp>
      <p:sp>
        <p:nvSpPr>
          <p:cNvPr id="288" name="Lightning Bolt 287"/>
          <p:cNvSpPr/>
          <p:nvPr/>
        </p:nvSpPr>
        <p:spPr bwMode="auto">
          <a:xfrm>
            <a:off x="2051720" y="4586784"/>
            <a:ext cx="121420" cy="181463"/>
          </a:xfrm>
          <a:prstGeom prst="lightningBol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grpSp>
        <p:nvGrpSpPr>
          <p:cNvPr id="4" name="Group 3"/>
          <p:cNvGrpSpPr/>
          <p:nvPr/>
        </p:nvGrpSpPr>
        <p:grpSpPr>
          <a:xfrm>
            <a:off x="2154735" y="4997596"/>
            <a:ext cx="605166" cy="521115"/>
            <a:chOff x="2618551" y="2856050"/>
            <a:chExt cx="605166" cy="521115"/>
          </a:xfrm>
        </p:grpSpPr>
        <p:sp>
          <p:nvSpPr>
            <p:cNvPr id="214" name="Freeform 213"/>
            <p:cNvSpPr/>
            <p:nvPr/>
          </p:nvSpPr>
          <p:spPr bwMode="auto">
            <a:xfrm rot="5628367">
              <a:off x="2715657" y="2784529"/>
              <a:ext cx="410953" cy="605166"/>
            </a:xfrm>
            <a:custGeom>
              <a:avLst/>
              <a:gdLst>
                <a:gd name="connsiteX0" fmla="*/ 0 w 1068979"/>
                <a:gd name="connsiteY0" fmla="*/ 330200 h 1241237"/>
                <a:gd name="connsiteX1" fmla="*/ 177800 w 1068979"/>
                <a:gd name="connsiteY1" fmla="*/ 88900 h 1241237"/>
                <a:gd name="connsiteX2" fmla="*/ 457200 w 1068979"/>
                <a:gd name="connsiteY2" fmla="*/ 0 h 1241237"/>
                <a:gd name="connsiteX3" fmla="*/ 762000 w 1068979"/>
                <a:gd name="connsiteY3" fmla="*/ 0 h 1241237"/>
                <a:gd name="connsiteX4" fmla="*/ 889000 w 1068979"/>
                <a:gd name="connsiteY4" fmla="*/ 88900 h 1241237"/>
                <a:gd name="connsiteX5" fmla="*/ 1028700 w 1068979"/>
                <a:gd name="connsiteY5" fmla="*/ 317500 h 1241237"/>
                <a:gd name="connsiteX6" fmla="*/ 1066800 w 1068979"/>
                <a:gd name="connsiteY6" fmla="*/ 622300 h 1241237"/>
                <a:gd name="connsiteX7" fmla="*/ 977900 w 1068979"/>
                <a:gd name="connsiteY7" fmla="*/ 1016000 h 1241237"/>
                <a:gd name="connsiteX8" fmla="*/ 711200 w 1068979"/>
                <a:gd name="connsiteY8" fmla="*/ 1231900 h 1241237"/>
                <a:gd name="connsiteX9" fmla="*/ 203200 w 1068979"/>
                <a:gd name="connsiteY9" fmla="*/ 1193800 h 1241237"/>
                <a:gd name="connsiteX10" fmla="*/ 114300 w 1068979"/>
                <a:gd name="connsiteY10" fmla="*/ 1117600 h 1241237"/>
                <a:gd name="connsiteX11" fmla="*/ 114300 w 1068979"/>
                <a:gd name="connsiteY11" fmla="*/ 1092200 h 12412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</a:cxnLst>
              <a:rect l="l" t="t" r="r" b="b"/>
              <a:pathLst>
                <a:path w="1068979" h="1241237">
                  <a:moveTo>
                    <a:pt x="0" y="330200"/>
                  </a:moveTo>
                  <a:cubicBezTo>
                    <a:pt x="50800" y="237066"/>
                    <a:pt x="101600" y="143933"/>
                    <a:pt x="177800" y="88900"/>
                  </a:cubicBezTo>
                  <a:cubicBezTo>
                    <a:pt x="254000" y="33867"/>
                    <a:pt x="359833" y="14817"/>
                    <a:pt x="457200" y="0"/>
                  </a:cubicBezTo>
                  <a:cubicBezTo>
                    <a:pt x="554567" y="-14817"/>
                    <a:pt x="690033" y="-14817"/>
                    <a:pt x="762000" y="0"/>
                  </a:cubicBezTo>
                  <a:cubicBezTo>
                    <a:pt x="833967" y="14817"/>
                    <a:pt x="844550" y="35983"/>
                    <a:pt x="889000" y="88900"/>
                  </a:cubicBezTo>
                  <a:cubicBezTo>
                    <a:pt x="933450" y="141817"/>
                    <a:pt x="999067" y="228600"/>
                    <a:pt x="1028700" y="317500"/>
                  </a:cubicBezTo>
                  <a:cubicBezTo>
                    <a:pt x="1058333" y="406400"/>
                    <a:pt x="1075267" y="505883"/>
                    <a:pt x="1066800" y="622300"/>
                  </a:cubicBezTo>
                  <a:cubicBezTo>
                    <a:pt x="1058333" y="738717"/>
                    <a:pt x="1037167" y="914400"/>
                    <a:pt x="977900" y="1016000"/>
                  </a:cubicBezTo>
                  <a:cubicBezTo>
                    <a:pt x="918633" y="1117600"/>
                    <a:pt x="840317" y="1202267"/>
                    <a:pt x="711200" y="1231900"/>
                  </a:cubicBezTo>
                  <a:cubicBezTo>
                    <a:pt x="582083" y="1261533"/>
                    <a:pt x="302683" y="1212850"/>
                    <a:pt x="203200" y="1193800"/>
                  </a:cubicBezTo>
                  <a:cubicBezTo>
                    <a:pt x="103717" y="1174750"/>
                    <a:pt x="129117" y="1134533"/>
                    <a:pt x="114300" y="1117600"/>
                  </a:cubicBezTo>
                  <a:cubicBezTo>
                    <a:pt x="99483" y="1100667"/>
                    <a:pt x="106891" y="1096433"/>
                    <a:pt x="114300" y="1092200"/>
                  </a:cubicBezTo>
                </a:path>
              </a:pathLst>
            </a:custGeom>
            <a:noFill/>
            <a:ln w="57150" cap="flat" cmpd="sng" algn="ctr">
              <a:solidFill>
                <a:srgbClr val="92D05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0000" tIns="46800" rIns="90000" bIns="46800" numCol="1" rtlCol="0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GB" sz="2000" b="0" i="0" u="none" strike="noStrike" cap="none" normalizeH="0" baseline="0" dirty="0" smtClean="0">
                <a:ln>
                  <a:noFill/>
                </a:ln>
                <a:solidFill>
                  <a:srgbClr val="000066"/>
                </a:solidFill>
                <a:effectLst/>
                <a:latin typeface="Arial" charset="0"/>
              </a:endParaRPr>
            </a:p>
          </p:txBody>
        </p:sp>
        <p:sp>
          <p:nvSpPr>
            <p:cNvPr id="215" name="Freeform 214"/>
            <p:cNvSpPr/>
            <p:nvPr/>
          </p:nvSpPr>
          <p:spPr bwMode="auto">
            <a:xfrm rot="5453253">
              <a:off x="2835114" y="2689167"/>
              <a:ext cx="68707" cy="402473"/>
            </a:xfrm>
            <a:custGeom>
              <a:avLst/>
              <a:gdLst>
                <a:gd name="connsiteX0" fmla="*/ 89821 w 178721"/>
                <a:gd name="connsiteY0" fmla="*/ 0 h 825500"/>
                <a:gd name="connsiteX1" fmla="*/ 921 w 178721"/>
                <a:gd name="connsiteY1" fmla="*/ 317500 h 825500"/>
                <a:gd name="connsiteX2" fmla="*/ 51721 w 178721"/>
                <a:gd name="connsiteY2" fmla="*/ 558800 h 825500"/>
                <a:gd name="connsiteX3" fmla="*/ 178721 w 178721"/>
                <a:gd name="connsiteY3" fmla="*/ 825500 h 8255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78721" h="825500">
                  <a:moveTo>
                    <a:pt x="89821" y="0"/>
                  </a:moveTo>
                  <a:cubicBezTo>
                    <a:pt x="48546" y="112183"/>
                    <a:pt x="7271" y="224367"/>
                    <a:pt x="921" y="317500"/>
                  </a:cubicBezTo>
                  <a:cubicBezTo>
                    <a:pt x="-5429" y="410633"/>
                    <a:pt x="22088" y="474133"/>
                    <a:pt x="51721" y="558800"/>
                  </a:cubicBezTo>
                  <a:cubicBezTo>
                    <a:pt x="81354" y="643467"/>
                    <a:pt x="130037" y="734483"/>
                    <a:pt x="178721" y="825500"/>
                  </a:cubicBezTo>
                </a:path>
              </a:pathLst>
            </a:custGeom>
            <a:noFill/>
            <a:ln w="57150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0000" tIns="46800" rIns="90000" bIns="46800" numCol="1" rtlCol="0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GB" sz="2000" b="0" i="0" u="none" strike="noStrike" cap="none" normalizeH="0" baseline="0" dirty="0" smtClean="0">
                <a:ln>
                  <a:noFill/>
                </a:ln>
                <a:solidFill>
                  <a:srgbClr val="000066"/>
                </a:solidFill>
                <a:effectLst/>
                <a:latin typeface="Arial" charset="0"/>
              </a:endParaRPr>
            </a:p>
          </p:txBody>
        </p:sp>
        <p:sp>
          <p:nvSpPr>
            <p:cNvPr id="289" name="Lightning Bolt 288"/>
            <p:cNvSpPr/>
            <p:nvPr/>
          </p:nvSpPr>
          <p:spPr bwMode="auto">
            <a:xfrm>
              <a:off x="2893698" y="3195702"/>
              <a:ext cx="121421" cy="181463"/>
            </a:xfrm>
            <a:prstGeom prst="lightningBol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/>
            </a:p>
          </p:txBody>
        </p:sp>
      </p:grpSp>
      <p:grpSp>
        <p:nvGrpSpPr>
          <p:cNvPr id="474" name="Group 473"/>
          <p:cNvGrpSpPr/>
          <p:nvPr/>
        </p:nvGrpSpPr>
        <p:grpSpPr>
          <a:xfrm>
            <a:off x="2182491" y="6137317"/>
            <a:ext cx="647998" cy="436538"/>
            <a:chOff x="2646307" y="3432114"/>
            <a:chExt cx="647998" cy="436538"/>
          </a:xfrm>
        </p:grpSpPr>
        <p:sp>
          <p:nvSpPr>
            <p:cNvPr id="219" name="Freeform 218"/>
            <p:cNvSpPr/>
            <p:nvPr/>
          </p:nvSpPr>
          <p:spPr bwMode="auto">
            <a:xfrm rot="5628367">
              <a:off x="2743413" y="3360592"/>
              <a:ext cx="410954" cy="605166"/>
            </a:xfrm>
            <a:custGeom>
              <a:avLst/>
              <a:gdLst>
                <a:gd name="connsiteX0" fmla="*/ 0 w 1068979"/>
                <a:gd name="connsiteY0" fmla="*/ 330200 h 1241237"/>
                <a:gd name="connsiteX1" fmla="*/ 177800 w 1068979"/>
                <a:gd name="connsiteY1" fmla="*/ 88900 h 1241237"/>
                <a:gd name="connsiteX2" fmla="*/ 457200 w 1068979"/>
                <a:gd name="connsiteY2" fmla="*/ 0 h 1241237"/>
                <a:gd name="connsiteX3" fmla="*/ 762000 w 1068979"/>
                <a:gd name="connsiteY3" fmla="*/ 0 h 1241237"/>
                <a:gd name="connsiteX4" fmla="*/ 889000 w 1068979"/>
                <a:gd name="connsiteY4" fmla="*/ 88900 h 1241237"/>
                <a:gd name="connsiteX5" fmla="*/ 1028700 w 1068979"/>
                <a:gd name="connsiteY5" fmla="*/ 317500 h 1241237"/>
                <a:gd name="connsiteX6" fmla="*/ 1066800 w 1068979"/>
                <a:gd name="connsiteY6" fmla="*/ 622300 h 1241237"/>
                <a:gd name="connsiteX7" fmla="*/ 977900 w 1068979"/>
                <a:gd name="connsiteY7" fmla="*/ 1016000 h 1241237"/>
                <a:gd name="connsiteX8" fmla="*/ 711200 w 1068979"/>
                <a:gd name="connsiteY8" fmla="*/ 1231900 h 1241237"/>
                <a:gd name="connsiteX9" fmla="*/ 203200 w 1068979"/>
                <a:gd name="connsiteY9" fmla="*/ 1193800 h 1241237"/>
                <a:gd name="connsiteX10" fmla="*/ 114300 w 1068979"/>
                <a:gd name="connsiteY10" fmla="*/ 1117600 h 1241237"/>
                <a:gd name="connsiteX11" fmla="*/ 114300 w 1068979"/>
                <a:gd name="connsiteY11" fmla="*/ 1092200 h 12412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</a:cxnLst>
              <a:rect l="l" t="t" r="r" b="b"/>
              <a:pathLst>
                <a:path w="1068979" h="1241237">
                  <a:moveTo>
                    <a:pt x="0" y="330200"/>
                  </a:moveTo>
                  <a:cubicBezTo>
                    <a:pt x="50800" y="237066"/>
                    <a:pt x="101600" y="143933"/>
                    <a:pt x="177800" y="88900"/>
                  </a:cubicBezTo>
                  <a:cubicBezTo>
                    <a:pt x="254000" y="33867"/>
                    <a:pt x="359833" y="14817"/>
                    <a:pt x="457200" y="0"/>
                  </a:cubicBezTo>
                  <a:cubicBezTo>
                    <a:pt x="554567" y="-14817"/>
                    <a:pt x="690033" y="-14817"/>
                    <a:pt x="762000" y="0"/>
                  </a:cubicBezTo>
                  <a:cubicBezTo>
                    <a:pt x="833967" y="14817"/>
                    <a:pt x="844550" y="35983"/>
                    <a:pt x="889000" y="88900"/>
                  </a:cubicBezTo>
                  <a:cubicBezTo>
                    <a:pt x="933450" y="141817"/>
                    <a:pt x="999067" y="228600"/>
                    <a:pt x="1028700" y="317500"/>
                  </a:cubicBezTo>
                  <a:cubicBezTo>
                    <a:pt x="1058333" y="406400"/>
                    <a:pt x="1075267" y="505883"/>
                    <a:pt x="1066800" y="622300"/>
                  </a:cubicBezTo>
                  <a:cubicBezTo>
                    <a:pt x="1058333" y="738717"/>
                    <a:pt x="1037167" y="914400"/>
                    <a:pt x="977900" y="1016000"/>
                  </a:cubicBezTo>
                  <a:cubicBezTo>
                    <a:pt x="918633" y="1117600"/>
                    <a:pt x="840317" y="1202267"/>
                    <a:pt x="711200" y="1231900"/>
                  </a:cubicBezTo>
                  <a:cubicBezTo>
                    <a:pt x="582083" y="1261533"/>
                    <a:pt x="302683" y="1212850"/>
                    <a:pt x="203200" y="1193800"/>
                  </a:cubicBezTo>
                  <a:cubicBezTo>
                    <a:pt x="103717" y="1174750"/>
                    <a:pt x="129117" y="1134533"/>
                    <a:pt x="114300" y="1117600"/>
                  </a:cubicBezTo>
                  <a:cubicBezTo>
                    <a:pt x="99483" y="1100667"/>
                    <a:pt x="106891" y="1096433"/>
                    <a:pt x="114300" y="1092200"/>
                  </a:cubicBezTo>
                </a:path>
              </a:pathLst>
            </a:custGeom>
            <a:noFill/>
            <a:ln w="57150" cap="flat" cmpd="sng" algn="ctr">
              <a:solidFill>
                <a:srgbClr val="FFC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0000" tIns="46800" rIns="90000" bIns="46800" numCol="1" rtlCol="0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GB" sz="2000" b="0" i="0" u="none" strike="noStrike" cap="none" normalizeH="0" baseline="0" dirty="0" smtClean="0">
                <a:ln>
                  <a:noFill/>
                </a:ln>
                <a:solidFill>
                  <a:srgbClr val="000066"/>
                </a:solidFill>
                <a:effectLst/>
                <a:latin typeface="Arial" charset="0"/>
              </a:endParaRPr>
            </a:p>
          </p:txBody>
        </p:sp>
        <p:sp>
          <p:nvSpPr>
            <p:cNvPr id="220" name="Freeform 219"/>
            <p:cNvSpPr/>
            <p:nvPr/>
          </p:nvSpPr>
          <p:spPr bwMode="auto">
            <a:xfrm rot="5453253">
              <a:off x="2862871" y="3265230"/>
              <a:ext cx="68706" cy="402473"/>
            </a:xfrm>
            <a:custGeom>
              <a:avLst/>
              <a:gdLst>
                <a:gd name="connsiteX0" fmla="*/ 89821 w 178721"/>
                <a:gd name="connsiteY0" fmla="*/ 0 h 825500"/>
                <a:gd name="connsiteX1" fmla="*/ 921 w 178721"/>
                <a:gd name="connsiteY1" fmla="*/ 317500 h 825500"/>
                <a:gd name="connsiteX2" fmla="*/ 51721 w 178721"/>
                <a:gd name="connsiteY2" fmla="*/ 558800 h 825500"/>
                <a:gd name="connsiteX3" fmla="*/ 178721 w 178721"/>
                <a:gd name="connsiteY3" fmla="*/ 825500 h 8255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78721" h="825500">
                  <a:moveTo>
                    <a:pt x="89821" y="0"/>
                  </a:moveTo>
                  <a:cubicBezTo>
                    <a:pt x="48546" y="112183"/>
                    <a:pt x="7271" y="224367"/>
                    <a:pt x="921" y="317500"/>
                  </a:cubicBezTo>
                  <a:cubicBezTo>
                    <a:pt x="-5429" y="410633"/>
                    <a:pt x="22088" y="474133"/>
                    <a:pt x="51721" y="558800"/>
                  </a:cubicBezTo>
                  <a:cubicBezTo>
                    <a:pt x="81354" y="643467"/>
                    <a:pt x="130037" y="734483"/>
                    <a:pt x="178721" y="825500"/>
                  </a:cubicBezTo>
                </a:path>
              </a:pathLst>
            </a:custGeom>
            <a:noFill/>
            <a:ln w="57150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0000" tIns="46800" rIns="90000" bIns="46800" numCol="1" rtlCol="0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GB" sz="2000" b="0" i="0" u="none" strike="noStrike" cap="none" normalizeH="0" baseline="0" dirty="0" smtClean="0">
                <a:ln>
                  <a:noFill/>
                </a:ln>
                <a:solidFill>
                  <a:srgbClr val="000066"/>
                </a:solidFill>
                <a:effectLst/>
                <a:latin typeface="Arial" charset="0"/>
              </a:endParaRPr>
            </a:p>
          </p:txBody>
        </p:sp>
        <p:sp>
          <p:nvSpPr>
            <p:cNvPr id="307" name="Lightning Bolt 306"/>
            <p:cNvSpPr/>
            <p:nvPr/>
          </p:nvSpPr>
          <p:spPr bwMode="auto">
            <a:xfrm>
              <a:off x="3172885" y="3684859"/>
              <a:ext cx="121420" cy="181463"/>
            </a:xfrm>
            <a:prstGeom prst="lightningBol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/>
            </a:p>
          </p:txBody>
        </p:sp>
      </p:grpSp>
      <p:cxnSp>
        <p:nvCxnSpPr>
          <p:cNvPr id="249" name="Straight Connector 248"/>
          <p:cNvCxnSpPr/>
          <p:nvPr/>
        </p:nvCxnSpPr>
        <p:spPr bwMode="auto">
          <a:xfrm>
            <a:off x="3879938" y="5231772"/>
            <a:ext cx="1410418" cy="0"/>
          </a:xfrm>
          <a:prstGeom prst="line">
            <a:avLst/>
          </a:prstGeom>
          <a:ln w="5715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0" name="Straight Connector 249"/>
          <p:cNvCxnSpPr/>
          <p:nvPr/>
        </p:nvCxnSpPr>
        <p:spPr bwMode="auto">
          <a:xfrm>
            <a:off x="4494280" y="5222100"/>
            <a:ext cx="355076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6" name="Straight Arrow Connector 195"/>
          <p:cNvCxnSpPr/>
          <p:nvPr/>
        </p:nvCxnSpPr>
        <p:spPr>
          <a:xfrm>
            <a:off x="5448505" y="4706264"/>
            <a:ext cx="277057" cy="0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7" name="Straight Arrow Connector 196"/>
          <p:cNvCxnSpPr/>
          <p:nvPr/>
        </p:nvCxnSpPr>
        <p:spPr>
          <a:xfrm>
            <a:off x="5462376" y="5239760"/>
            <a:ext cx="277057" cy="0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8" name="Straight Arrow Connector 197"/>
          <p:cNvCxnSpPr/>
          <p:nvPr/>
        </p:nvCxnSpPr>
        <p:spPr>
          <a:xfrm>
            <a:off x="5462375" y="6262350"/>
            <a:ext cx="277057" cy="0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30" name="Group 229"/>
          <p:cNvGrpSpPr/>
          <p:nvPr/>
        </p:nvGrpSpPr>
        <p:grpSpPr>
          <a:xfrm>
            <a:off x="710407" y="5067359"/>
            <a:ext cx="605165" cy="436539"/>
            <a:chOff x="357039" y="3416751"/>
            <a:chExt cx="605165" cy="436539"/>
          </a:xfrm>
        </p:grpSpPr>
        <p:sp>
          <p:nvSpPr>
            <p:cNvPr id="231" name="Freeform 230"/>
            <p:cNvSpPr/>
            <p:nvPr/>
          </p:nvSpPr>
          <p:spPr bwMode="auto">
            <a:xfrm rot="5628367">
              <a:off x="454145" y="3345230"/>
              <a:ext cx="410954" cy="605165"/>
            </a:xfrm>
            <a:custGeom>
              <a:avLst/>
              <a:gdLst>
                <a:gd name="connsiteX0" fmla="*/ 0 w 1068979"/>
                <a:gd name="connsiteY0" fmla="*/ 330200 h 1241237"/>
                <a:gd name="connsiteX1" fmla="*/ 177800 w 1068979"/>
                <a:gd name="connsiteY1" fmla="*/ 88900 h 1241237"/>
                <a:gd name="connsiteX2" fmla="*/ 457200 w 1068979"/>
                <a:gd name="connsiteY2" fmla="*/ 0 h 1241237"/>
                <a:gd name="connsiteX3" fmla="*/ 762000 w 1068979"/>
                <a:gd name="connsiteY3" fmla="*/ 0 h 1241237"/>
                <a:gd name="connsiteX4" fmla="*/ 889000 w 1068979"/>
                <a:gd name="connsiteY4" fmla="*/ 88900 h 1241237"/>
                <a:gd name="connsiteX5" fmla="*/ 1028700 w 1068979"/>
                <a:gd name="connsiteY5" fmla="*/ 317500 h 1241237"/>
                <a:gd name="connsiteX6" fmla="*/ 1066800 w 1068979"/>
                <a:gd name="connsiteY6" fmla="*/ 622300 h 1241237"/>
                <a:gd name="connsiteX7" fmla="*/ 977900 w 1068979"/>
                <a:gd name="connsiteY7" fmla="*/ 1016000 h 1241237"/>
                <a:gd name="connsiteX8" fmla="*/ 711200 w 1068979"/>
                <a:gd name="connsiteY8" fmla="*/ 1231900 h 1241237"/>
                <a:gd name="connsiteX9" fmla="*/ 203200 w 1068979"/>
                <a:gd name="connsiteY9" fmla="*/ 1193800 h 1241237"/>
                <a:gd name="connsiteX10" fmla="*/ 114300 w 1068979"/>
                <a:gd name="connsiteY10" fmla="*/ 1117600 h 1241237"/>
                <a:gd name="connsiteX11" fmla="*/ 114300 w 1068979"/>
                <a:gd name="connsiteY11" fmla="*/ 1092200 h 12412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</a:cxnLst>
              <a:rect l="l" t="t" r="r" b="b"/>
              <a:pathLst>
                <a:path w="1068979" h="1241237">
                  <a:moveTo>
                    <a:pt x="0" y="330200"/>
                  </a:moveTo>
                  <a:cubicBezTo>
                    <a:pt x="50800" y="237066"/>
                    <a:pt x="101600" y="143933"/>
                    <a:pt x="177800" y="88900"/>
                  </a:cubicBezTo>
                  <a:cubicBezTo>
                    <a:pt x="254000" y="33867"/>
                    <a:pt x="359833" y="14817"/>
                    <a:pt x="457200" y="0"/>
                  </a:cubicBezTo>
                  <a:cubicBezTo>
                    <a:pt x="554567" y="-14817"/>
                    <a:pt x="690033" y="-14817"/>
                    <a:pt x="762000" y="0"/>
                  </a:cubicBezTo>
                  <a:cubicBezTo>
                    <a:pt x="833967" y="14817"/>
                    <a:pt x="844550" y="35983"/>
                    <a:pt x="889000" y="88900"/>
                  </a:cubicBezTo>
                  <a:cubicBezTo>
                    <a:pt x="933450" y="141817"/>
                    <a:pt x="999067" y="228600"/>
                    <a:pt x="1028700" y="317500"/>
                  </a:cubicBezTo>
                  <a:cubicBezTo>
                    <a:pt x="1058333" y="406400"/>
                    <a:pt x="1075267" y="505883"/>
                    <a:pt x="1066800" y="622300"/>
                  </a:cubicBezTo>
                  <a:cubicBezTo>
                    <a:pt x="1058333" y="738717"/>
                    <a:pt x="1037167" y="914400"/>
                    <a:pt x="977900" y="1016000"/>
                  </a:cubicBezTo>
                  <a:cubicBezTo>
                    <a:pt x="918633" y="1117600"/>
                    <a:pt x="840317" y="1202267"/>
                    <a:pt x="711200" y="1231900"/>
                  </a:cubicBezTo>
                  <a:cubicBezTo>
                    <a:pt x="582083" y="1261533"/>
                    <a:pt x="302683" y="1212850"/>
                    <a:pt x="203200" y="1193800"/>
                  </a:cubicBezTo>
                  <a:cubicBezTo>
                    <a:pt x="103717" y="1174750"/>
                    <a:pt x="129117" y="1134533"/>
                    <a:pt x="114300" y="1117600"/>
                  </a:cubicBezTo>
                  <a:cubicBezTo>
                    <a:pt x="99483" y="1100667"/>
                    <a:pt x="106891" y="1096433"/>
                    <a:pt x="114300" y="1092200"/>
                  </a:cubicBezTo>
                </a:path>
              </a:pathLst>
            </a:custGeom>
            <a:noFill/>
            <a:ln w="57150" cap="flat" cmpd="sng" algn="ctr">
              <a:solidFill>
                <a:srgbClr val="92D05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0000" tIns="46800" rIns="90000" bIns="46800" numCol="1" rtlCol="0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GB" sz="2000" b="0" i="0" u="none" strike="noStrike" cap="none" normalizeH="0" baseline="0" dirty="0" smtClean="0">
                <a:ln>
                  <a:noFill/>
                </a:ln>
                <a:solidFill>
                  <a:srgbClr val="000066"/>
                </a:solidFill>
                <a:effectLst/>
                <a:latin typeface="Arial" charset="0"/>
              </a:endParaRPr>
            </a:p>
          </p:txBody>
        </p:sp>
        <p:sp>
          <p:nvSpPr>
            <p:cNvPr id="232" name="Freeform 231"/>
            <p:cNvSpPr/>
            <p:nvPr/>
          </p:nvSpPr>
          <p:spPr bwMode="auto">
            <a:xfrm rot="5453253">
              <a:off x="573603" y="3249867"/>
              <a:ext cx="68706" cy="402473"/>
            </a:xfrm>
            <a:custGeom>
              <a:avLst/>
              <a:gdLst>
                <a:gd name="connsiteX0" fmla="*/ 89821 w 178721"/>
                <a:gd name="connsiteY0" fmla="*/ 0 h 825500"/>
                <a:gd name="connsiteX1" fmla="*/ 921 w 178721"/>
                <a:gd name="connsiteY1" fmla="*/ 317500 h 825500"/>
                <a:gd name="connsiteX2" fmla="*/ 51721 w 178721"/>
                <a:gd name="connsiteY2" fmla="*/ 558800 h 825500"/>
                <a:gd name="connsiteX3" fmla="*/ 178721 w 178721"/>
                <a:gd name="connsiteY3" fmla="*/ 825500 h 8255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78721" h="825500">
                  <a:moveTo>
                    <a:pt x="89821" y="0"/>
                  </a:moveTo>
                  <a:cubicBezTo>
                    <a:pt x="48546" y="112183"/>
                    <a:pt x="7271" y="224367"/>
                    <a:pt x="921" y="317500"/>
                  </a:cubicBezTo>
                  <a:cubicBezTo>
                    <a:pt x="-5429" y="410633"/>
                    <a:pt x="22088" y="474133"/>
                    <a:pt x="51721" y="558800"/>
                  </a:cubicBezTo>
                  <a:cubicBezTo>
                    <a:pt x="81354" y="643467"/>
                    <a:pt x="130037" y="734483"/>
                    <a:pt x="178721" y="825500"/>
                  </a:cubicBezTo>
                </a:path>
              </a:pathLst>
            </a:custGeom>
            <a:noFill/>
            <a:ln w="57150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0000" tIns="46800" rIns="90000" bIns="46800" numCol="1" rtlCol="0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GB" sz="2000" b="0" i="0" u="none" strike="noStrike" cap="none" normalizeH="0" baseline="0" dirty="0" smtClean="0">
                <a:ln>
                  <a:noFill/>
                </a:ln>
                <a:solidFill>
                  <a:srgbClr val="000066"/>
                </a:solidFill>
                <a:effectLst/>
                <a:latin typeface="Arial" charset="0"/>
              </a:endParaRPr>
            </a:p>
          </p:txBody>
        </p:sp>
      </p:grpSp>
      <p:cxnSp>
        <p:nvCxnSpPr>
          <p:cNvPr id="233" name="Straight Connector 232"/>
          <p:cNvCxnSpPr/>
          <p:nvPr/>
        </p:nvCxnSpPr>
        <p:spPr bwMode="auto">
          <a:xfrm>
            <a:off x="5209396" y="4709808"/>
            <a:ext cx="108000" cy="0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4" name="Straight Connector 233"/>
          <p:cNvCxnSpPr/>
          <p:nvPr/>
        </p:nvCxnSpPr>
        <p:spPr bwMode="auto">
          <a:xfrm>
            <a:off x="5209396" y="5224637"/>
            <a:ext cx="108000" cy="0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75" name="Group 474"/>
          <p:cNvGrpSpPr/>
          <p:nvPr/>
        </p:nvGrpSpPr>
        <p:grpSpPr>
          <a:xfrm>
            <a:off x="3901232" y="6278219"/>
            <a:ext cx="1416164" cy="0"/>
            <a:chOff x="3623876" y="3573016"/>
            <a:chExt cx="1416164" cy="0"/>
          </a:xfrm>
        </p:grpSpPr>
        <p:cxnSp>
          <p:nvCxnSpPr>
            <p:cNvPr id="251" name="Straight Connector 250"/>
            <p:cNvCxnSpPr/>
            <p:nvPr/>
          </p:nvCxnSpPr>
          <p:spPr bwMode="auto">
            <a:xfrm>
              <a:off x="3623876" y="3573016"/>
              <a:ext cx="1410418" cy="0"/>
            </a:xfrm>
            <a:prstGeom prst="line">
              <a:avLst/>
            </a:prstGeom>
            <a:ln w="57150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2" name="Straight Connector 251"/>
            <p:cNvCxnSpPr/>
            <p:nvPr/>
          </p:nvCxnSpPr>
          <p:spPr bwMode="auto">
            <a:xfrm>
              <a:off x="4139952" y="3573016"/>
              <a:ext cx="355076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5" name="Straight Connector 234"/>
            <p:cNvCxnSpPr/>
            <p:nvPr/>
          </p:nvCxnSpPr>
          <p:spPr bwMode="auto">
            <a:xfrm>
              <a:off x="4932040" y="3573016"/>
              <a:ext cx="108000" cy="0"/>
            </a:xfrm>
            <a:prstGeom prst="line">
              <a:avLst/>
            </a:prstGeom>
            <a:ln w="57150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77" name="Group 476"/>
          <p:cNvGrpSpPr/>
          <p:nvPr/>
        </p:nvGrpSpPr>
        <p:grpSpPr>
          <a:xfrm>
            <a:off x="6001484" y="5215863"/>
            <a:ext cx="912340" cy="390"/>
            <a:chOff x="5724128" y="3071203"/>
            <a:chExt cx="912340" cy="390"/>
          </a:xfrm>
        </p:grpSpPr>
        <p:cxnSp>
          <p:nvCxnSpPr>
            <p:cNvPr id="446" name="Straight Connector 445"/>
            <p:cNvCxnSpPr/>
            <p:nvPr/>
          </p:nvCxnSpPr>
          <p:spPr bwMode="auto">
            <a:xfrm>
              <a:off x="5724128" y="3071593"/>
              <a:ext cx="216000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7" name="Straight Connector 446"/>
            <p:cNvCxnSpPr/>
            <p:nvPr/>
          </p:nvCxnSpPr>
          <p:spPr bwMode="auto">
            <a:xfrm>
              <a:off x="5946058" y="3071593"/>
              <a:ext cx="612000" cy="0"/>
            </a:xfrm>
            <a:prstGeom prst="line">
              <a:avLst/>
            </a:prstGeom>
            <a:ln w="57150">
              <a:solidFill>
                <a:srgbClr val="92D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6" name="Straight Connector 245"/>
            <p:cNvCxnSpPr/>
            <p:nvPr/>
          </p:nvCxnSpPr>
          <p:spPr bwMode="auto">
            <a:xfrm>
              <a:off x="6528468" y="3071203"/>
              <a:ext cx="108000" cy="0"/>
            </a:xfrm>
            <a:prstGeom prst="line">
              <a:avLst/>
            </a:prstGeom>
            <a:ln w="57150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50" name="Group 449"/>
          <p:cNvGrpSpPr/>
          <p:nvPr/>
        </p:nvGrpSpPr>
        <p:grpSpPr>
          <a:xfrm>
            <a:off x="5969368" y="4662863"/>
            <a:ext cx="1184244" cy="1292"/>
            <a:chOff x="5764020" y="2459753"/>
            <a:chExt cx="1184244" cy="1292"/>
          </a:xfrm>
        </p:grpSpPr>
        <p:cxnSp>
          <p:nvCxnSpPr>
            <p:cNvPr id="448" name="Straight Connector 447"/>
            <p:cNvCxnSpPr/>
            <p:nvPr/>
          </p:nvCxnSpPr>
          <p:spPr bwMode="auto">
            <a:xfrm>
              <a:off x="5826313" y="2459753"/>
              <a:ext cx="1021815" cy="1292"/>
            </a:xfrm>
            <a:prstGeom prst="line">
              <a:avLst/>
            </a:prstGeom>
            <a:ln w="57150">
              <a:solidFill>
                <a:srgbClr val="92D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9" name="Straight Connector 448"/>
            <p:cNvCxnSpPr/>
            <p:nvPr/>
          </p:nvCxnSpPr>
          <p:spPr bwMode="auto">
            <a:xfrm>
              <a:off x="5764020" y="2459753"/>
              <a:ext cx="216000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1" name="Straight Connector 270"/>
            <p:cNvCxnSpPr/>
            <p:nvPr/>
          </p:nvCxnSpPr>
          <p:spPr bwMode="auto">
            <a:xfrm>
              <a:off x="6840264" y="2459753"/>
              <a:ext cx="108000" cy="0"/>
            </a:xfrm>
            <a:prstGeom prst="line">
              <a:avLst/>
            </a:prstGeom>
            <a:ln w="57150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72" name="Group 271"/>
          <p:cNvGrpSpPr/>
          <p:nvPr/>
        </p:nvGrpSpPr>
        <p:grpSpPr>
          <a:xfrm>
            <a:off x="5969368" y="4760178"/>
            <a:ext cx="1184244" cy="1292"/>
            <a:chOff x="5764020" y="2459753"/>
            <a:chExt cx="1184244" cy="1292"/>
          </a:xfrm>
        </p:grpSpPr>
        <p:cxnSp>
          <p:nvCxnSpPr>
            <p:cNvPr id="274" name="Straight Connector 273"/>
            <p:cNvCxnSpPr/>
            <p:nvPr/>
          </p:nvCxnSpPr>
          <p:spPr bwMode="auto">
            <a:xfrm>
              <a:off x="5826313" y="2459753"/>
              <a:ext cx="1021815" cy="1292"/>
            </a:xfrm>
            <a:prstGeom prst="line">
              <a:avLst/>
            </a:prstGeom>
            <a:ln w="57150">
              <a:solidFill>
                <a:srgbClr val="92D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5" name="Straight Connector 274"/>
            <p:cNvCxnSpPr/>
            <p:nvPr/>
          </p:nvCxnSpPr>
          <p:spPr bwMode="auto">
            <a:xfrm>
              <a:off x="5764020" y="2459753"/>
              <a:ext cx="216000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6" name="Straight Connector 275"/>
            <p:cNvCxnSpPr/>
            <p:nvPr/>
          </p:nvCxnSpPr>
          <p:spPr bwMode="auto">
            <a:xfrm>
              <a:off x="6840264" y="2459753"/>
              <a:ext cx="108000" cy="0"/>
            </a:xfrm>
            <a:prstGeom prst="line">
              <a:avLst/>
            </a:prstGeom>
            <a:ln w="57150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51" name="Group 450"/>
          <p:cNvGrpSpPr/>
          <p:nvPr/>
        </p:nvGrpSpPr>
        <p:grpSpPr>
          <a:xfrm>
            <a:off x="6001484" y="6097568"/>
            <a:ext cx="788436" cy="7354"/>
            <a:chOff x="5763772" y="3443680"/>
            <a:chExt cx="788436" cy="7354"/>
          </a:xfrm>
        </p:grpSpPr>
        <p:grpSp>
          <p:nvGrpSpPr>
            <p:cNvPr id="30" name="Group 29"/>
            <p:cNvGrpSpPr/>
            <p:nvPr/>
          </p:nvGrpSpPr>
          <p:grpSpPr>
            <a:xfrm>
              <a:off x="5763772" y="3443680"/>
              <a:ext cx="679161" cy="0"/>
              <a:chOff x="5798893" y="4472243"/>
              <a:chExt cx="679161" cy="0"/>
            </a:xfrm>
          </p:grpSpPr>
          <p:cxnSp>
            <p:nvCxnSpPr>
              <p:cNvPr id="464" name="Straight Connector 463"/>
              <p:cNvCxnSpPr/>
              <p:nvPr/>
            </p:nvCxnSpPr>
            <p:spPr bwMode="auto">
              <a:xfrm>
                <a:off x="5798893" y="4472243"/>
                <a:ext cx="216000" cy="0"/>
              </a:xfrm>
              <a:prstGeom prst="line">
                <a:avLst/>
              </a:prstGeom>
              <a:ln w="571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5" name="Straight Connector 464"/>
              <p:cNvCxnSpPr/>
              <p:nvPr/>
            </p:nvCxnSpPr>
            <p:spPr bwMode="auto">
              <a:xfrm>
                <a:off x="6010054" y="4472243"/>
                <a:ext cx="468000" cy="0"/>
              </a:xfrm>
              <a:prstGeom prst="line">
                <a:avLst/>
              </a:prstGeom>
              <a:ln w="5715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77" name="Straight Connector 276"/>
            <p:cNvCxnSpPr/>
            <p:nvPr/>
          </p:nvCxnSpPr>
          <p:spPr bwMode="auto">
            <a:xfrm>
              <a:off x="6444208" y="3451034"/>
              <a:ext cx="108000" cy="0"/>
            </a:xfrm>
            <a:prstGeom prst="line">
              <a:avLst/>
            </a:prstGeom>
            <a:ln w="57150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79" name="Group 278"/>
          <p:cNvGrpSpPr/>
          <p:nvPr/>
        </p:nvGrpSpPr>
        <p:grpSpPr>
          <a:xfrm>
            <a:off x="6001484" y="6196737"/>
            <a:ext cx="788436" cy="7354"/>
            <a:chOff x="5763772" y="3443680"/>
            <a:chExt cx="788436" cy="7354"/>
          </a:xfrm>
        </p:grpSpPr>
        <p:grpSp>
          <p:nvGrpSpPr>
            <p:cNvPr id="280" name="Group 279"/>
            <p:cNvGrpSpPr/>
            <p:nvPr/>
          </p:nvGrpSpPr>
          <p:grpSpPr>
            <a:xfrm>
              <a:off x="5763772" y="3443680"/>
              <a:ext cx="679161" cy="0"/>
              <a:chOff x="5798893" y="4472243"/>
              <a:chExt cx="679161" cy="0"/>
            </a:xfrm>
          </p:grpSpPr>
          <p:cxnSp>
            <p:nvCxnSpPr>
              <p:cNvPr id="282" name="Straight Connector 281"/>
              <p:cNvCxnSpPr/>
              <p:nvPr/>
            </p:nvCxnSpPr>
            <p:spPr bwMode="auto">
              <a:xfrm>
                <a:off x="5798893" y="4472243"/>
                <a:ext cx="216000" cy="0"/>
              </a:xfrm>
              <a:prstGeom prst="line">
                <a:avLst/>
              </a:prstGeom>
              <a:ln w="571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3" name="Straight Connector 282"/>
              <p:cNvCxnSpPr/>
              <p:nvPr/>
            </p:nvCxnSpPr>
            <p:spPr bwMode="auto">
              <a:xfrm>
                <a:off x="6010054" y="4472243"/>
                <a:ext cx="468000" cy="0"/>
              </a:xfrm>
              <a:prstGeom prst="line">
                <a:avLst/>
              </a:prstGeom>
              <a:ln w="5715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81" name="Straight Connector 280"/>
            <p:cNvCxnSpPr/>
            <p:nvPr/>
          </p:nvCxnSpPr>
          <p:spPr bwMode="auto">
            <a:xfrm>
              <a:off x="6444208" y="3451034"/>
              <a:ext cx="108000" cy="0"/>
            </a:xfrm>
            <a:prstGeom prst="line">
              <a:avLst/>
            </a:prstGeom>
            <a:ln w="57150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84" name="Group 283"/>
          <p:cNvGrpSpPr/>
          <p:nvPr/>
        </p:nvGrpSpPr>
        <p:grpSpPr>
          <a:xfrm>
            <a:off x="6001484" y="6395075"/>
            <a:ext cx="788436" cy="7354"/>
            <a:chOff x="5763772" y="3443680"/>
            <a:chExt cx="788436" cy="7354"/>
          </a:xfrm>
        </p:grpSpPr>
        <p:grpSp>
          <p:nvGrpSpPr>
            <p:cNvPr id="285" name="Group 284"/>
            <p:cNvGrpSpPr/>
            <p:nvPr/>
          </p:nvGrpSpPr>
          <p:grpSpPr>
            <a:xfrm>
              <a:off x="5763772" y="3443680"/>
              <a:ext cx="679161" cy="0"/>
              <a:chOff x="5798893" y="4472243"/>
              <a:chExt cx="679161" cy="0"/>
            </a:xfrm>
          </p:grpSpPr>
          <p:cxnSp>
            <p:nvCxnSpPr>
              <p:cNvPr id="291" name="Straight Connector 290"/>
              <p:cNvCxnSpPr/>
              <p:nvPr/>
            </p:nvCxnSpPr>
            <p:spPr bwMode="auto">
              <a:xfrm>
                <a:off x="5798893" y="4472243"/>
                <a:ext cx="216000" cy="0"/>
              </a:xfrm>
              <a:prstGeom prst="line">
                <a:avLst/>
              </a:prstGeom>
              <a:ln w="571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2" name="Straight Connector 291"/>
              <p:cNvCxnSpPr/>
              <p:nvPr/>
            </p:nvCxnSpPr>
            <p:spPr bwMode="auto">
              <a:xfrm>
                <a:off x="6010054" y="4472243"/>
                <a:ext cx="468000" cy="0"/>
              </a:xfrm>
              <a:prstGeom prst="line">
                <a:avLst/>
              </a:prstGeom>
              <a:ln w="5715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86" name="Straight Connector 285"/>
            <p:cNvCxnSpPr/>
            <p:nvPr/>
          </p:nvCxnSpPr>
          <p:spPr bwMode="auto">
            <a:xfrm>
              <a:off x="6444208" y="3451034"/>
              <a:ext cx="108000" cy="0"/>
            </a:xfrm>
            <a:prstGeom prst="line">
              <a:avLst/>
            </a:prstGeom>
            <a:ln w="57150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93" name="Group 292"/>
          <p:cNvGrpSpPr/>
          <p:nvPr/>
        </p:nvGrpSpPr>
        <p:grpSpPr>
          <a:xfrm>
            <a:off x="6001484" y="6494243"/>
            <a:ext cx="788436" cy="7354"/>
            <a:chOff x="5763772" y="3443680"/>
            <a:chExt cx="788436" cy="7354"/>
          </a:xfrm>
        </p:grpSpPr>
        <p:grpSp>
          <p:nvGrpSpPr>
            <p:cNvPr id="294" name="Group 293"/>
            <p:cNvGrpSpPr/>
            <p:nvPr/>
          </p:nvGrpSpPr>
          <p:grpSpPr>
            <a:xfrm>
              <a:off x="5763772" y="3443680"/>
              <a:ext cx="679161" cy="0"/>
              <a:chOff x="5798893" y="4472243"/>
              <a:chExt cx="679161" cy="0"/>
            </a:xfrm>
          </p:grpSpPr>
          <p:cxnSp>
            <p:nvCxnSpPr>
              <p:cNvPr id="296" name="Straight Connector 295"/>
              <p:cNvCxnSpPr/>
              <p:nvPr/>
            </p:nvCxnSpPr>
            <p:spPr bwMode="auto">
              <a:xfrm>
                <a:off x="5798893" y="4472243"/>
                <a:ext cx="216000" cy="0"/>
              </a:xfrm>
              <a:prstGeom prst="line">
                <a:avLst/>
              </a:prstGeom>
              <a:ln w="571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7" name="Straight Connector 296"/>
              <p:cNvCxnSpPr/>
              <p:nvPr/>
            </p:nvCxnSpPr>
            <p:spPr bwMode="auto">
              <a:xfrm>
                <a:off x="6010054" y="4472243"/>
                <a:ext cx="468000" cy="0"/>
              </a:xfrm>
              <a:prstGeom prst="line">
                <a:avLst/>
              </a:prstGeom>
              <a:ln w="5715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95" name="Straight Connector 294"/>
            <p:cNvCxnSpPr/>
            <p:nvPr/>
          </p:nvCxnSpPr>
          <p:spPr bwMode="auto">
            <a:xfrm>
              <a:off x="6444208" y="3451034"/>
              <a:ext cx="108000" cy="0"/>
            </a:xfrm>
            <a:prstGeom prst="line">
              <a:avLst/>
            </a:prstGeom>
            <a:ln w="57150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98" name="Group 297"/>
          <p:cNvGrpSpPr/>
          <p:nvPr/>
        </p:nvGrpSpPr>
        <p:grpSpPr>
          <a:xfrm>
            <a:off x="6001484" y="6295906"/>
            <a:ext cx="788436" cy="7354"/>
            <a:chOff x="5763772" y="3443680"/>
            <a:chExt cx="788436" cy="7354"/>
          </a:xfrm>
        </p:grpSpPr>
        <p:grpSp>
          <p:nvGrpSpPr>
            <p:cNvPr id="299" name="Group 298"/>
            <p:cNvGrpSpPr/>
            <p:nvPr/>
          </p:nvGrpSpPr>
          <p:grpSpPr>
            <a:xfrm>
              <a:off x="5763772" y="3443680"/>
              <a:ext cx="679161" cy="0"/>
              <a:chOff x="5798893" y="4472243"/>
              <a:chExt cx="679161" cy="0"/>
            </a:xfrm>
          </p:grpSpPr>
          <p:cxnSp>
            <p:nvCxnSpPr>
              <p:cNvPr id="301" name="Straight Connector 300"/>
              <p:cNvCxnSpPr/>
              <p:nvPr/>
            </p:nvCxnSpPr>
            <p:spPr bwMode="auto">
              <a:xfrm>
                <a:off x="5798893" y="4472243"/>
                <a:ext cx="216000" cy="0"/>
              </a:xfrm>
              <a:prstGeom prst="line">
                <a:avLst/>
              </a:prstGeom>
              <a:ln w="571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2" name="Straight Connector 301"/>
              <p:cNvCxnSpPr/>
              <p:nvPr/>
            </p:nvCxnSpPr>
            <p:spPr bwMode="auto">
              <a:xfrm>
                <a:off x="6010054" y="4472243"/>
                <a:ext cx="468000" cy="0"/>
              </a:xfrm>
              <a:prstGeom prst="line">
                <a:avLst/>
              </a:prstGeom>
              <a:ln w="5715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00" name="Straight Connector 299"/>
            <p:cNvCxnSpPr/>
            <p:nvPr/>
          </p:nvCxnSpPr>
          <p:spPr bwMode="auto">
            <a:xfrm>
              <a:off x="6444208" y="3451034"/>
              <a:ext cx="108000" cy="0"/>
            </a:xfrm>
            <a:prstGeom prst="line">
              <a:avLst/>
            </a:prstGeom>
            <a:ln w="57150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86" name="Group 385"/>
          <p:cNvGrpSpPr/>
          <p:nvPr/>
        </p:nvGrpSpPr>
        <p:grpSpPr>
          <a:xfrm>
            <a:off x="5969368" y="4852288"/>
            <a:ext cx="1184244" cy="1292"/>
            <a:chOff x="5764020" y="2459753"/>
            <a:chExt cx="1184244" cy="1292"/>
          </a:xfrm>
        </p:grpSpPr>
        <p:cxnSp>
          <p:nvCxnSpPr>
            <p:cNvPr id="387" name="Straight Connector 386"/>
            <p:cNvCxnSpPr/>
            <p:nvPr/>
          </p:nvCxnSpPr>
          <p:spPr bwMode="auto">
            <a:xfrm>
              <a:off x="5826313" y="2459753"/>
              <a:ext cx="1021815" cy="1292"/>
            </a:xfrm>
            <a:prstGeom prst="line">
              <a:avLst/>
            </a:prstGeom>
            <a:ln w="57150">
              <a:solidFill>
                <a:srgbClr val="92D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8" name="Straight Connector 387"/>
            <p:cNvCxnSpPr/>
            <p:nvPr/>
          </p:nvCxnSpPr>
          <p:spPr bwMode="auto">
            <a:xfrm>
              <a:off x="5764020" y="2459753"/>
              <a:ext cx="216000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9" name="Straight Connector 388"/>
            <p:cNvCxnSpPr/>
            <p:nvPr/>
          </p:nvCxnSpPr>
          <p:spPr bwMode="auto">
            <a:xfrm>
              <a:off x="6840264" y="2459753"/>
              <a:ext cx="108000" cy="0"/>
            </a:xfrm>
            <a:prstGeom prst="line">
              <a:avLst/>
            </a:prstGeom>
            <a:ln w="57150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05" name="Group 404"/>
          <p:cNvGrpSpPr/>
          <p:nvPr/>
        </p:nvGrpSpPr>
        <p:grpSpPr>
          <a:xfrm>
            <a:off x="6001484" y="5313178"/>
            <a:ext cx="912340" cy="390"/>
            <a:chOff x="5724128" y="3071203"/>
            <a:chExt cx="912340" cy="390"/>
          </a:xfrm>
        </p:grpSpPr>
        <p:cxnSp>
          <p:nvCxnSpPr>
            <p:cNvPr id="406" name="Straight Connector 405"/>
            <p:cNvCxnSpPr/>
            <p:nvPr/>
          </p:nvCxnSpPr>
          <p:spPr bwMode="auto">
            <a:xfrm>
              <a:off x="5724128" y="3071593"/>
              <a:ext cx="216000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7" name="Straight Connector 406"/>
            <p:cNvCxnSpPr/>
            <p:nvPr/>
          </p:nvCxnSpPr>
          <p:spPr bwMode="auto">
            <a:xfrm>
              <a:off x="5946058" y="3071593"/>
              <a:ext cx="612000" cy="0"/>
            </a:xfrm>
            <a:prstGeom prst="line">
              <a:avLst/>
            </a:prstGeom>
            <a:ln w="57150">
              <a:solidFill>
                <a:srgbClr val="92D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8" name="Straight Connector 407"/>
            <p:cNvCxnSpPr/>
            <p:nvPr/>
          </p:nvCxnSpPr>
          <p:spPr bwMode="auto">
            <a:xfrm>
              <a:off x="6528468" y="3071203"/>
              <a:ext cx="108000" cy="0"/>
            </a:xfrm>
            <a:prstGeom prst="line">
              <a:avLst/>
            </a:prstGeom>
            <a:ln w="57150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10" name="Freeform 409"/>
          <p:cNvSpPr/>
          <p:nvPr/>
        </p:nvSpPr>
        <p:spPr bwMode="auto">
          <a:xfrm rot="5628367">
            <a:off x="2275605" y="5469559"/>
            <a:ext cx="410953" cy="605166"/>
          </a:xfrm>
          <a:custGeom>
            <a:avLst/>
            <a:gdLst>
              <a:gd name="connsiteX0" fmla="*/ 0 w 1068979"/>
              <a:gd name="connsiteY0" fmla="*/ 330200 h 1241237"/>
              <a:gd name="connsiteX1" fmla="*/ 177800 w 1068979"/>
              <a:gd name="connsiteY1" fmla="*/ 88900 h 1241237"/>
              <a:gd name="connsiteX2" fmla="*/ 457200 w 1068979"/>
              <a:gd name="connsiteY2" fmla="*/ 0 h 1241237"/>
              <a:gd name="connsiteX3" fmla="*/ 762000 w 1068979"/>
              <a:gd name="connsiteY3" fmla="*/ 0 h 1241237"/>
              <a:gd name="connsiteX4" fmla="*/ 889000 w 1068979"/>
              <a:gd name="connsiteY4" fmla="*/ 88900 h 1241237"/>
              <a:gd name="connsiteX5" fmla="*/ 1028700 w 1068979"/>
              <a:gd name="connsiteY5" fmla="*/ 317500 h 1241237"/>
              <a:gd name="connsiteX6" fmla="*/ 1066800 w 1068979"/>
              <a:gd name="connsiteY6" fmla="*/ 622300 h 1241237"/>
              <a:gd name="connsiteX7" fmla="*/ 977900 w 1068979"/>
              <a:gd name="connsiteY7" fmla="*/ 1016000 h 1241237"/>
              <a:gd name="connsiteX8" fmla="*/ 711200 w 1068979"/>
              <a:gd name="connsiteY8" fmla="*/ 1231900 h 1241237"/>
              <a:gd name="connsiteX9" fmla="*/ 203200 w 1068979"/>
              <a:gd name="connsiteY9" fmla="*/ 1193800 h 1241237"/>
              <a:gd name="connsiteX10" fmla="*/ 114300 w 1068979"/>
              <a:gd name="connsiteY10" fmla="*/ 1117600 h 1241237"/>
              <a:gd name="connsiteX11" fmla="*/ 114300 w 1068979"/>
              <a:gd name="connsiteY11" fmla="*/ 1092200 h 124123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1068979" h="1241237">
                <a:moveTo>
                  <a:pt x="0" y="330200"/>
                </a:moveTo>
                <a:cubicBezTo>
                  <a:pt x="50800" y="237066"/>
                  <a:pt x="101600" y="143933"/>
                  <a:pt x="177800" y="88900"/>
                </a:cubicBezTo>
                <a:cubicBezTo>
                  <a:pt x="254000" y="33867"/>
                  <a:pt x="359833" y="14817"/>
                  <a:pt x="457200" y="0"/>
                </a:cubicBezTo>
                <a:cubicBezTo>
                  <a:pt x="554567" y="-14817"/>
                  <a:pt x="690033" y="-14817"/>
                  <a:pt x="762000" y="0"/>
                </a:cubicBezTo>
                <a:cubicBezTo>
                  <a:pt x="833967" y="14817"/>
                  <a:pt x="844550" y="35983"/>
                  <a:pt x="889000" y="88900"/>
                </a:cubicBezTo>
                <a:cubicBezTo>
                  <a:pt x="933450" y="141817"/>
                  <a:pt x="999067" y="228600"/>
                  <a:pt x="1028700" y="317500"/>
                </a:cubicBezTo>
                <a:cubicBezTo>
                  <a:pt x="1058333" y="406400"/>
                  <a:pt x="1075267" y="505883"/>
                  <a:pt x="1066800" y="622300"/>
                </a:cubicBezTo>
                <a:cubicBezTo>
                  <a:pt x="1058333" y="738717"/>
                  <a:pt x="1037167" y="914400"/>
                  <a:pt x="977900" y="1016000"/>
                </a:cubicBezTo>
                <a:cubicBezTo>
                  <a:pt x="918633" y="1117600"/>
                  <a:pt x="840317" y="1202267"/>
                  <a:pt x="711200" y="1231900"/>
                </a:cubicBezTo>
                <a:cubicBezTo>
                  <a:pt x="582083" y="1261533"/>
                  <a:pt x="302683" y="1212850"/>
                  <a:pt x="203200" y="1193800"/>
                </a:cubicBezTo>
                <a:cubicBezTo>
                  <a:pt x="103717" y="1174750"/>
                  <a:pt x="129117" y="1134533"/>
                  <a:pt x="114300" y="1117600"/>
                </a:cubicBezTo>
                <a:cubicBezTo>
                  <a:pt x="99483" y="1100667"/>
                  <a:pt x="106891" y="1096433"/>
                  <a:pt x="114300" y="1092200"/>
                </a:cubicBezTo>
              </a:path>
            </a:pathLst>
          </a:custGeom>
          <a:noFill/>
          <a:ln w="57150" cap="flat" cmpd="sng" algn="ctr">
            <a:solidFill>
              <a:srgbClr val="92D05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0000" tIns="46800" rIns="90000" bIns="46800" numCol="1" rtlCol="0" anchor="t" anchorCtr="0" compatLnSpc="1">
            <a:prstTxWarp prst="textNoShape">
              <a:avLst/>
            </a:prstTxWarp>
            <a:spAutoFit/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sz="2000" b="0" i="0" u="none" strike="noStrike" cap="none" normalizeH="0" baseline="0" dirty="0" smtClean="0">
              <a:ln>
                <a:noFill/>
              </a:ln>
              <a:solidFill>
                <a:srgbClr val="000066"/>
              </a:solidFill>
              <a:effectLst/>
              <a:latin typeface="Arial" charset="0"/>
            </a:endParaRPr>
          </a:p>
        </p:txBody>
      </p:sp>
      <p:sp>
        <p:nvSpPr>
          <p:cNvPr id="411" name="Freeform 410"/>
          <p:cNvSpPr/>
          <p:nvPr/>
        </p:nvSpPr>
        <p:spPr bwMode="auto">
          <a:xfrm rot="5453253">
            <a:off x="2395062" y="5374197"/>
            <a:ext cx="68707" cy="402473"/>
          </a:xfrm>
          <a:custGeom>
            <a:avLst/>
            <a:gdLst>
              <a:gd name="connsiteX0" fmla="*/ 89821 w 178721"/>
              <a:gd name="connsiteY0" fmla="*/ 0 h 825500"/>
              <a:gd name="connsiteX1" fmla="*/ 921 w 178721"/>
              <a:gd name="connsiteY1" fmla="*/ 317500 h 825500"/>
              <a:gd name="connsiteX2" fmla="*/ 51721 w 178721"/>
              <a:gd name="connsiteY2" fmla="*/ 558800 h 825500"/>
              <a:gd name="connsiteX3" fmla="*/ 178721 w 178721"/>
              <a:gd name="connsiteY3" fmla="*/ 825500 h 825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78721" h="825500">
                <a:moveTo>
                  <a:pt x="89821" y="0"/>
                </a:moveTo>
                <a:cubicBezTo>
                  <a:pt x="48546" y="112183"/>
                  <a:pt x="7271" y="224367"/>
                  <a:pt x="921" y="317500"/>
                </a:cubicBezTo>
                <a:cubicBezTo>
                  <a:pt x="-5429" y="410633"/>
                  <a:pt x="22088" y="474133"/>
                  <a:pt x="51721" y="558800"/>
                </a:cubicBezTo>
                <a:cubicBezTo>
                  <a:pt x="81354" y="643467"/>
                  <a:pt x="130037" y="734483"/>
                  <a:pt x="178721" y="825500"/>
                </a:cubicBezTo>
              </a:path>
            </a:pathLst>
          </a:custGeom>
          <a:noFill/>
          <a:ln w="571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0000" tIns="46800" rIns="90000" bIns="46800" numCol="1" rtlCol="0" anchor="t" anchorCtr="0" compatLnSpc="1">
            <a:prstTxWarp prst="textNoShape">
              <a:avLst/>
            </a:prstTxWarp>
            <a:spAutoFit/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sz="2000" b="0" i="0" u="none" strike="noStrike" cap="none" normalizeH="0" baseline="0" dirty="0" smtClean="0">
              <a:ln>
                <a:noFill/>
              </a:ln>
              <a:solidFill>
                <a:srgbClr val="000066"/>
              </a:solidFill>
              <a:effectLst/>
              <a:latin typeface="Arial" charset="0"/>
            </a:endParaRPr>
          </a:p>
        </p:txBody>
      </p:sp>
      <p:sp>
        <p:nvSpPr>
          <p:cNvPr id="412" name="Lightning Bolt 411"/>
          <p:cNvSpPr/>
          <p:nvPr/>
        </p:nvSpPr>
        <p:spPr bwMode="auto">
          <a:xfrm>
            <a:off x="2685840" y="5604579"/>
            <a:ext cx="121421" cy="181463"/>
          </a:xfrm>
          <a:prstGeom prst="lightningBol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cxnSp>
        <p:nvCxnSpPr>
          <p:cNvPr id="413" name="Straight Connector 412"/>
          <p:cNvCxnSpPr/>
          <p:nvPr/>
        </p:nvCxnSpPr>
        <p:spPr bwMode="auto">
          <a:xfrm>
            <a:off x="3903702" y="5764239"/>
            <a:ext cx="1410418" cy="0"/>
          </a:xfrm>
          <a:prstGeom prst="line">
            <a:avLst/>
          </a:prstGeom>
          <a:ln w="5715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4" name="Straight Connector 413"/>
          <p:cNvCxnSpPr/>
          <p:nvPr/>
        </p:nvCxnSpPr>
        <p:spPr bwMode="auto">
          <a:xfrm>
            <a:off x="4705340" y="5765584"/>
            <a:ext cx="355076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5" name="Straight Arrow Connector 414"/>
          <p:cNvCxnSpPr/>
          <p:nvPr/>
        </p:nvCxnSpPr>
        <p:spPr>
          <a:xfrm>
            <a:off x="5486140" y="5774163"/>
            <a:ext cx="277057" cy="0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16" name="Group 415"/>
          <p:cNvGrpSpPr/>
          <p:nvPr/>
        </p:nvGrpSpPr>
        <p:grpSpPr>
          <a:xfrm>
            <a:off x="734171" y="5610843"/>
            <a:ext cx="605165" cy="436539"/>
            <a:chOff x="357039" y="3416751"/>
            <a:chExt cx="605165" cy="436539"/>
          </a:xfrm>
        </p:grpSpPr>
        <p:sp>
          <p:nvSpPr>
            <p:cNvPr id="417" name="Freeform 416"/>
            <p:cNvSpPr/>
            <p:nvPr/>
          </p:nvSpPr>
          <p:spPr bwMode="auto">
            <a:xfrm rot="5628367">
              <a:off x="454145" y="3345230"/>
              <a:ext cx="410954" cy="605165"/>
            </a:xfrm>
            <a:custGeom>
              <a:avLst/>
              <a:gdLst>
                <a:gd name="connsiteX0" fmla="*/ 0 w 1068979"/>
                <a:gd name="connsiteY0" fmla="*/ 330200 h 1241237"/>
                <a:gd name="connsiteX1" fmla="*/ 177800 w 1068979"/>
                <a:gd name="connsiteY1" fmla="*/ 88900 h 1241237"/>
                <a:gd name="connsiteX2" fmla="*/ 457200 w 1068979"/>
                <a:gd name="connsiteY2" fmla="*/ 0 h 1241237"/>
                <a:gd name="connsiteX3" fmla="*/ 762000 w 1068979"/>
                <a:gd name="connsiteY3" fmla="*/ 0 h 1241237"/>
                <a:gd name="connsiteX4" fmla="*/ 889000 w 1068979"/>
                <a:gd name="connsiteY4" fmla="*/ 88900 h 1241237"/>
                <a:gd name="connsiteX5" fmla="*/ 1028700 w 1068979"/>
                <a:gd name="connsiteY5" fmla="*/ 317500 h 1241237"/>
                <a:gd name="connsiteX6" fmla="*/ 1066800 w 1068979"/>
                <a:gd name="connsiteY6" fmla="*/ 622300 h 1241237"/>
                <a:gd name="connsiteX7" fmla="*/ 977900 w 1068979"/>
                <a:gd name="connsiteY7" fmla="*/ 1016000 h 1241237"/>
                <a:gd name="connsiteX8" fmla="*/ 711200 w 1068979"/>
                <a:gd name="connsiteY8" fmla="*/ 1231900 h 1241237"/>
                <a:gd name="connsiteX9" fmla="*/ 203200 w 1068979"/>
                <a:gd name="connsiteY9" fmla="*/ 1193800 h 1241237"/>
                <a:gd name="connsiteX10" fmla="*/ 114300 w 1068979"/>
                <a:gd name="connsiteY10" fmla="*/ 1117600 h 1241237"/>
                <a:gd name="connsiteX11" fmla="*/ 114300 w 1068979"/>
                <a:gd name="connsiteY11" fmla="*/ 1092200 h 12412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</a:cxnLst>
              <a:rect l="l" t="t" r="r" b="b"/>
              <a:pathLst>
                <a:path w="1068979" h="1241237">
                  <a:moveTo>
                    <a:pt x="0" y="330200"/>
                  </a:moveTo>
                  <a:cubicBezTo>
                    <a:pt x="50800" y="237066"/>
                    <a:pt x="101600" y="143933"/>
                    <a:pt x="177800" y="88900"/>
                  </a:cubicBezTo>
                  <a:cubicBezTo>
                    <a:pt x="254000" y="33867"/>
                    <a:pt x="359833" y="14817"/>
                    <a:pt x="457200" y="0"/>
                  </a:cubicBezTo>
                  <a:cubicBezTo>
                    <a:pt x="554567" y="-14817"/>
                    <a:pt x="690033" y="-14817"/>
                    <a:pt x="762000" y="0"/>
                  </a:cubicBezTo>
                  <a:cubicBezTo>
                    <a:pt x="833967" y="14817"/>
                    <a:pt x="844550" y="35983"/>
                    <a:pt x="889000" y="88900"/>
                  </a:cubicBezTo>
                  <a:cubicBezTo>
                    <a:pt x="933450" y="141817"/>
                    <a:pt x="999067" y="228600"/>
                    <a:pt x="1028700" y="317500"/>
                  </a:cubicBezTo>
                  <a:cubicBezTo>
                    <a:pt x="1058333" y="406400"/>
                    <a:pt x="1075267" y="505883"/>
                    <a:pt x="1066800" y="622300"/>
                  </a:cubicBezTo>
                  <a:cubicBezTo>
                    <a:pt x="1058333" y="738717"/>
                    <a:pt x="1037167" y="914400"/>
                    <a:pt x="977900" y="1016000"/>
                  </a:cubicBezTo>
                  <a:cubicBezTo>
                    <a:pt x="918633" y="1117600"/>
                    <a:pt x="840317" y="1202267"/>
                    <a:pt x="711200" y="1231900"/>
                  </a:cubicBezTo>
                  <a:cubicBezTo>
                    <a:pt x="582083" y="1261533"/>
                    <a:pt x="302683" y="1212850"/>
                    <a:pt x="203200" y="1193800"/>
                  </a:cubicBezTo>
                  <a:cubicBezTo>
                    <a:pt x="103717" y="1174750"/>
                    <a:pt x="129117" y="1134533"/>
                    <a:pt x="114300" y="1117600"/>
                  </a:cubicBezTo>
                  <a:cubicBezTo>
                    <a:pt x="99483" y="1100667"/>
                    <a:pt x="106891" y="1096433"/>
                    <a:pt x="114300" y="1092200"/>
                  </a:cubicBezTo>
                </a:path>
              </a:pathLst>
            </a:custGeom>
            <a:noFill/>
            <a:ln w="57150" cap="flat" cmpd="sng" algn="ctr">
              <a:solidFill>
                <a:srgbClr val="92D05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0000" tIns="46800" rIns="90000" bIns="46800" numCol="1" rtlCol="0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GB" sz="2000" b="0" i="0" u="none" strike="noStrike" cap="none" normalizeH="0" baseline="0" dirty="0" smtClean="0">
                <a:ln>
                  <a:noFill/>
                </a:ln>
                <a:solidFill>
                  <a:srgbClr val="000066"/>
                </a:solidFill>
                <a:effectLst/>
                <a:latin typeface="Arial" charset="0"/>
              </a:endParaRPr>
            </a:p>
          </p:txBody>
        </p:sp>
        <p:sp>
          <p:nvSpPr>
            <p:cNvPr id="418" name="Freeform 417"/>
            <p:cNvSpPr/>
            <p:nvPr/>
          </p:nvSpPr>
          <p:spPr bwMode="auto">
            <a:xfrm rot="5453253">
              <a:off x="573603" y="3249867"/>
              <a:ext cx="68706" cy="402473"/>
            </a:xfrm>
            <a:custGeom>
              <a:avLst/>
              <a:gdLst>
                <a:gd name="connsiteX0" fmla="*/ 89821 w 178721"/>
                <a:gd name="connsiteY0" fmla="*/ 0 h 825500"/>
                <a:gd name="connsiteX1" fmla="*/ 921 w 178721"/>
                <a:gd name="connsiteY1" fmla="*/ 317500 h 825500"/>
                <a:gd name="connsiteX2" fmla="*/ 51721 w 178721"/>
                <a:gd name="connsiteY2" fmla="*/ 558800 h 825500"/>
                <a:gd name="connsiteX3" fmla="*/ 178721 w 178721"/>
                <a:gd name="connsiteY3" fmla="*/ 825500 h 8255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78721" h="825500">
                  <a:moveTo>
                    <a:pt x="89821" y="0"/>
                  </a:moveTo>
                  <a:cubicBezTo>
                    <a:pt x="48546" y="112183"/>
                    <a:pt x="7271" y="224367"/>
                    <a:pt x="921" y="317500"/>
                  </a:cubicBezTo>
                  <a:cubicBezTo>
                    <a:pt x="-5429" y="410633"/>
                    <a:pt x="22088" y="474133"/>
                    <a:pt x="51721" y="558800"/>
                  </a:cubicBezTo>
                  <a:cubicBezTo>
                    <a:pt x="81354" y="643467"/>
                    <a:pt x="130037" y="734483"/>
                    <a:pt x="178721" y="825500"/>
                  </a:cubicBezTo>
                </a:path>
              </a:pathLst>
            </a:custGeom>
            <a:noFill/>
            <a:ln w="57150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0000" tIns="46800" rIns="90000" bIns="46800" numCol="1" rtlCol="0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GB" sz="2000" b="0" i="0" u="none" strike="noStrike" cap="none" normalizeH="0" baseline="0" dirty="0" smtClean="0">
                <a:ln>
                  <a:noFill/>
                </a:ln>
                <a:solidFill>
                  <a:srgbClr val="000066"/>
                </a:solidFill>
                <a:effectLst/>
                <a:latin typeface="Arial" charset="0"/>
              </a:endParaRPr>
            </a:p>
          </p:txBody>
        </p:sp>
      </p:grpSp>
      <p:cxnSp>
        <p:nvCxnSpPr>
          <p:cNvPr id="419" name="Straight Connector 418"/>
          <p:cNvCxnSpPr/>
          <p:nvPr/>
        </p:nvCxnSpPr>
        <p:spPr bwMode="auto">
          <a:xfrm>
            <a:off x="5233160" y="5768121"/>
            <a:ext cx="108000" cy="0"/>
          </a:xfrm>
          <a:prstGeom prst="line">
            <a:avLst/>
          </a:prstGeom>
          <a:ln w="571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4" name="Straight Arrow Connector 423"/>
          <p:cNvCxnSpPr/>
          <p:nvPr/>
        </p:nvCxnSpPr>
        <p:spPr>
          <a:xfrm>
            <a:off x="1402472" y="5552858"/>
            <a:ext cx="277057" cy="0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79" name="Group 478"/>
          <p:cNvGrpSpPr/>
          <p:nvPr/>
        </p:nvGrpSpPr>
        <p:grpSpPr>
          <a:xfrm>
            <a:off x="6025248" y="5790526"/>
            <a:ext cx="588292" cy="390"/>
            <a:chOff x="5747892" y="3295475"/>
            <a:chExt cx="588292" cy="390"/>
          </a:xfrm>
        </p:grpSpPr>
        <p:cxnSp>
          <p:nvCxnSpPr>
            <p:cNvPr id="426" name="Straight Connector 425"/>
            <p:cNvCxnSpPr/>
            <p:nvPr/>
          </p:nvCxnSpPr>
          <p:spPr bwMode="auto">
            <a:xfrm>
              <a:off x="5747892" y="3295865"/>
              <a:ext cx="216000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0" name="Straight Connector 439"/>
            <p:cNvCxnSpPr/>
            <p:nvPr/>
          </p:nvCxnSpPr>
          <p:spPr bwMode="auto">
            <a:xfrm>
              <a:off x="5969822" y="3295865"/>
              <a:ext cx="252000" cy="0"/>
            </a:xfrm>
            <a:prstGeom prst="line">
              <a:avLst/>
            </a:prstGeom>
            <a:ln w="57150">
              <a:solidFill>
                <a:srgbClr val="92D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1" name="Straight Connector 440"/>
            <p:cNvCxnSpPr/>
            <p:nvPr/>
          </p:nvCxnSpPr>
          <p:spPr bwMode="auto">
            <a:xfrm>
              <a:off x="6228184" y="3295475"/>
              <a:ext cx="108000" cy="0"/>
            </a:xfrm>
            <a:prstGeom prst="line">
              <a:avLst/>
            </a:prstGeom>
            <a:ln w="57150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42" name="Group 441"/>
          <p:cNvGrpSpPr/>
          <p:nvPr/>
        </p:nvGrpSpPr>
        <p:grpSpPr>
          <a:xfrm>
            <a:off x="6028213" y="5702155"/>
            <a:ext cx="588292" cy="323"/>
            <a:chOff x="5747892" y="3295475"/>
            <a:chExt cx="588292" cy="390"/>
          </a:xfrm>
        </p:grpSpPr>
        <p:cxnSp>
          <p:nvCxnSpPr>
            <p:cNvPr id="443" name="Straight Connector 442"/>
            <p:cNvCxnSpPr/>
            <p:nvPr/>
          </p:nvCxnSpPr>
          <p:spPr bwMode="auto">
            <a:xfrm>
              <a:off x="5747892" y="3295865"/>
              <a:ext cx="216000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4" name="Straight Connector 443"/>
            <p:cNvCxnSpPr/>
            <p:nvPr/>
          </p:nvCxnSpPr>
          <p:spPr bwMode="auto">
            <a:xfrm>
              <a:off x="5969822" y="3295865"/>
              <a:ext cx="252000" cy="0"/>
            </a:xfrm>
            <a:prstGeom prst="line">
              <a:avLst/>
            </a:prstGeom>
            <a:ln w="57150">
              <a:solidFill>
                <a:srgbClr val="92D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5" name="Straight Connector 444"/>
            <p:cNvCxnSpPr/>
            <p:nvPr/>
          </p:nvCxnSpPr>
          <p:spPr bwMode="auto">
            <a:xfrm>
              <a:off x="6228184" y="3295475"/>
              <a:ext cx="108000" cy="0"/>
            </a:xfrm>
            <a:prstGeom prst="line">
              <a:avLst/>
            </a:prstGeom>
            <a:ln w="57150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" name="Group 1"/>
          <p:cNvGrpSpPr/>
          <p:nvPr/>
        </p:nvGrpSpPr>
        <p:grpSpPr>
          <a:xfrm>
            <a:off x="4273292" y="4622035"/>
            <a:ext cx="515065" cy="1562142"/>
            <a:chOff x="3995936" y="2060848"/>
            <a:chExt cx="515065" cy="1562142"/>
          </a:xfrm>
        </p:grpSpPr>
        <p:cxnSp>
          <p:nvCxnSpPr>
            <p:cNvPr id="256" name="Straight Arrow Connector 255"/>
            <p:cNvCxnSpPr/>
            <p:nvPr/>
          </p:nvCxnSpPr>
          <p:spPr>
            <a:xfrm>
              <a:off x="3995936" y="2060848"/>
              <a:ext cx="72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7" name="Straight Arrow Connector 256"/>
            <p:cNvCxnSpPr/>
            <p:nvPr/>
          </p:nvCxnSpPr>
          <p:spPr>
            <a:xfrm>
              <a:off x="4283976" y="2570810"/>
              <a:ext cx="72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8" name="Straight Arrow Connector 257"/>
            <p:cNvCxnSpPr/>
            <p:nvPr/>
          </p:nvCxnSpPr>
          <p:spPr>
            <a:xfrm>
              <a:off x="4439001" y="3113028"/>
              <a:ext cx="72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9" name="Straight Arrow Connector 258"/>
            <p:cNvCxnSpPr/>
            <p:nvPr/>
          </p:nvCxnSpPr>
          <p:spPr>
            <a:xfrm>
              <a:off x="4211960" y="3622990"/>
              <a:ext cx="72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61" name="Straight Arrow Connector 260"/>
          <p:cNvCxnSpPr/>
          <p:nvPr/>
        </p:nvCxnSpPr>
        <p:spPr>
          <a:xfrm flipH="1">
            <a:off x="5231840" y="4630484"/>
            <a:ext cx="55972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2" name="Straight Arrow Connector 261"/>
          <p:cNvCxnSpPr/>
          <p:nvPr/>
        </p:nvCxnSpPr>
        <p:spPr>
          <a:xfrm flipH="1">
            <a:off x="5231840" y="5140446"/>
            <a:ext cx="55972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3" name="Straight Arrow Connector 262"/>
          <p:cNvCxnSpPr/>
          <p:nvPr/>
        </p:nvCxnSpPr>
        <p:spPr>
          <a:xfrm flipH="1">
            <a:off x="5231840" y="5682664"/>
            <a:ext cx="55972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4" name="Straight Arrow Connector 263"/>
          <p:cNvCxnSpPr/>
          <p:nvPr/>
        </p:nvCxnSpPr>
        <p:spPr>
          <a:xfrm flipH="1">
            <a:off x="5231840" y="6192626"/>
            <a:ext cx="55972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" name="Group 4"/>
          <p:cNvGrpSpPr/>
          <p:nvPr/>
        </p:nvGrpSpPr>
        <p:grpSpPr>
          <a:xfrm>
            <a:off x="1915716" y="2533572"/>
            <a:ext cx="844090" cy="436538"/>
            <a:chOff x="2570452" y="5296718"/>
            <a:chExt cx="844090" cy="436538"/>
          </a:xfrm>
        </p:grpSpPr>
        <p:grpSp>
          <p:nvGrpSpPr>
            <p:cNvPr id="482" name="Group 481"/>
            <p:cNvGrpSpPr/>
            <p:nvPr/>
          </p:nvGrpSpPr>
          <p:grpSpPr>
            <a:xfrm>
              <a:off x="2695479" y="5296718"/>
              <a:ext cx="605166" cy="436538"/>
              <a:chOff x="1318670" y="2187357"/>
              <a:chExt cx="758733" cy="667458"/>
            </a:xfrm>
          </p:grpSpPr>
          <p:sp>
            <p:nvSpPr>
              <p:cNvPr id="483" name="Freeform 482"/>
              <p:cNvSpPr/>
              <p:nvPr/>
            </p:nvSpPr>
            <p:spPr bwMode="auto">
              <a:xfrm rot="5628367">
                <a:off x="1383867" y="2161279"/>
                <a:ext cx="628339" cy="758733"/>
              </a:xfrm>
              <a:custGeom>
                <a:avLst/>
                <a:gdLst>
                  <a:gd name="connsiteX0" fmla="*/ 0 w 1068979"/>
                  <a:gd name="connsiteY0" fmla="*/ 330200 h 1241237"/>
                  <a:gd name="connsiteX1" fmla="*/ 177800 w 1068979"/>
                  <a:gd name="connsiteY1" fmla="*/ 88900 h 1241237"/>
                  <a:gd name="connsiteX2" fmla="*/ 457200 w 1068979"/>
                  <a:gd name="connsiteY2" fmla="*/ 0 h 1241237"/>
                  <a:gd name="connsiteX3" fmla="*/ 762000 w 1068979"/>
                  <a:gd name="connsiteY3" fmla="*/ 0 h 1241237"/>
                  <a:gd name="connsiteX4" fmla="*/ 889000 w 1068979"/>
                  <a:gd name="connsiteY4" fmla="*/ 88900 h 1241237"/>
                  <a:gd name="connsiteX5" fmla="*/ 1028700 w 1068979"/>
                  <a:gd name="connsiteY5" fmla="*/ 317500 h 1241237"/>
                  <a:gd name="connsiteX6" fmla="*/ 1066800 w 1068979"/>
                  <a:gd name="connsiteY6" fmla="*/ 622300 h 1241237"/>
                  <a:gd name="connsiteX7" fmla="*/ 977900 w 1068979"/>
                  <a:gd name="connsiteY7" fmla="*/ 1016000 h 1241237"/>
                  <a:gd name="connsiteX8" fmla="*/ 711200 w 1068979"/>
                  <a:gd name="connsiteY8" fmla="*/ 1231900 h 1241237"/>
                  <a:gd name="connsiteX9" fmla="*/ 203200 w 1068979"/>
                  <a:gd name="connsiteY9" fmla="*/ 1193800 h 1241237"/>
                  <a:gd name="connsiteX10" fmla="*/ 114300 w 1068979"/>
                  <a:gd name="connsiteY10" fmla="*/ 1117600 h 1241237"/>
                  <a:gd name="connsiteX11" fmla="*/ 114300 w 1068979"/>
                  <a:gd name="connsiteY11" fmla="*/ 1092200 h 124123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</a:cxnLst>
                <a:rect l="l" t="t" r="r" b="b"/>
                <a:pathLst>
                  <a:path w="1068979" h="1241237">
                    <a:moveTo>
                      <a:pt x="0" y="330200"/>
                    </a:moveTo>
                    <a:cubicBezTo>
                      <a:pt x="50800" y="237066"/>
                      <a:pt x="101600" y="143933"/>
                      <a:pt x="177800" y="88900"/>
                    </a:cubicBezTo>
                    <a:cubicBezTo>
                      <a:pt x="254000" y="33867"/>
                      <a:pt x="359833" y="14817"/>
                      <a:pt x="457200" y="0"/>
                    </a:cubicBezTo>
                    <a:cubicBezTo>
                      <a:pt x="554567" y="-14817"/>
                      <a:pt x="690033" y="-14817"/>
                      <a:pt x="762000" y="0"/>
                    </a:cubicBezTo>
                    <a:cubicBezTo>
                      <a:pt x="833967" y="14817"/>
                      <a:pt x="844550" y="35983"/>
                      <a:pt x="889000" y="88900"/>
                    </a:cubicBezTo>
                    <a:cubicBezTo>
                      <a:pt x="933450" y="141817"/>
                      <a:pt x="999067" y="228600"/>
                      <a:pt x="1028700" y="317500"/>
                    </a:cubicBezTo>
                    <a:cubicBezTo>
                      <a:pt x="1058333" y="406400"/>
                      <a:pt x="1075267" y="505883"/>
                      <a:pt x="1066800" y="622300"/>
                    </a:cubicBezTo>
                    <a:cubicBezTo>
                      <a:pt x="1058333" y="738717"/>
                      <a:pt x="1037167" y="914400"/>
                      <a:pt x="977900" y="1016000"/>
                    </a:cubicBezTo>
                    <a:cubicBezTo>
                      <a:pt x="918633" y="1117600"/>
                      <a:pt x="840317" y="1202267"/>
                      <a:pt x="711200" y="1231900"/>
                    </a:cubicBezTo>
                    <a:cubicBezTo>
                      <a:pt x="582083" y="1261533"/>
                      <a:pt x="302683" y="1212850"/>
                      <a:pt x="203200" y="1193800"/>
                    </a:cubicBezTo>
                    <a:cubicBezTo>
                      <a:pt x="103717" y="1174750"/>
                      <a:pt x="129117" y="1134533"/>
                      <a:pt x="114300" y="1117600"/>
                    </a:cubicBezTo>
                    <a:cubicBezTo>
                      <a:pt x="99483" y="1100667"/>
                      <a:pt x="106891" y="1096433"/>
                      <a:pt x="114300" y="1092200"/>
                    </a:cubicBezTo>
                  </a:path>
                </a:pathLst>
              </a:custGeom>
              <a:noFill/>
              <a:ln w="57150" cap="flat" cmpd="sng" algn="ctr">
                <a:solidFill>
                  <a:srgbClr val="92D05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0000" tIns="46800" rIns="90000" bIns="46800" numCol="1" rtlCol="0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GB" sz="2000" b="0" i="0" u="none" strike="noStrike" cap="none" normalizeH="0" baseline="0" dirty="0" smtClean="0">
                  <a:ln>
                    <a:noFill/>
                  </a:ln>
                  <a:solidFill>
                    <a:srgbClr val="000066"/>
                  </a:solidFill>
                  <a:effectLst/>
                  <a:latin typeface="Arial" charset="0"/>
                </a:endParaRPr>
              </a:p>
            </p:txBody>
          </p:sp>
          <p:sp>
            <p:nvSpPr>
              <p:cNvPr id="484" name="Freeform 483"/>
              <p:cNvSpPr/>
              <p:nvPr/>
            </p:nvSpPr>
            <p:spPr bwMode="auto">
              <a:xfrm rot="5453253">
                <a:off x="1580735" y="1987580"/>
                <a:ext cx="105051" cy="504605"/>
              </a:xfrm>
              <a:custGeom>
                <a:avLst/>
                <a:gdLst>
                  <a:gd name="connsiteX0" fmla="*/ 89821 w 178721"/>
                  <a:gd name="connsiteY0" fmla="*/ 0 h 825500"/>
                  <a:gd name="connsiteX1" fmla="*/ 921 w 178721"/>
                  <a:gd name="connsiteY1" fmla="*/ 317500 h 825500"/>
                  <a:gd name="connsiteX2" fmla="*/ 51721 w 178721"/>
                  <a:gd name="connsiteY2" fmla="*/ 558800 h 825500"/>
                  <a:gd name="connsiteX3" fmla="*/ 178721 w 178721"/>
                  <a:gd name="connsiteY3" fmla="*/ 825500 h 8255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78721" h="825500">
                    <a:moveTo>
                      <a:pt x="89821" y="0"/>
                    </a:moveTo>
                    <a:cubicBezTo>
                      <a:pt x="48546" y="112183"/>
                      <a:pt x="7271" y="224367"/>
                      <a:pt x="921" y="317500"/>
                    </a:cubicBezTo>
                    <a:cubicBezTo>
                      <a:pt x="-5429" y="410633"/>
                      <a:pt x="22088" y="474133"/>
                      <a:pt x="51721" y="558800"/>
                    </a:cubicBezTo>
                    <a:cubicBezTo>
                      <a:pt x="81354" y="643467"/>
                      <a:pt x="130037" y="734483"/>
                      <a:pt x="178721" y="825500"/>
                    </a:cubicBezTo>
                  </a:path>
                </a:pathLst>
              </a:custGeom>
              <a:noFill/>
              <a:ln w="57150" cap="flat" cmpd="sng" algn="ctr">
                <a:solidFill>
                  <a:srgbClr val="FF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0000" tIns="46800" rIns="90000" bIns="46800" numCol="1" rtlCol="0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GB" sz="2000" b="0" i="0" u="none" strike="noStrike" cap="none" normalizeH="0" baseline="0" dirty="0" smtClean="0">
                  <a:ln>
                    <a:noFill/>
                  </a:ln>
                  <a:solidFill>
                    <a:srgbClr val="000066"/>
                  </a:solidFill>
                  <a:effectLst/>
                  <a:latin typeface="Arial" charset="0"/>
                </a:endParaRPr>
              </a:p>
            </p:txBody>
          </p:sp>
        </p:grpSp>
        <p:cxnSp>
          <p:nvCxnSpPr>
            <p:cNvPr id="485" name="Straight Connector 484"/>
            <p:cNvCxnSpPr/>
            <p:nvPr/>
          </p:nvCxnSpPr>
          <p:spPr bwMode="auto">
            <a:xfrm>
              <a:off x="2570452" y="5430464"/>
              <a:ext cx="211120" cy="48000"/>
            </a:xfrm>
            <a:prstGeom prst="line">
              <a:avLst/>
            </a:prstGeom>
            <a:ln w="28575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6" name="Straight Connector 485"/>
            <p:cNvCxnSpPr/>
            <p:nvPr/>
          </p:nvCxnSpPr>
          <p:spPr bwMode="auto">
            <a:xfrm flipH="1">
              <a:off x="3258174" y="5410586"/>
              <a:ext cx="156368" cy="87755"/>
            </a:xfrm>
            <a:prstGeom prst="line">
              <a:avLst/>
            </a:prstGeom>
            <a:ln w="28575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5" name="Group 124"/>
          <p:cNvGrpSpPr/>
          <p:nvPr/>
        </p:nvGrpSpPr>
        <p:grpSpPr>
          <a:xfrm>
            <a:off x="1907704" y="1961998"/>
            <a:ext cx="828903" cy="436538"/>
            <a:chOff x="2570452" y="5296718"/>
            <a:chExt cx="828903" cy="436538"/>
          </a:xfrm>
        </p:grpSpPr>
        <p:grpSp>
          <p:nvGrpSpPr>
            <p:cNvPr id="126" name="Group 125"/>
            <p:cNvGrpSpPr/>
            <p:nvPr/>
          </p:nvGrpSpPr>
          <p:grpSpPr>
            <a:xfrm>
              <a:off x="2695479" y="5296718"/>
              <a:ext cx="605166" cy="436538"/>
              <a:chOff x="1318670" y="2187357"/>
              <a:chExt cx="758733" cy="667458"/>
            </a:xfrm>
          </p:grpSpPr>
          <p:sp>
            <p:nvSpPr>
              <p:cNvPr id="129" name="Freeform 128"/>
              <p:cNvSpPr/>
              <p:nvPr/>
            </p:nvSpPr>
            <p:spPr bwMode="auto">
              <a:xfrm rot="5628367">
                <a:off x="1383867" y="2161279"/>
                <a:ext cx="628339" cy="758733"/>
              </a:xfrm>
              <a:custGeom>
                <a:avLst/>
                <a:gdLst>
                  <a:gd name="connsiteX0" fmla="*/ 0 w 1068979"/>
                  <a:gd name="connsiteY0" fmla="*/ 330200 h 1241237"/>
                  <a:gd name="connsiteX1" fmla="*/ 177800 w 1068979"/>
                  <a:gd name="connsiteY1" fmla="*/ 88900 h 1241237"/>
                  <a:gd name="connsiteX2" fmla="*/ 457200 w 1068979"/>
                  <a:gd name="connsiteY2" fmla="*/ 0 h 1241237"/>
                  <a:gd name="connsiteX3" fmla="*/ 762000 w 1068979"/>
                  <a:gd name="connsiteY3" fmla="*/ 0 h 1241237"/>
                  <a:gd name="connsiteX4" fmla="*/ 889000 w 1068979"/>
                  <a:gd name="connsiteY4" fmla="*/ 88900 h 1241237"/>
                  <a:gd name="connsiteX5" fmla="*/ 1028700 w 1068979"/>
                  <a:gd name="connsiteY5" fmla="*/ 317500 h 1241237"/>
                  <a:gd name="connsiteX6" fmla="*/ 1066800 w 1068979"/>
                  <a:gd name="connsiteY6" fmla="*/ 622300 h 1241237"/>
                  <a:gd name="connsiteX7" fmla="*/ 977900 w 1068979"/>
                  <a:gd name="connsiteY7" fmla="*/ 1016000 h 1241237"/>
                  <a:gd name="connsiteX8" fmla="*/ 711200 w 1068979"/>
                  <a:gd name="connsiteY8" fmla="*/ 1231900 h 1241237"/>
                  <a:gd name="connsiteX9" fmla="*/ 203200 w 1068979"/>
                  <a:gd name="connsiteY9" fmla="*/ 1193800 h 1241237"/>
                  <a:gd name="connsiteX10" fmla="*/ 114300 w 1068979"/>
                  <a:gd name="connsiteY10" fmla="*/ 1117600 h 1241237"/>
                  <a:gd name="connsiteX11" fmla="*/ 114300 w 1068979"/>
                  <a:gd name="connsiteY11" fmla="*/ 1092200 h 124123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</a:cxnLst>
                <a:rect l="l" t="t" r="r" b="b"/>
                <a:pathLst>
                  <a:path w="1068979" h="1241237">
                    <a:moveTo>
                      <a:pt x="0" y="330200"/>
                    </a:moveTo>
                    <a:cubicBezTo>
                      <a:pt x="50800" y="237066"/>
                      <a:pt x="101600" y="143933"/>
                      <a:pt x="177800" y="88900"/>
                    </a:cubicBezTo>
                    <a:cubicBezTo>
                      <a:pt x="254000" y="33867"/>
                      <a:pt x="359833" y="14817"/>
                      <a:pt x="457200" y="0"/>
                    </a:cubicBezTo>
                    <a:cubicBezTo>
                      <a:pt x="554567" y="-14817"/>
                      <a:pt x="690033" y="-14817"/>
                      <a:pt x="762000" y="0"/>
                    </a:cubicBezTo>
                    <a:cubicBezTo>
                      <a:pt x="833967" y="14817"/>
                      <a:pt x="844550" y="35983"/>
                      <a:pt x="889000" y="88900"/>
                    </a:cubicBezTo>
                    <a:cubicBezTo>
                      <a:pt x="933450" y="141817"/>
                      <a:pt x="999067" y="228600"/>
                      <a:pt x="1028700" y="317500"/>
                    </a:cubicBezTo>
                    <a:cubicBezTo>
                      <a:pt x="1058333" y="406400"/>
                      <a:pt x="1075267" y="505883"/>
                      <a:pt x="1066800" y="622300"/>
                    </a:cubicBezTo>
                    <a:cubicBezTo>
                      <a:pt x="1058333" y="738717"/>
                      <a:pt x="1037167" y="914400"/>
                      <a:pt x="977900" y="1016000"/>
                    </a:cubicBezTo>
                    <a:cubicBezTo>
                      <a:pt x="918633" y="1117600"/>
                      <a:pt x="840317" y="1202267"/>
                      <a:pt x="711200" y="1231900"/>
                    </a:cubicBezTo>
                    <a:cubicBezTo>
                      <a:pt x="582083" y="1261533"/>
                      <a:pt x="302683" y="1212850"/>
                      <a:pt x="203200" y="1193800"/>
                    </a:cubicBezTo>
                    <a:cubicBezTo>
                      <a:pt x="103717" y="1174750"/>
                      <a:pt x="129117" y="1134533"/>
                      <a:pt x="114300" y="1117600"/>
                    </a:cubicBezTo>
                    <a:cubicBezTo>
                      <a:pt x="99483" y="1100667"/>
                      <a:pt x="106891" y="1096433"/>
                      <a:pt x="114300" y="1092200"/>
                    </a:cubicBezTo>
                  </a:path>
                </a:pathLst>
              </a:custGeom>
              <a:noFill/>
              <a:ln w="57150" cap="flat" cmpd="sng" algn="ctr">
                <a:solidFill>
                  <a:srgbClr val="92D05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0000" tIns="46800" rIns="90000" bIns="46800" numCol="1" rtlCol="0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GB" sz="2000" b="0" i="0" u="none" strike="noStrike" cap="none" normalizeH="0" baseline="0" dirty="0" smtClean="0">
                  <a:ln>
                    <a:noFill/>
                  </a:ln>
                  <a:solidFill>
                    <a:srgbClr val="000066"/>
                  </a:solidFill>
                  <a:effectLst/>
                  <a:latin typeface="Arial" charset="0"/>
                </a:endParaRPr>
              </a:p>
            </p:txBody>
          </p:sp>
          <p:sp>
            <p:nvSpPr>
              <p:cNvPr id="130" name="Freeform 129"/>
              <p:cNvSpPr/>
              <p:nvPr/>
            </p:nvSpPr>
            <p:spPr bwMode="auto">
              <a:xfrm rot="5453253">
                <a:off x="1580735" y="1987580"/>
                <a:ext cx="105051" cy="504605"/>
              </a:xfrm>
              <a:custGeom>
                <a:avLst/>
                <a:gdLst>
                  <a:gd name="connsiteX0" fmla="*/ 89821 w 178721"/>
                  <a:gd name="connsiteY0" fmla="*/ 0 h 825500"/>
                  <a:gd name="connsiteX1" fmla="*/ 921 w 178721"/>
                  <a:gd name="connsiteY1" fmla="*/ 317500 h 825500"/>
                  <a:gd name="connsiteX2" fmla="*/ 51721 w 178721"/>
                  <a:gd name="connsiteY2" fmla="*/ 558800 h 825500"/>
                  <a:gd name="connsiteX3" fmla="*/ 178721 w 178721"/>
                  <a:gd name="connsiteY3" fmla="*/ 825500 h 8255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78721" h="825500">
                    <a:moveTo>
                      <a:pt x="89821" y="0"/>
                    </a:moveTo>
                    <a:cubicBezTo>
                      <a:pt x="48546" y="112183"/>
                      <a:pt x="7271" y="224367"/>
                      <a:pt x="921" y="317500"/>
                    </a:cubicBezTo>
                    <a:cubicBezTo>
                      <a:pt x="-5429" y="410633"/>
                      <a:pt x="22088" y="474133"/>
                      <a:pt x="51721" y="558800"/>
                    </a:cubicBezTo>
                    <a:cubicBezTo>
                      <a:pt x="81354" y="643467"/>
                      <a:pt x="130037" y="734483"/>
                      <a:pt x="178721" y="825500"/>
                    </a:cubicBezTo>
                  </a:path>
                </a:pathLst>
              </a:custGeom>
              <a:noFill/>
              <a:ln w="57150" cap="flat" cmpd="sng" algn="ctr">
                <a:solidFill>
                  <a:srgbClr val="FF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0000" tIns="46800" rIns="90000" bIns="46800" numCol="1" rtlCol="0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GB" sz="2000" b="0" i="0" u="none" strike="noStrike" cap="none" normalizeH="0" baseline="0" dirty="0" smtClean="0">
                  <a:ln>
                    <a:noFill/>
                  </a:ln>
                  <a:solidFill>
                    <a:srgbClr val="000066"/>
                  </a:solidFill>
                  <a:effectLst/>
                  <a:latin typeface="Arial" charset="0"/>
                </a:endParaRPr>
              </a:p>
            </p:txBody>
          </p:sp>
        </p:grpSp>
        <p:cxnSp>
          <p:nvCxnSpPr>
            <p:cNvPr id="127" name="Straight Connector 126"/>
            <p:cNvCxnSpPr/>
            <p:nvPr/>
          </p:nvCxnSpPr>
          <p:spPr bwMode="auto">
            <a:xfrm>
              <a:off x="2570452" y="5430464"/>
              <a:ext cx="211120" cy="48000"/>
            </a:xfrm>
            <a:prstGeom prst="line">
              <a:avLst/>
            </a:prstGeom>
            <a:ln w="28575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Straight Connector 127"/>
            <p:cNvCxnSpPr/>
            <p:nvPr/>
          </p:nvCxnSpPr>
          <p:spPr bwMode="auto">
            <a:xfrm flipH="1">
              <a:off x="3202561" y="5478464"/>
              <a:ext cx="196794" cy="49316"/>
            </a:xfrm>
            <a:prstGeom prst="line">
              <a:avLst/>
            </a:prstGeom>
            <a:ln w="28575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2" name="Group 131"/>
          <p:cNvGrpSpPr/>
          <p:nvPr/>
        </p:nvGrpSpPr>
        <p:grpSpPr>
          <a:xfrm>
            <a:off x="2104739" y="3648933"/>
            <a:ext cx="605166" cy="436538"/>
            <a:chOff x="1318670" y="2187357"/>
            <a:chExt cx="758733" cy="667458"/>
          </a:xfrm>
        </p:grpSpPr>
        <p:sp>
          <p:nvSpPr>
            <p:cNvPr id="135" name="Freeform 134"/>
            <p:cNvSpPr/>
            <p:nvPr/>
          </p:nvSpPr>
          <p:spPr bwMode="auto">
            <a:xfrm rot="5628367">
              <a:off x="1383867" y="2161279"/>
              <a:ext cx="628339" cy="758733"/>
            </a:xfrm>
            <a:custGeom>
              <a:avLst/>
              <a:gdLst>
                <a:gd name="connsiteX0" fmla="*/ 0 w 1068979"/>
                <a:gd name="connsiteY0" fmla="*/ 330200 h 1241237"/>
                <a:gd name="connsiteX1" fmla="*/ 177800 w 1068979"/>
                <a:gd name="connsiteY1" fmla="*/ 88900 h 1241237"/>
                <a:gd name="connsiteX2" fmla="*/ 457200 w 1068979"/>
                <a:gd name="connsiteY2" fmla="*/ 0 h 1241237"/>
                <a:gd name="connsiteX3" fmla="*/ 762000 w 1068979"/>
                <a:gd name="connsiteY3" fmla="*/ 0 h 1241237"/>
                <a:gd name="connsiteX4" fmla="*/ 889000 w 1068979"/>
                <a:gd name="connsiteY4" fmla="*/ 88900 h 1241237"/>
                <a:gd name="connsiteX5" fmla="*/ 1028700 w 1068979"/>
                <a:gd name="connsiteY5" fmla="*/ 317500 h 1241237"/>
                <a:gd name="connsiteX6" fmla="*/ 1066800 w 1068979"/>
                <a:gd name="connsiteY6" fmla="*/ 622300 h 1241237"/>
                <a:gd name="connsiteX7" fmla="*/ 977900 w 1068979"/>
                <a:gd name="connsiteY7" fmla="*/ 1016000 h 1241237"/>
                <a:gd name="connsiteX8" fmla="*/ 711200 w 1068979"/>
                <a:gd name="connsiteY8" fmla="*/ 1231900 h 1241237"/>
                <a:gd name="connsiteX9" fmla="*/ 203200 w 1068979"/>
                <a:gd name="connsiteY9" fmla="*/ 1193800 h 1241237"/>
                <a:gd name="connsiteX10" fmla="*/ 114300 w 1068979"/>
                <a:gd name="connsiteY10" fmla="*/ 1117600 h 1241237"/>
                <a:gd name="connsiteX11" fmla="*/ 114300 w 1068979"/>
                <a:gd name="connsiteY11" fmla="*/ 1092200 h 12412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</a:cxnLst>
              <a:rect l="l" t="t" r="r" b="b"/>
              <a:pathLst>
                <a:path w="1068979" h="1241237">
                  <a:moveTo>
                    <a:pt x="0" y="330200"/>
                  </a:moveTo>
                  <a:cubicBezTo>
                    <a:pt x="50800" y="237066"/>
                    <a:pt x="101600" y="143933"/>
                    <a:pt x="177800" y="88900"/>
                  </a:cubicBezTo>
                  <a:cubicBezTo>
                    <a:pt x="254000" y="33867"/>
                    <a:pt x="359833" y="14817"/>
                    <a:pt x="457200" y="0"/>
                  </a:cubicBezTo>
                  <a:cubicBezTo>
                    <a:pt x="554567" y="-14817"/>
                    <a:pt x="690033" y="-14817"/>
                    <a:pt x="762000" y="0"/>
                  </a:cubicBezTo>
                  <a:cubicBezTo>
                    <a:pt x="833967" y="14817"/>
                    <a:pt x="844550" y="35983"/>
                    <a:pt x="889000" y="88900"/>
                  </a:cubicBezTo>
                  <a:cubicBezTo>
                    <a:pt x="933450" y="141817"/>
                    <a:pt x="999067" y="228600"/>
                    <a:pt x="1028700" y="317500"/>
                  </a:cubicBezTo>
                  <a:cubicBezTo>
                    <a:pt x="1058333" y="406400"/>
                    <a:pt x="1075267" y="505883"/>
                    <a:pt x="1066800" y="622300"/>
                  </a:cubicBezTo>
                  <a:cubicBezTo>
                    <a:pt x="1058333" y="738717"/>
                    <a:pt x="1037167" y="914400"/>
                    <a:pt x="977900" y="1016000"/>
                  </a:cubicBezTo>
                  <a:cubicBezTo>
                    <a:pt x="918633" y="1117600"/>
                    <a:pt x="840317" y="1202267"/>
                    <a:pt x="711200" y="1231900"/>
                  </a:cubicBezTo>
                  <a:cubicBezTo>
                    <a:pt x="582083" y="1261533"/>
                    <a:pt x="302683" y="1212850"/>
                    <a:pt x="203200" y="1193800"/>
                  </a:cubicBezTo>
                  <a:cubicBezTo>
                    <a:pt x="103717" y="1174750"/>
                    <a:pt x="129117" y="1134533"/>
                    <a:pt x="114300" y="1117600"/>
                  </a:cubicBezTo>
                  <a:cubicBezTo>
                    <a:pt x="99483" y="1100667"/>
                    <a:pt x="106891" y="1096433"/>
                    <a:pt x="114300" y="1092200"/>
                  </a:cubicBezTo>
                </a:path>
              </a:pathLst>
            </a:custGeom>
            <a:noFill/>
            <a:ln w="57150" cap="flat" cmpd="sng" algn="ctr">
              <a:solidFill>
                <a:srgbClr val="FFC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0000" tIns="46800" rIns="90000" bIns="46800" numCol="1" rtlCol="0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GB" sz="2000" b="0" i="0" u="none" strike="noStrike" cap="none" normalizeH="0" baseline="0" dirty="0" smtClean="0">
                <a:ln>
                  <a:noFill/>
                </a:ln>
                <a:solidFill>
                  <a:srgbClr val="000066"/>
                </a:solidFill>
                <a:effectLst/>
                <a:latin typeface="Arial" charset="0"/>
              </a:endParaRPr>
            </a:p>
          </p:txBody>
        </p:sp>
        <p:sp>
          <p:nvSpPr>
            <p:cNvPr id="136" name="Freeform 135"/>
            <p:cNvSpPr/>
            <p:nvPr/>
          </p:nvSpPr>
          <p:spPr bwMode="auto">
            <a:xfrm rot="5453253">
              <a:off x="1580735" y="1987580"/>
              <a:ext cx="105051" cy="504605"/>
            </a:xfrm>
            <a:custGeom>
              <a:avLst/>
              <a:gdLst>
                <a:gd name="connsiteX0" fmla="*/ 89821 w 178721"/>
                <a:gd name="connsiteY0" fmla="*/ 0 h 825500"/>
                <a:gd name="connsiteX1" fmla="*/ 921 w 178721"/>
                <a:gd name="connsiteY1" fmla="*/ 317500 h 825500"/>
                <a:gd name="connsiteX2" fmla="*/ 51721 w 178721"/>
                <a:gd name="connsiteY2" fmla="*/ 558800 h 825500"/>
                <a:gd name="connsiteX3" fmla="*/ 178721 w 178721"/>
                <a:gd name="connsiteY3" fmla="*/ 825500 h 8255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78721" h="825500">
                  <a:moveTo>
                    <a:pt x="89821" y="0"/>
                  </a:moveTo>
                  <a:cubicBezTo>
                    <a:pt x="48546" y="112183"/>
                    <a:pt x="7271" y="224367"/>
                    <a:pt x="921" y="317500"/>
                  </a:cubicBezTo>
                  <a:cubicBezTo>
                    <a:pt x="-5429" y="410633"/>
                    <a:pt x="22088" y="474133"/>
                    <a:pt x="51721" y="558800"/>
                  </a:cubicBezTo>
                  <a:cubicBezTo>
                    <a:pt x="81354" y="643467"/>
                    <a:pt x="130037" y="734483"/>
                    <a:pt x="178721" y="825500"/>
                  </a:cubicBezTo>
                </a:path>
              </a:pathLst>
            </a:custGeom>
            <a:noFill/>
            <a:ln w="57150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0000" tIns="46800" rIns="90000" bIns="46800" numCol="1" rtlCol="0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GB" sz="2000" b="0" i="0" u="none" strike="noStrike" cap="none" normalizeH="0" baseline="0" dirty="0" smtClean="0">
                <a:ln>
                  <a:noFill/>
                </a:ln>
                <a:solidFill>
                  <a:srgbClr val="000066"/>
                </a:solidFill>
                <a:effectLst/>
                <a:latin typeface="Arial" charset="0"/>
              </a:endParaRPr>
            </a:p>
          </p:txBody>
        </p:sp>
      </p:grpSp>
      <p:cxnSp>
        <p:nvCxnSpPr>
          <p:cNvPr id="133" name="Straight Connector 132"/>
          <p:cNvCxnSpPr/>
          <p:nvPr/>
        </p:nvCxnSpPr>
        <p:spPr bwMode="auto">
          <a:xfrm>
            <a:off x="1979712" y="3782679"/>
            <a:ext cx="211120" cy="48000"/>
          </a:xfrm>
          <a:prstGeom prst="line">
            <a:avLst/>
          </a:prstGeom>
          <a:ln w="2857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Connector 133"/>
          <p:cNvCxnSpPr/>
          <p:nvPr/>
        </p:nvCxnSpPr>
        <p:spPr bwMode="auto">
          <a:xfrm flipH="1" flipV="1">
            <a:off x="2545127" y="3979427"/>
            <a:ext cx="158305" cy="75969"/>
          </a:xfrm>
          <a:prstGeom prst="line">
            <a:avLst/>
          </a:prstGeom>
          <a:ln w="2857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4" name="Rectangle 97"/>
          <p:cNvSpPr>
            <a:spLocks noChangeArrowheads="1"/>
          </p:cNvSpPr>
          <p:nvPr/>
        </p:nvSpPr>
        <p:spPr bwMode="auto">
          <a:xfrm>
            <a:off x="2880376" y="2453708"/>
            <a:ext cx="1115248" cy="7386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kumimoji="0" lang="en-US" altLang="ja-JP" sz="1400" b="1" dirty="0" smtClean="0">
                <a:latin typeface="Calibri" pitchFamily="127" charset="0"/>
              </a:rPr>
              <a:t>2</a:t>
            </a:r>
            <a:r>
              <a:rPr kumimoji="0" lang="en-US" altLang="ja-JP" sz="1400" b="1" baseline="30000" dirty="0" smtClean="0">
                <a:latin typeface="Calibri" pitchFamily="127" charset="0"/>
              </a:rPr>
              <a:t>nd</a:t>
            </a:r>
            <a:r>
              <a:rPr kumimoji="0" lang="en-US" altLang="ja-JP" sz="1400" b="1" dirty="0" smtClean="0">
                <a:latin typeface="Calibri" pitchFamily="127" charset="0"/>
              </a:rPr>
              <a:t> RE</a:t>
            </a:r>
          </a:p>
          <a:p>
            <a:r>
              <a:rPr lang="en-US" altLang="ja-JP" sz="1400" b="1" dirty="0" smtClean="0">
                <a:latin typeface="Calibri" pitchFamily="127" charset="0"/>
              </a:rPr>
              <a:t>Digestion</a:t>
            </a:r>
          </a:p>
          <a:p>
            <a:r>
              <a:rPr lang="en-US" altLang="ja-JP" sz="1400" b="1" dirty="0" smtClean="0">
                <a:latin typeface="Calibri" pitchFamily="127" charset="0"/>
              </a:rPr>
              <a:t>and </a:t>
            </a:r>
            <a:r>
              <a:rPr lang="en-US" altLang="ja-JP" sz="1400" b="1" dirty="0" smtClean="0">
                <a:latin typeface="Calibri" pitchFamily="127" charset="0"/>
              </a:rPr>
              <a:t>ligation</a:t>
            </a:r>
            <a:endParaRPr lang="en-GB" altLang="ja-JP" sz="1400" b="1" dirty="0">
              <a:latin typeface="Calibri" pitchFamily="127" charset="0"/>
            </a:endParaRPr>
          </a:p>
        </p:txBody>
      </p:sp>
      <p:sp>
        <p:nvSpPr>
          <p:cNvPr id="305" name="Rectangle 97"/>
          <p:cNvSpPr>
            <a:spLocks noChangeArrowheads="1"/>
          </p:cNvSpPr>
          <p:nvPr/>
        </p:nvSpPr>
        <p:spPr bwMode="auto">
          <a:xfrm>
            <a:off x="233869" y="1533250"/>
            <a:ext cx="2274997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b="1" u="sng" dirty="0" smtClean="0">
                <a:latin typeface="Calibri" pitchFamily="127" charset="0"/>
              </a:rPr>
              <a:t>A. Conventional </a:t>
            </a:r>
            <a:r>
              <a:rPr lang="en-US" altLang="ja-JP" b="1" u="sng" dirty="0">
                <a:latin typeface="Calibri" pitchFamily="127" charset="0"/>
              </a:rPr>
              <a:t>4C</a:t>
            </a:r>
            <a:endParaRPr lang="en-GB" altLang="ja-JP" b="1" u="sng" dirty="0">
              <a:latin typeface="Calibri" pitchFamily="127" charset="0"/>
            </a:endParaRPr>
          </a:p>
        </p:txBody>
      </p:sp>
      <p:cxnSp>
        <p:nvCxnSpPr>
          <p:cNvPr id="403" name="Straight Arrow Connector 402"/>
          <p:cNvCxnSpPr/>
          <p:nvPr/>
        </p:nvCxnSpPr>
        <p:spPr>
          <a:xfrm>
            <a:off x="1402472" y="2987344"/>
            <a:ext cx="277057" cy="0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92" name="Group 491"/>
          <p:cNvGrpSpPr/>
          <p:nvPr/>
        </p:nvGrpSpPr>
        <p:grpSpPr>
          <a:xfrm>
            <a:off x="1926418" y="3146340"/>
            <a:ext cx="844090" cy="436538"/>
            <a:chOff x="2570452" y="5296718"/>
            <a:chExt cx="844090" cy="436538"/>
          </a:xfrm>
        </p:grpSpPr>
        <p:grpSp>
          <p:nvGrpSpPr>
            <p:cNvPr id="493" name="Group 492"/>
            <p:cNvGrpSpPr/>
            <p:nvPr/>
          </p:nvGrpSpPr>
          <p:grpSpPr>
            <a:xfrm>
              <a:off x="2695479" y="5296718"/>
              <a:ext cx="605166" cy="436538"/>
              <a:chOff x="1318670" y="2187357"/>
              <a:chExt cx="758733" cy="667458"/>
            </a:xfrm>
          </p:grpSpPr>
          <p:sp>
            <p:nvSpPr>
              <p:cNvPr id="496" name="Freeform 495"/>
              <p:cNvSpPr/>
              <p:nvPr/>
            </p:nvSpPr>
            <p:spPr bwMode="auto">
              <a:xfrm rot="5628367">
                <a:off x="1383867" y="2161279"/>
                <a:ext cx="628339" cy="758733"/>
              </a:xfrm>
              <a:custGeom>
                <a:avLst/>
                <a:gdLst>
                  <a:gd name="connsiteX0" fmla="*/ 0 w 1068979"/>
                  <a:gd name="connsiteY0" fmla="*/ 330200 h 1241237"/>
                  <a:gd name="connsiteX1" fmla="*/ 177800 w 1068979"/>
                  <a:gd name="connsiteY1" fmla="*/ 88900 h 1241237"/>
                  <a:gd name="connsiteX2" fmla="*/ 457200 w 1068979"/>
                  <a:gd name="connsiteY2" fmla="*/ 0 h 1241237"/>
                  <a:gd name="connsiteX3" fmla="*/ 762000 w 1068979"/>
                  <a:gd name="connsiteY3" fmla="*/ 0 h 1241237"/>
                  <a:gd name="connsiteX4" fmla="*/ 889000 w 1068979"/>
                  <a:gd name="connsiteY4" fmla="*/ 88900 h 1241237"/>
                  <a:gd name="connsiteX5" fmla="*/ 1028700 w 1068979"/>
                  <a:gd name="connsiteY5" fmla="*/ 317500 h 1241237"/>
                  <a:gd name="connsiteX6" fmla="*/ 1066800 w 1068979"/>
                  <a:gd name="connsiteY6" fmla="*/ 622300 h 1241237"/>
                  <a:gd name="connsiteX7" fmla="*/ 977900 w 1068979"/>
                  <a:gd name="connsiteY7" fmla="*/ 1016000 h 1241237"/>
                  <a:gd name="connsiteX8" fmla="*/ 711200 w 1068979"/>
                  <a:gd name="connsiteY8" fmla="*/ 1231900 h 1241237"/>
                  <a:gd name="connsiteX9" fmla="*/ 203200 w 1068979"/>
                  <a:gd name="connsiteY9" fmla="*/ 1193800 h 1241237"/>
                  <a:gd name="connsiteX10" fmla="*/ 114300 w 1068979"/>
                  <a:gd name="connsiteY10" fmla="*/ 1117600 h 1241237"/>
                  <a:gd name="connsiteX11" fmla="*/ 114300 w 1068979"/>
                  <a:gd name="connsiteY11" fmla="*/ 1092200 h 124123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</a:cxnLst>
                <a:rect l="l" t="t" r="r" b="b"/>
                <a:pathLst>
                  <a:path w="1068979" h="1241237">
                    <a:moveTo>
                      <a:pt x="0" y="330200"/>
                    </a:moveTo>
                    <a:cubicBezTo>
                      <a:pt x="50800" y="237066"/>
                      <a:pt x="101600" y="143933"/>
                      <a:pt x="177800" y="88900"/>
                    </a:cubicBezTo>
                    <a:cubicBezTo>
                      <a:pt x="254000" y="33867"/>
                      <a:pt x="359833" y="14817"/>
                      <a:pt x="457200" y="0"/>
                    </a:cubicBezTo>
                    <a:cubicBezTo>
                      <a:pt x="554567" y="-14817"/>
                      <a:pt x="690033" y="-14817"/>
                      <a:pt x="762000" y="0"/>
                    </a:cubicBezTo>
                    <a:cubicBezTo>
                      <a:pt x="833967" y="14817"/>
                      <a:pt x="844550" y="35983"/>
                      <a:pt x="889000" y="88900"/>
                    </a:cubicBezTo>
                    <a:cubicBezTo>
                      <a:pt x="933450" y="141817"/>
                      <a:pt x="999067" y="228600"/>
                      <a:pt x="1028700" y="317500"/>
                    </a:cubicBezTo>
                    <a:cubicBezTo>
                      <a:pt x="1058333" y="406400"/>
                      <a:pt x="1075267" y="505883"/>
                      <a:pt x="1066800" y="622300"/>
                    </a:cubicBezTo>
                    <a:cubicBezTo>
                      <a:pt x="1058333" y="738717"/>
                      <a:pt x="1037167" y="914400"/>
                      <a:pt x="977900" y="1016000"/>
                    </a:cubicBezTo>
                    <a:cubicBezTo>
                      <a:pt x="918633" y="1117600"/>
                      <a:pt x="840317" y="1202267"/>
                      <a:pt x="711200" y="1231900"/>
                    </a:cubicBezTo>
                    <a:cubicBezTo>
                      <a:pt x="582083" y="1261533"/>
                      <a:pt x="302683" y="1212850"/>
                      <a:pt x="203200" y="1193800"/>
                    </a:cubicBezTo>
                    <a:cubicBezTo>
                      <a:pt x="103717" y="1174750"/>
                      <a:pt x="129117" y="1134533"/>
                      <a:pt x="114300" y="1117600"/>
                    </a:cubicBezTo>
                    <a:cubicBezTo>
                      <a:pt x="99483" y="1100667"/>
                      <a:pt x="106891" y="1096433"/>
                      <a:pt x="114300" y="1092200"/>
                    </a:cubicBezTo>
                  </a:path>
                </a:pathLst>
              </a:custGeom>
              <a:noFill/>
              <a:ln w="57150" cap="flat" cmpd="sng" algn="ctr">
                <a:solidFill>
                  <a:srgbClr val="92D05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0000" tIns="46800" rIns="90000" bIns="46800" numCol="1" rtlCol="0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GB" sz="2000" b="0" i="0" u="none" strike="noStrike" cap="none" normalizeH="0" baseline="0" dirty="0" smtClean="0">
                  <a:ln>
                    <a:noFill/>
                  </a:ln>
                  <a:solidFill>
                    <a:srgbClr val="000066"/>
                  </a:solidFill>
                  <a:effectLst/>
                  <a:latin typeface="Arial" charset="0"/>
                </a:endParaRPr>
              </a:p>
            </p:txBody>
          </p:sp>
          <p:sp>
            <p:nvSpPr>
              <p:cNvPr id="497" name="Freeform 496"/>
              <p:cNvSpPr/>
              <p:nvPr/>
            </p:nvSpPr>
            <p:spPr bwMode="auto">
              <a:xfrm rot="5453253">
                <a:off x="1580735" y="1987580"/>
                <a:ext cx="105051" cy="504605"/>
              </a:xfrm>
              <a:custGeom>
                <a:avLst/>
                <a:gdLst>
                  <a:gd name="connsiteX0" fmla="*/ 89821 w 178721"/>
                  <a:gd name="connsiteY0" fmla="*/ 0 h 825500"/>
                  <a:gd name="connsiteX1" fmla="*/ 921 w 178721"/>
                  <a:gd name="connsiteY1" fmla="*/ 317500 h 825500"/>
                  <a:gd name="connsiteX2" fmla="*/ 51721 w 178721"/>
                  <a:gd name="connsiteY2" fmla="*/ 558800 h 825500"/>
                  <a:gd name="connsiteX3" fmla="*/ 178721 w 178721"/>
                  <a:gd name="connsiteY3" fmla="*/ 825500 h 8255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78721" h="825500">
                    <a:moveTo>
                      <a:pt x="89821" y="0"/>
                    </a:moveTo>
                    <a:cubicBezTo>
                      <a:pt x="48546" y="112183"/>
                      <a:pt x="7271" y="224367"/>
                      <a:pt x="921" y="317500"/>
                    </a:cubicBezTo>
                    <a:cubicBezTo>
                      <a:pt x="-5429" y="410633"/>
                      <a:pt x="22088" y="474133"/>
                      <a:pt x="51721" y="558800"/>
                    </a:cubicBezTo>
                    <a:cubicBezTo>
                      <a:pt x="81354" y="643467"/>
                      <a:pt x="130037" y="734483"/>
                      <a:pt x="178721" y="825500"/>
                    </a:cubicBezTo>
                  </a:path>
                </a:pathLst>
              </a:custGeom>
              <a:noFill/>
              <a:ln w="57150" cap="flat" cmpd="sng" algn="ctr">
                <a:solidFill>
                  <a:srgbClr val="FF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0000" tIns="46800" rIns="90000" bIns="46800" numCol="1" rtlCol="0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GB" sz="2000" b="0" i="0" u="none" strike="noStrike" cap="none" normalizeH="0" baseline="0" dirty="0" smtClean="0">
                  <a:ln>
                    <a:noFill/>
                  </a:ln>
                  <a:solidFill>
                    <a:srgbClr val="000066"/>
                  </a:solidFill>
                  <a:effectLst/>
                  <a:latin typeface="Arial" charset="0"/>
                </a:endParaRPr>
              </a:p>
            </p:txBody>
          </p:sp>
        </p:grpSp>
        <p:cxnSp>
          <p:nvCxnSpPr>
            <p:cNvPr id="494" name="Straight Connector 493"/>
            <p:cNvCxnSpPr/>
            <p:nvPr/>
          </p:nvCxnSpPr>
          <p:spPr bwMode="auto">
            <a:xfrm>
              <a:off x="2570452" y="5430464"/>
              <a:ext cx="211120" cy="48000"/>
            </a:xfrm>
            <a:prstGeom prst="line">
              <a:avLst/>
            </a:prstGeom>
            <a:ln w="28575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5" name="Straight Connector 494"/>
            <p:cNvCxnSpPr/>
            <p:nvPr/>
          </p:nvCxnSpPr>
          <p:spPr bwMode="auto">
            <a:xfrm flipH="1">
              <a:off x="3258174" y="5410586"/>
              <a:ext cx="156368" cy="87755"/>
            </a:xfrm>
            <a:prstGeom prst="line">
              <a:avLst/>
            </a:prstGeom>
            <a:ln w="28575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15" name="Group 514"/>
          <p:cNvGrpSpPr/>
          <p:nvPr/>
        </p:nvGrpSpPr>
        <p:grpSpPr>
          <a:xfrm>
            <a:off x="652102" y="3564410"/>
            <a:ext cx="605165" cy="436538"/>
            <a:chOff x="1318670" y="2187357"/>
            <a:chExt cx="758733" cy="667458"/>
          </a:xfrm>
        </p:grpSpPr>
        <p:sp>
          <p:nvSpPr>
            <p:cNvPr id="516" name="Freeform 515"/>
            <p:cNvSpPr/>
            <p:nvPr/>
          </p:nvSpPr>
          <p:spPr bwMode="auto">
            <a:xfrm rot="5628367">
              <a:off x="1383867" y="2161279"/>
              <a:ext cx="628339" cy="758733"/>
            </a:xfrm>
            <a:custGeom>
              <a:avLst/>
              <a:gdLst>
                <a:gd name="connsiteX0" fmla="*/ 0 w 1068979"/>
                <a:gd name="connsiteY0" fmla="*/ 330200 h 1241237"/>
                <a:gd name="connsiteX1" fmla="*/ 177800 w 1068979"/>
                <a:gd name="connsiteY1" fmla="*/ 88900 h 1241237"/>
                <a:gd name="connsiteX2" fmla="*/ 457200 w 1068979"/>
                <a:gd name="connsiteY2" fmla="*/ 0 h 1241237"/>
                <a:gd name="connsiteX3" fmla="*/ 762000 w 1068979"/>
                <a:gd name="connsiteY3" fmla="*/ 0 h 1241237"/>
                <a:gd name="connsiteX4" fmla="*/ 889000 w 1068979"/>
                <a:gd name="connsiteY4" fmla="*/ 88900 h 1241237"/>
                <a:gd name="connsiteX5" fmla="*/ 1028700 w 1068979"/>
                <a:gd name="connsiteY5" fmla="*/ 317500 h 1241237"/>
                <a:gd name="connsiteX6" fmla="*/ 1066800 w 1068979"/>
                <a:gd name="connsiteY6" fmla="*/ 622300 h 1241237"/>
                <a:gd name="connsiteX7" fmla="*/ 977900 w 1068979"/>
                <a:gd name="connsiteY7" fmla="*/ 1016000 h 1241237"/>
                <a:gd name="connsiteX8" fmla="*/ 711200 w 1068979"/>
                <a:gd name="connsiteY8" fmla="*/ 1231900 h 1241237"/>
                <a:gd name="connsiteX9" fmla="*/ 203200 w 1068979"/>
                <a:gd name="connsiteY9" fmla="*/ 1193800 h 1241237"/>
                <a:gd name="connsiteX10" fmla="*/ 114300 w 1068979"/>
                <a:gd name="connsiteY10" fmla="*/ 1117600 h 1241237"/>
                <a:gd name="connsiteX11" fmla="*/ 114300 w 1068979"/>
                <a:gd name="connsiteY11" fmla="*/ 1092200 h 12412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</a:cxnLst>
              <a:rect l="l" t="t" r="r" b="b"/>
              <a:pathLst>
                <a:path w="1068979" h="1241237">
                  <a:moveTo>
                    <a:pt x="0" y="330200"/>
                  </a:moveTo>
                  <a:cubicBezTo>
                    <a:pt x="50800" y="237066"/>
                    <a:pt x="101600" y="143933"/>
                    <a:pt x="177800" y="88900"/>
                  </a:cubicBezTo>
                  <a:cubicBezTo>
                    <a:pt x="254000" y="33867"/>
                    <a:pt x="359833" y="14817"/>
                    <a:pt x="457200" y="0"/>
                  </a:cubicBezTo>
                  <a:cubicBezTo>
                    <a:pt x="554567" y="-14817"/>
                    <a:pt x="690033" y="-14817"/>
                    <a:pt x="762000" y="0"/>
                  </a:cubicBezTo>
                  <a:cubicBezTo>
                    <a:pt x="833967" y="14817"/>
                    <a:pt x="844550" y="35983"/>
                    <a:pt x="889000" y="88900"/>
                  </a:cubicBezTo>
                  <a:cubicBezTo>
                    <a:pt x="933450" y="141817"/>
                    <a:pt x="999067" y="228600"/>
                    <a:pt x="1028700" y="317500"/>
                  </a:cubicBezTo>
                  <a:cubicBezTo>
                    <a:pt x="1058333" y="406400"/>
                    <a:pt x="1075267" y="505883"/>
                    <a:pt x="1066800" y="622300"/>
                  </a:cubicBezTo>
                  <a:cubicBezTo>
                    <a:pt x="1058333" y="738717"/>
                    <a:pt x="1037167" y="914400"/>
                    <a:pt x="977900" y="1016000"/>
                  </a:cubicBezTo>
                  <a:cubicBezTo>
                    <a:pt x="918633" y="1117600"/>
                    <a:pt x="840317" y="1202267"/>
                    <a:pt x="711200" y="1231900"/>
                  </a:cubicBezTo>
                  <a:cubicBezTo>
                    <a:pt x="582083" y="1261533"/>
                    <a:pt x="302683" y="1212850"/>
                    <a:pt x="203200" y="1193800"/>
                  </a:cubicBezTo>
                  <a:cubicBezTo>
                    <a:pt x="103717" y="1174750"/>
                    <a:pt x="129117" y="1134533"/>
                    <a:pt x="114300" y="1117600"/>
                  </a:cubicBezTo>
                  <a:cubicBezTo>
                    <a:pt x="99483" y="1100667"/>
                    <a:pt x="106891" y="1096433"/>
                    <a:pt x="114300" y="1092200"/>
                  </a:cubicBezTo>
                </a:path>
              </a:pathLst>
            </a:custGeom>
            <a:noFill/>
            <a:ln w="57150" cap="flat" cmpd="sng" algn="ctr">
              <a:solidFill>
                <a:srgbClr val="FFC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0000" tIns="46800" rIns="90000" bIns="46800" numCol="1" rtlCol="0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GB" sz="2000" b="0" i="0" u="none" strike="noStrike" cap="none" normalizeH="0" baseline="0" dirty="0" smtClean="0">
                <a:ln>
                  <a:noFill/>
                </a:ln>
                <a:solidFill>
                  <a:srgbClr val="000066"/>
                </a:solidFill>
                <a:effectLst/>
                <a:latin typeface="Arial" charset="0"/>
              </a:endParaRPr>
            </a:p>
          </p:txBody>
        </p:sp>
        <p:sp>
          <p:nvSpPr>
            <p:cNvPr id="517" name="Freeform 516"/>
            <p:cNvSpPr/>
            <p:nvPr/>
          </p:nvSpPr>
          <p:spPr bwMode="auto">
            <a:xfrm rot="5453253">
              <a:off x="1580735" y="1987580"/>
              <a:ext cx="105051" cy="504605"/>
            </a:xfrm>
            <a:custGeom>
              <a:avLst/>
              <a:gdLst>
                <a:gd name="connsiteX0" fmla="*/ 89821 w 178721"/>
                <a:gd name="connsiteY0" fmla="*/ 0 h 825500"/>
                <a:gd name="connsiteX1" fmla="*/ 921 w 178721"/>
                <a:gd name="connsiteY1" fmla="*/ 317500 h 825500"/>
                <a:gd name="connsiteX2" fmla="*/ 51721 w 178721"/>
                <a:gd name="connsiteY2" fmla="*/ 558800 h 825500"/>
                <a:gd name="connsiteX3" fmla="*/ 178721 w 178721"/>
                <a:gd name="connsiteY3" fmla="*/ 825500 h 8255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78721" h="825500">
                  <a:moveTo>
                    <a:pt x="89821" y="0"/>
                  </a:moveTo>
                  <a:cubicBezTo>
                    <a:pt x="48546" y="112183"/>
                    <a:pt x="7271" y="224367"/>
                    <a:pt x="921" y="317500"/>
                  </a:cubicBezTo>
                  <a:cubicBezTo>
                    <a:pt x="-5429" y="410633"/>
                    <a:pt x="22088" y="474133"/>
                    <a:pt x="51721" y="558800"/>
                  </a:cubicBezTo>
                  <a:cubicBezTo>
                    <a:pt x="81354" y="643467"/>
                    <a:pt x="130037" y="734483"/>
                    <a:pt x="178721" y="825500"/>
                  </a:cubicBezTo>
                </a:path>
              </a:pathLst>
            </a:custGeom>
            <a:noFill/>
            <a:ln w="57150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0000" tIns="46800" rIns="90000" bIns="46800" numCol="1" rtlCol="0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GB" sz="2000" b="0" i="0" u="none" strike="noStrike" cap="none" normalizeH="0" baseline="0" dirty="0" smtClean="0">
                <a:ln>
                  <a:noFill/>
                </a:ln>
                <a:solidFill>
                  <a:srgbClr val="000066"/>
                </a:solidFill>
                <a:effectLst/>
                <a:latin typeface="Arial" charset="0"/>
              </a:endParaRPr>
            </a:p>
          </p:txBody>
        </p:sp>
      </p:grpSp>
      <p:grpSp>
        <p:nvGrpSpPr>
          <p:cNvPr id="518" name="Group 517"/>
          <p:cNvGrpSpPr/>
          <p:nvPr/>
        </p:nvGrpSpPr>
        <p:grpSpPr>
          <a:xfrm>
            <a:off x="593931" y="1991264"/>
            <a:ext cx="605165" cy="436539"/>
            <a:chOff x="357039" y="3416751"/>
            <a:chExt cx="605165" cy="436539"/>
          </a:xfrm>
        </p:grpSpPr>
        <p:sp>
          <p:nvSpPr>
            <p:cNvPr id="519" name="Freeform 518"/>
            <p:cNvSpPr/>
            <p:nvPr/>
          </p:nvSpPr>
          <p:spPr bwMode="auto">
            <a:xfrm rot="5628367">
              <a:off x="454145" y="3345230"/>
              <a:ext cx="410954" cy="605165"/>
            </a:xfrm>
            <a:custGeom>
              <a:avLst/>
              <a:gdLst>
                <a:gd name="connsiteX0" fmla="*/ 0 w 1068979"/>
                <a:gd name="connsiteY0" fmla="*/ 330200 h 1241237"/>
                <a:gd name="connsiteX1" fmla="*/ 177800 w 1068979"/>
                <a:gd name="connsiteY1" fmla="*/ 88900 h 1241237"/>
                <a:gd name="connsiteX2" fmla="*/ 457200 w 1068979"/>
                <a:gd name="connsiteY2" fmla="*/ 0 h 1241237"/>
                <a:gd name="connsiteX3" fmla="*/ 762000 w 1068979"/>
                <a:gd name="connsiteY3" fmla="*/ 0 h 1241237"/>
                <a:gd name="connsiteX4" fmla="*/ 889000 w 1068979"/>
                <a:gd name="connsiteY4" fmla="*/ 88900 h 1241237"/>
                <a:gd name="connsiteX5" fmla="*/ 1028700 w 1068979"/>
                <a:gd name="connsiteY5" fmla="*/ 317500 h 1241237"/>
                <a:gd name="connsiteX6" fmla="*/ 1066800 w 1068979"/>
                <a:gd name="connsiteY6" fmla="*/ 622300 h 1241237"/>
                <a:gd name="connsiteX7" fmla="*/ 977900 w 1068979"/>
                <a:gd name="connsiteY7" fmla="*/ 1016000 h 1241237"/>
                <a:gd name="connsiteX8" fmla="*/ 711200 w 1068979"/>
                <a:gd name="connsiteY8" fmla="*/ 1231900 h 1241237"/>
                <a:gd name="connsiteX9" fmla="*/ 203200 w 1068979"/>
                <a:gd name="connsiteY9" fmla="*/ 1193800 h 1241237"/>
                <a:gd name="connsiteX10" fmla="*/ 114300 w 1068979"/>
                <a:gd name="connsiteY10" fmla="*/ 1117600 h 1241237"/>
                <a:gd name="connsiteX11" fmla="*/ 114300 w 1068979"/>
                <a:gd name="connsiteY11" fmla="*/ 1092200 h 12412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</a:cxnLst>
              <a:rect l="l" t="t" r="r" b="b"/>
              <a:pathLst>
                <a:path w="1068979" h="1241237">
                  <a:moveTo>
                    <a:pt x="0" y="330200"/>
                  </a:moveTo>
                  <a:cubicBezTo>
                    <a:pt x="50800" y="237066"/>
                    <a:pt x="101600" y="143933"/>
                    <a:pt x="177800" y="88900"/>
                  </a:cubicBezTo>
                  <a:cubicBezTo>
                    <a:pt x="254000" y="33867"/>
                    <a:pt x="359833" y="14817"/>
                    <a:pt x="457200" y="0"/>
                  </a:cubicBezTo>
                  <a:cubicBezTo>
                    <a:pt x="554567" y="-14817"/>
                    <a:pt x="690033" y="-14817"/>
                    <a:pt x="762000" y="0"/>
                  </a:cubicBezTo>
                  <a:cubicBezTo>
                    <a:pt x="833967" y="14817"/>
                    <a:pt x="844550" y="35983"/>
                    <a:pt x="889000" y="88900"/>
                  </a:cubicBezTo>
                  <a:cubicBezTo>
                    <a:pt x="933450" y="141817"/>
                    <a:pt x="999067" y="228600"/>
                    <a:pt x="1028700" y="317500"/>
                  </a:cubicBezTo>
                  <a:cubicBezTo>
                    <a:pt x="1058333" y="406400"/>
                    <a:pt x="1075267" y="505883"/>
                    <a:pt x="1066800" y="622300"/>
                  </a:cubicBezTo>
                  <a:cubicBezTo>
                    <a:pt x="1058333" y="738717"/>
                    <a:pt x="1037167" y="914400"/>
                    <a:pt x="977900" y="1016000"/>
                  </a:cubicBezTo>
                  <a:cubicBezTo>
                    <a:pt x="918633" y="1117600"/>
                    <a:pt x="840317" y="1202267"/>
                    <a:pt x="711200" y="1231900"/>
                  </a:cubicBezTo>
                  <a:cubicBezTo>
                    <a:pt x="582083" y="1261533"/>
                    <a:pt x="302683" y="1212850"/>
                    <a:pt x="203200" y="1193800"/>
                  </a:cubicBezTo>
                  <a:cubicBezTo>
                    <a:pt x="103717" y="1174750"/>
                    <a:pt x="129117" y="1134533"/>
                    <a:pt x="114300" y="1117600"/>
                  </a:cubicBezTo>
                  <a:cubicBezTo>
                    <a:pt x="99483" y="1100667"/>
                    <a:pt x="106891" y="1096433"/>
                    <a:pt x="114300" y="1092200"/>
                  </a:cubicBezTo>
                </a:path>
              </a:pathLst>
            </a:custGeom>
            <a:noFill/>
            <a:ln w="57150" cap="flat" cmpd="sng" algn="ctr">
              <a:solidFill>
                <a:srgbClr val="92D05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0000" tIns="46800" rIns="90000" bIns="46800" numCol="1" rtlCol="0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GB" sz="2000" b="0" i="0" u="none" strike="noStrike" cap="none" normalizeH="0" baseline="0" dirty="0" smtClean="0">
                <a:ln>
                  <a:noFill/>
                </a:ln>
                <a:solidFill>
                  <a:srgbClr val="000066"/>
                </a:solidFill>
                <a:effectLst/>
                <a:latin typeface="Arial" charset="0"/>
              </a:endParaRPr>
            </a:p>
          </p:txBody>
        </p:sp>
        <p:sp>
          <p:nvSpPr>
            <p:cNvPr id="520" name="Freeform 519"/>
            <p:cNvSpPr/>
            <p:nvPr/>
          </p:nvSpPr>
          <p:spPr bwMode="auto">
            <a:xfrm rot="5453253">
              <a:off x="573603" y="3249867"/>
              <a:ext cx="68706" cy="402473"/>
            </a:xfrm>
            <a:custGeom>
              <a:avLst/>
              <a:gdLst>
                <a:gd name="connsiteX0" fmla="*/ 89821 w 178721"/>
                <a:gd name="connsiteY0" fmla="*/ 0 h 825500"/>
                <a:gd name="connsiteX1" fmla="*/ 921 w 178721"/>
                <a:gd name="connsiteY1" fmla="*/ 317500 h 825500"/>
                <a:gd name="connsiteX2" fmla="*/ 51721 w 178721"/>
                <a:gd name="connsiteY2" fmla="*/ 558800 h 825500"/>
                <a:gd name="connsiteX3" fmla="*/ 178721 w 178721"/>
                <a:gd name="connsiteY3" fmla="*/ 825500 h 8255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78721" h="825500">
                  <a:moveTo>
                    <a:pt x="89821" y="0"/>
                  </a:moveTo>
                  <a:cubicBezTo>
                    <a:pt x="48546" y="112183"/>
                    <a:pt x="7271" y="224367"/>
                    <a:pt x="921" y="317500"/>
                  </a:cubicBezTo>
                  <a:cubicBezTo>
                    <a:pt x="-5429" y="410633"/>
                    <a:pt x="22088" y="474133"/>
                    <a:pt x="51721" y="558800"/>
                  </a:cubicBezTo>
                  <a:cubicBezTo>
                    <a:pt x="81354" y="643467"/>
                    <a:pt x="130037" y="734483"/>
                    <a:pt x="178721" y="825500"/>
                  </a:cubicBezTo>
                </a:path>
              </a:pathLst>
            </a:custGeom>
            <a:noFill/>
            <a:ln w="57150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0000" tIns="46800" rIns="90000" bIns="46800" numCol="1" rtlCol="0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GB" sz="2000" b="0" i="0" u="none" strike="noStrike" cap="none" normalizeH="0" baseline="0" dirty="0" smtClean="0">
                <a:ln>
                  <a:noFill/>
                </a:ln>
                <a:solidFill>
                  <a:srgbClr val="000066"/>
                </a:solidFill>
                <a:effectLst/>
                <a:latin typeface="Arial" charset="0"/>
              </a:endParaRPr>
            </a:p>
          </p:txBody>
        </p:sp>
      </p:grpSp>
      <p:grpSp>
        <p:nvGrpSpPr>
          <p:cNvPr id="521" name="Group 520"/>
          <p:cNvGrpSpPr/>
          <p:nvPr/>
        </p:nvGrpSpPr>
        <p:grpSpPr>
          <a:xfrm>
            <a:off x="620770" y="2497566"/>
            <a:ext cx="605165" cy="436539"/>
            <a:chOff x="357039" y="3416751"/>
            <a:chExt cx="605165" cy="436539"/>
          </a:xfrm>
        </p:grpSpPr>
        <p:sp>
          <p:nvSpPr>
            <p:cNvPr id="522" name="Freeform 521"/>
            <p:cNvSpPr/>
            <p:nvPr/>
          </p:nvSpPr>
          <p:spPr bwMode="auto">
            <a:xfrm rot="5628367">
              <a:off x="454145" y="3345230"/>
              <a:ext cx="410954" cy="605165"/>
            </a:xfrm>
            <a:custGeom>
              <a:avLst/>
              <a:gdLst>
                <a:gd name="connsiteX0" fmla="*/ 0 w 1068979"/>
                <a:gd name="connsiteY0" fmla="*/ 330200 h 1241237"/>
                <a:gd name="connsiteX1" fmla="*/ 177800 w 1068979"/>
                <a:gd name="connsiteY1" fmla="*/ 88900 h 1241237"/>
                <a:gd name="connsiteX2" fmla="*/ 457200 w 1068979"/>
                <a:gd name="connsiteY2" fmla="*/ 0 h 1241237"/>
                <a:gd name="connsiteX3" fmla="*/ 762000 w 1068979"/>
                <a:gd name="connsiteY3" fmla="*/ 0 h 1241237"/>
                <a:gd name="connsiteX4" fmla="*/ 889000 w 1068979"/>
                <a:gd name="connsiteY4" fmla="*/ 88900 h 1241237"/>
                <a:gd name="connsiteX5" fmla="*/ 1028700 w 1068979"/>
                <a:gd name="connsiteY5" fmla="*/ 317500 h 1241237"/>
                <a:gd name="connsiteX6" fmla="*/ 1066800 w 1068979"/>
                <a:gd name="connsiteY6" fmla="*/ 622300 h 1241237"/>
                <a:gd name="connsiteX7" fmla="*/ 977900 w 1068979"/>
                <a:gd name="connsiteY7" fmla="*/ 1016000 h 1241237"/>
                <a:gd name="connsiteX8" fmla="*/ 711200 w 1068979"/>
                <a:gd name="connsiteY8" fmla="*/ 1231900 h 1241237"/>
                <a:gd name="connsiteX9" fmla="*/ 203200 w 1068979"/>
                <a:gd name="connsiteY9" fmla="*/ 1193800 h 1241237"/>
                <a:gd name="connsiteX10" fmla="*/ 114300 w 1068979"/>
                <a:gd name="connsiteY10" fmla="*/ 1117600 h 1241237"/>
                <a:gd name="connsiteX11" fmla="*/ 114300 w 1068979"/>
                <a:gd name="connsiteY11" fmla="*/ 1092200 h 12412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</a:cxnLst>
              <a:rect l="l" t="t" r="r" b="b"/>
              <a:pathLst>
                <a:path w="1068979" h="1241237">
                  <a:moveTo>
                    <a:pt x="0" y="330200"/>
                  </a:moveTo>
                  <a:cubicBezTo>
                    <a:pt x="50800" y="237066"/>
                    <a:pt x="101600" y="143933"/>
                    <a:pt x="177800" y="88900"/>
                  </a:cubicBezTo>
                  <a:cubicBezTo>
                    <a:pt x="254000" y="33867"/>
                    <a:pt x="359833" y="14817"/>
                    <a:pt x="457200" y="0"/>
                  </a:cubicBezTo>
                  <a:cubicBezTo>
                    <a:pt x="554567" y="-14817"/>
                    <a:pt x="690033" y="-14817"/>
                    <a:pt x="762000" y="0"/>
                  </a:cubicBezTo>
                  <a:cubicBezTo>
                    <a:pt x="833967" y="14817"/>
                    <a:pt x="844550" y="35983"/>
                    <a:pt x="889000" y="88900"/>
                  </a:cubicBezTo>
                  <a:cubicBezTo>
                    <a:pt x="933450" y="141817"/>
                    <a:pt x="999067" y="228600"/>
                    <a:pt x="1028700" y="317500"/>
                  </a:cubicBezTo>
                  <a:cubicBezTo>
                    <a:pt x="1058333" y="406400"/>
                    <a:pt x="1075267" y="505883"/>
                    <a:pt x="1066800" y="622300"/>
                  </a:cubicBezTo>
                  <a:cubicBezTo>
                    <a:pt x="1058333" y="738717"/>
                    <a:pt x="1037167" y="914400"/>
                    <a:pt x="977900" y="1016000"/>
                  </a:cubicBezTo>
                  <a:cubicBezTo>
                    <a:pt x="918633" y="1117600"/>
                    <a:pt x="840317" y="1202267"/>
                    <a:pt x="711200" y="1231900"/>
                  </a:cubicBezTo>
                  <a:cubicBezTo>
                    <a:pt x="582083" y="1261533"/>
                    <a:pt x="302683" y="1212850"/>
                    <a:pt x="203200" y="1193800"/>
                  </a:cubicBezTo>
                  <a:cubicBezTo>
                    <a:pt x="103717" y="1174750"/>
                    <a:pt x="129117" y="1134533"/>
                    <a:pt x="114300" y="1117600"/>
                  </a:cubicBezTo>
                  <a:cubicBezTo>
                    <a:pt x="99483" y="1100667"/>
                    <a:pt x="106891" y="1096433"/>
                    <a:pt x="114300" y="1092200"/>
                  </a:cubicBezTo>
                </a:path>
              </a:pathLst>
            </a:custGeom>
            <a:noFill/>
            <a:ln w="57150" cap="flat" cmpd="sng" algn="ctr">
              <a:solidFill>
                <a:srgbClr val="92D05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0000" tIns="46800" rIns="90000" bIns="46800" numCol="1" rtlCol="0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GB" sz="2000" b="0" i="0" u="none" strike="noStrike" cap="none" normalizeH="0" baseline="0" dirty="0" smtClean="0">
                <a:ln>
                  <a:noFill/>
                </a:ln>
                <a:solidFill>
                  <a:srgbClr val="000066"/>
                </a:solidFill>
                <a:effectLst/>
                <a:latin typeface="Arial" charset="0"/>
              </a:endParaRPr>
            </a:p>
          </p:txBody>
        </p:sp>
        <p:sp>
          <p:nvSpPr>
            <p:cNvPr id="523" name="Freeform 522"/>
            <p:cNvSpPr/>
            <p:nvPr/>
          </p:nvSpPr>
          <p:spPr bwMode="auto">
            <a:xfrm rot="5453253">
              <a:off x="573603" y="3249867"/>
              <a:ext cx="68706" cy="402473"/>
            </a:xfrm>
            <a:custGeom>
              <a:avLst/>
              <a:gdLst>
                <a:gd name="connsiteX0" fmla="*/ 89821 w 178721"/>
                <a:gd name="connsiteY0" fmla="*/ 0 h 825500"/>
                <a:gd name="connsiteX1" fmla="*/ 921 w 178721"/>
                <a:gd name="connsiteY1" fmla="*/ 317500 h 825500"/>
                <a:gd name="connsiteX2" fmla="*/ 51721 w 178721"/>
                <a:gd name="connsiteY2" fmla="*/ 558800 h 825500"/>
                <a:gd name="connsiteX3" fmla="*/ 178721 w 178721"/>
                <a:gd name="connsiteY3" fmla="*/ 825500 h 8255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78721" h="825500">
                  <a:moveTo>
                    <a:pt x="89821" y="0"/>
                  </a:moveTo>
                  <a:cubicBezTo>
                    <a:pt x="48546" y="112183"/>
                    <a:pt x="7271" y="224367"/>
                    <a:pt x="921" y="317500"/>
                  </a:cubicBezTo>
                  <a:cubicBezTo>
                    <a:pt x="-5429" y="410633"/>
                    <a:pt x="22088" y="474133"/>
                    <a:pt x="51721" y="558800"/>
                  </a:cubicBezTo>
                  <a:cubicBezTo>
                    <a:pt x="81354" y="643467"/>
                    <a:pt x="130037" y="734483"/>
                    <a:pt x="178721" y="825500"/>
                  </a:cubicBezTo>
                </a:path>
              </a:pathLst>
            </a:custGeom>
            <a:noFill/>
            <a:ln w="57150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0000" tIns="46800" rIns="90000" bIns="46800" numCol="1" rtlCol="0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GB" sz="2000" b="0" i="0" u="none" strike="noStrike" cap="none" normalizeH="0" baseline="0" dirty="0" smtClean="0">
                <a:ln>
                  <a:noFill/>
                </a:ln>
                <a:solidFill>
                  <a:srgbClr val="000066"/>
                </a:solidFill>
                <a:effectLst/>
                <a:latin typeface="Arial" charset="0"/>
              </a:endParaRPr>
            </a:p>
          </p:txBody>
        </p:sp>
      </p:grpSp>
      <p:grpSp>
        <p:nvGrpSpPr>
          <p:cNvPr id="524" name="Group 523"/>
          <p:cNvGrpSpPr/>
          <p:nvPr/>
        </p:nvGrpSpPr>
        <p:grpSpPr>
          <a:xfrm>
            <a:off x="644534" y="3041050"/>
            <a:ext cx="605165" cy="436539"/>
            <a:chOff x="357039" y="3416751"/>
            <a:chExt cx="605165" cy="436539"/>
          </a:xfrm>
        </p:grpSpPr>
        <p:sp>
          <p:nvSpPr>
            <p:cNvPr id="525" name="Freeform 524"/>
            <p:cNvSpPr/>
            <p:nvPr/>
          </p:nvSpPr>
          <p:spPr bwMode="auto">
            <a:xfrm rot="5628367">
              <a:off x="454145" y="3345230"/>
              <a:ext cx="410954" cy="605165"/>
            </a:xfrm>
            <a:custGeom>
              <a:avLst/>
              <a:gdLst>
                <a:gd name="connsiteX0" fmla="*/ 0 w 1068979"/>
                <a:gd name="connsiteY0" fmla="*/ 330200 h 1241237"/>
                <a:gd name="connsiteX1" fmla="*/ 177800 w 1068979"/>
                <a:gd name="connsiteY1" fmla="*/ 88900 h 1241237"/>
                <a:gd name="connsiteX2" fmla="*/ 457200 w 1068979"/>
                <a:gd name="connsiteY2" fmla="*/ 0 h 1241237"/>
                <a:gd name="connsiteX3" fmla="*/ 762000 w 1068979"/>
                <a:gd name="connsiteY3" fmla="*/ 0 h 1241237"/>
                <a:gd name="connsiteX4" fmla="*/ 889000 w 1068979"/>
                <a:gd name="connsiteY4" fmla="*/ 88900 h 1241237"/>
                <a:gd name="connsiteX5" fmla="*/ 1028700 w 1068979"/>
                <a:gd name="connsiteY5" fmla="*/ 317500 h 1241237"/>
                <a:gd name="connsiteX6" fmla="*/ 1066800 w 1068979"/>
                <a:gd name="connsiteY6" fmla="*/ 622300 h 1241237"/>
                <a:gd name="connsiteX7" fmla="*/ 977900 w 1068979"/>
                <a:gd name="connsiteY7" fmla="*/ 1016000 h 1241237"/>
                <a:gd name="connsiteX8" fmla="*/ 711200 w 1068979"/>
                <a:gd name="connsiteY8" fmla="*/ 1231900 h 1241237"/>
                <a:gd name="connsiteX9" fmla="*/ 203200 w 1068979"/>
                <a:gd name="connsiteY9" fmla="*/ 1193800 h 1241237"/>
                <a:gd name="connsiteX10" fmla="*/ 114300 w 1068979"/>
                <a:gd name="connsiteY10" fmla="*/ 1117600 h 1241237"/>
                <a:gd name="connsiteX11" fmla="*/ 114300 w 1068979"/>
                <a:gd name="connsiteY11" fmla="*/ 1092200 h 12412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</a:cxnLst>
              <a:rect l="l" t="t" r="r" b="b"/>
              <a:pathLst>
                <a:path w="1068979" h="1241237">
                  <a:moveTo>
                    <a:pt x="0" y="330200"/>
                  </a:moveTo>
                  <a:cubicBezTo>
                    <a:pt x="50800" y="237066"/>
                    <a:pt x="101600" y="143933"/>
                    <a:pt x="177800" y="88900"/>
                  </a:cubicBezTo>
                  <a:cubicBezTo>
                    <a:pt x="254000" y="33867"/>
                    <a:pt x="359833" y="14817"/>
                    <a:pt x="457200" y="0"/>
                  </a:cubicBezTo>
                  <a:cubicBezTo>
                    <a:pt x="554567" y="-14817"/>
                    <a:pt x="690033" y="-14817"/>
                    <a:pt x="762000" y="0"/>
                  </a:cubicBezTo>
                  <a:cubicBezTo>
                    <a:pt x="833967" y="14817"/>
                    <a:pt x="844550" y="35983"/>
                    <a:pt x="889000" y="88900"/>
                  </a:cubicBezTo>
                  <a:cubicBezTo>
                    <a:pt x="933450" y="141817"/>
                    <a:pt x="999067" y="228600"/>
                    <a:pt x="1028700" y="317500"/>
                  </a:cubicBezTo>
                  <a:cubicBezTo>
                    <a:pt x="1058333" y="406400"/>
                    <a:pt x="1075267" y="505883"/>
                    <a:pt x="1066800" y="622300"/>
                  </a:cubicBezTo>
                  <a:cubicBezTo>
                    <a:pt x="1058333" y="738717"/>
                    <a:pt x="1037167" y="914400"/>
                    <a:pt x="977900" y="1016000"/>
                  </a:cubicBezTo>
                  <a:cubicBezTo>
                    <a:pt x="918633" y="1117600"/>
                    <a:pt x="840317" y="1202267"/>
                    <a:pt x="711200" y="1231900"/>
                  </a:cubicBezTo>
                  <a:cubicBezTo>
                    <a:pt x="582083" y="1261533"/>
                    <a:pt x="302683" y="1212850"/>
                    <a:pt x="203200" y="1193800"/>
                  </a:cubicBezTo>
                  <a:cubicBezTo>
                    <a:pt x="103717" y="1174750"/>
                    <a:pt x="129117" y="1134533"/>
                    <a:pt x="114300" y="1117600"/>
                  </a:cubicBezTo>
                  <a:cubicBezTo>
                    <a:pt x="99483" y="1100667"/>
                    <a:pt x="106891" y="1096433"/>
                    <a:pt x="114300" y="1092200"/>
                  </a:cubicBezTo>
                </a:path>
              </a:pathLst>
            </a:custGeom>
            <a:noFill/>
            <a:ln w="57150" cap="flat" cmpd="sng" algn="ctr">
              <a:solidFill>
                <a:srgbClr val="92D05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0000" tIns="46800" rIns="90000" bIns="46800" numCol="1" rtlCol="0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GB" sz="2000" b="0" i="0" u="none" strike="noStrike" cap="none" normalizeH="0" baseline="0" dirty="0" smtClean="0">
                <a:ln>
                  <a:noFill/>
                </a:ln>
                <a:solidFill>
                  <a:srgbClr val="000066"/>
                </a:solidFill>
                <a:effectLst/>
                <a:latin typeface="Arial" charset="0"/>
              </a:endParaRPr>
            </a:p>
          </p:txBody>
        </p:sp>
        <p:sp>
          <p:nvSpPr>
            <p:cNvPr id="526" name="Freeform 525"/>
            <p:cNvSpPr/>
            <p:nvPr/>
          </p:nvSpPr>
          <p:spPr bwMode="auto">
            <a:xfrm rot="5453253">
              <a:off x="573603" y="3249867"/>
              <a:ext cx="68706" cy="402473"/>
            </a:xfrm>
            <a:custGeom>
              <a:avLst/>
              <a:gdLst>
                <a:gd name="connsiteX0" fmla="*/ 89821 w 178721"/>
                <a:gd name="connsiteY0" fmla="*/ 0 h 825500"/>
                <a:gd name="connsiteX1" fmla="*/ 921 w 178721"/>
                <a:gd name="connsiteY1" fmla="*/ 317500 h 825500"/>
                <a:gd name="connsiteX2" fmla="*/ 51721 w 178721"/>
                <a:gd name="connsiteY2" fmla="*/ 558800 h 825500"/>
                <a:gd name="connsiteX3" fmla="*/ 178721 w 178721"/>
                <a:gd name="connsiteY3" fmla="*/ 825500 h 8255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78721" h="825500">
                  <a:moveTo>
                    <a:pt x="89821" y="0"/>
                  </a:moveTo>
                  <a:cubicBezTo>
                    <a:pt x="48546" y="112183"/>
                    <a:pt x="7271" y="224367"/>
                    <a:pt x="921" y="317500"/>
                  </a:cubicBezTo>
                  <a:cubicBezTo>
                    <a:pt x="-5429" y="410633"/>
                    <a:pt x="22088" y="474133"/>
                    <a:pt x="51721" y="558800"/>
                  </a:cubicBezTo>
                  <a:cubicBezTo>
                    <a:pt x="81354" y="643467"/>
                    <a:pt x="130037" y="734483"/>
                    <a:pt x="178721" y="825500"/>
                  </a:cubicBezTo>
                </a:path>
              </a:pathLst>
            </a:custGeom>
            <a:noFill/>
            <a:ln w="57150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0000" tIns="46800" rIns="90000" bIns="46800" numCol="1" rtlCol="0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GB" sz="2000" b="0" i="0" u="none" strike="noStrike" cap="none" normalizeH="0" baseline="0" dirty="0" smtClean="0">
                <a:ln>
                  <a:noFill/>
                </a:ln>
                <a:solidFill>
                  <a:srgbClr val="000066"/>
                </a:solidFill>
                <a:effectLst/>
                <a:latin typeface="Arial" charset="0"/>
              </a:endParaRPr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4183490" y="1936962"/>
            <a:ext cx="433824" cy="365564"/>
            <a:chOff x="4106430" y="4449704"/>
            <a:chExt cx="575354" cy="484825"/>
          </a:xfrm>
        </p:grpSpPr>
        <p:sp>
          <p:nvSpPr>
            <p:cNvPr id="6" name="Oval 5"/>
            <p:cNvSpPr/>
            <p:nvPr/>
          </p:nvSpPr>
          <p:spPr>
            <a:xfrm>
              <a:off x="4154857" y="4449704"/>
              <a:ext cx="487836" cy="484825"/>
            </a:xfrm>
            <a:prstGeom prst="ellipse">
              <a:avLst/>
            </a:prstGeom>
            <a:noFill/>
            <a:ln w="57150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9" name="Arc 8"/>
            <p:cNvSpPr/>
            <p:nvPr/>
          </p:nvSpPr>
          <p:spPr>
            <a:xfrm>
              <a:off x="4106430" y="4449704"/>
              <a:ext cx="536263" cy="347448"/>
            </a:xfrm>
            <a:prstGeom prst="arc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54" name="Arc 353"/>
            <p:cNvSpPr/>
            <p:nvPr/>
          </p:nvSpPr>
          <p:spPr>
            <a:xfrm flipH="1">
              <a:off x="4174184" y="4452078"/>
              <a:ext cx="507600" cy="265820"/>
            </a:xfrm>
            <a:prstGeom prst="arc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101" name="Isosceles Triangle 100"/>
          <p:cNvSpPr/>
          <p:nvPr/>
        </p:nvSpPr>
        <p:spPr>
          <a:xfrm rot="12436484">
            <a:off x="4190457" y="1893522"/>
            <a:ext cx="62011" cy="93836"/>
          </a:xfrm>
          <a:prstGeom prst="triangle">
            <a:avLst/>
          </a:prstGeom>
          <a:solidFill>
            <a:schemeClr val="tx1"/>
          </a:solidFill>
          <a:ln>
            <a:noFill/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73" name="Isosceles Triangle 472"/>
          <p:cNvSpPr/>
          <p:nvPr/>
        </p:nvSpPr>
        <p:spPr>
          <a:xfrm rot="8793214">
            <a:off x="4579705" y="1899014"/>
            <a:ext cx="62011" cy="93836"/>
          </a:xfrm>
          <a:prstGeom prst="triangle">
            <a:avLst/>
          </a:prstGeom>
          <a:solidFill>
            <a:schemeClr val="tx1"/>
          </a:solidFill>
          <a:ln>
            <a:noFill/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476" name="Group 475"/>
          <p:cNvGrpSpPr/>
          <p:nvPr/>
        </p:nvGrpSpPr>
        <p:grpSpPr>
          <a:xfrm>
            <a:off x="4183490" y="2532538"/>
            <a:ext cx="433824" cy="365564"/>
            <a:chOff x="4106430" y="4449704"/>
            <a:chExt cx="575354" cy="484825"/>
          </a:xfrm>
        </p:grpSpPr>
        <p:sp>
          <p:nvSpPr>
            <p:cNvPr id="480" name="Oval 479"/>
            <p:cNvSpPr/>
            <p:nvPr/>
          </p:nvSpPr>
          <p:spPr>
            <a:xfrm>
              <a:off x="4154857" y="4449704"/>
              <a:ext cx="487836" cy="484825"/>
            </a:xfrm>
            <a:prstGeom prst="ellipse">
              <a:avLst/>
            </a:prstGeom>
            <a:noFill/>
            <a:ln w="57150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81" name="Arc 480"/>
            <p:cNvSpPr/>
            <p:nvPr/>
          </p:nvSpPr>
          <p:spPr>
            <a:xfrm>
              <a:off x="4106430" y="4449704"/>
              <a:ext cx="536263" cy="347448"/>
            </a:xfrm>
            <a:prstGeom prst="arc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87" name="Arc 486"/>
            <p:cNvSpPr/>
            <p:nvPr/>
          </p:nvSpPr>
          <p:spPr>
            <a:xfrm flipH="1">
              <a:off x="4174184" y="4452078"/>
              <a:ext cx="507600" cy="265820"/>
            </a:xfrm>
            <a:prstGeom prst="arc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488" name="Isosceles Triangle 487"/>
          <p:cNvSpPr/>
          <p:nvPr/>
        </p:nvSpPr>
        <p:spPr>
          <a:xfrm rot="12436484">
            <a:off x="4190457" y="2489098"/>
            <a:ext cx="62011" cy="93836"/>
          </a:xfrm>
          <a:prstGeom prst="triangle">
            <a:avLst/>
          </a:prstGeom>
          <a:solidFill>
            <a:schemeClr val="tx1"/>
          </a:solidFill>
          <a:ln>
            <a:noFill/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89" name="Isosceles Triangle 488"/>
          <p:cNvSpPr/>
          <p:nvPr/>
        </p:nvSpPr>
        <p:spPr>
          <a:xfrm rot="8793214">
            <a:off x="4579705" y="2494590"/>
            <a:ext cx="62011" cy="93836"/>
          </a:xfrm>
          <a:prstGeom prst="triangle">
            <a:avLst/>
          </a:prstGeom>
          <a:solidFill>
            <a:schemeClr val="tx1"/>
          </a:solidFill>
          <a:ln>
            <a:noFill/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490" name="Group 489"/>
          <p:cNvGrpSpPr/>
          <p:nvPr/>
        </p:nvGrpSpPr>
        <p:grpSpPr>
          <a:xfrm>
            <a:off x="4206898" y="3108602"/>
            <a:ext cx="433824" cy="365564"/>
            <a:chOff x="4106430" y="4449704"/>
            <a:chExt cx="575354" cy="484825"/>
          </a:xfrm>
        </p:grpSpPr>
        <p:sp>
          <p:nvSpPr>
            <p:cNvPr id="491" name="Oval 490"/>
            <p:cNvSpPr/>
            <p:nvPr/>
          </p:nvSpPr>
          <p:spPr>
            <a:xfrm>
              <a:off x="4154857" y="4449704"/>
              <a:ext cx="487836" cy="484825"/>
            </a:xfrm>
            <a:prstGeom prst="ellipse">
              <a:avLst/>
            </a:prstGeom>
            <a:noFill/>
            <a:ln w="57150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14" name="Arc 513"/>
            <p:cNvSpPr/>
            <p:nvPr/>
          </p:nvSpPr>
          <p:spPr>
            <a:xfrm>
              <a:off x="4106430" y="4449704"/>
              <a:ext cx="536263" cy="347448"/>
            </a:xfrm>
            <a:prstGeom prst="arc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28" name="Arc 527"/>
            <p:cNvSpPr/>
            <p:nvPr/>
          </p:nvSpPr>
          <p:spPr>
            <a:xfrm flipH="1">
              <a:off x="4174184" y="4452078"/>
              <a:ext cx="507600" cy="265820"/>
            </a:xfrm>
            <a:prstGeom prst="arc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529" name="Isosceles Triangle 528"/>
          <p:cNvSpPr/>
          <p:nvPr/>
        </p:nvSpPr>
        <p:spPr>
          <a:xfrm rot="12436484">
            <a:off x="4213865" y="3065162"/>
            <a:ext cx="62011" cy="93836"/>
          </a:xfrm>
          <a:prstGeom prst="triangle">
            <a:avLst/>
          </a:prstGeom>
          <a:solidFill>
            <a:schemeClr val="tx1"/>
          </a:solidFill>
          <a:ln>
            <a:noFill/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30" name="Isosceles Triangle 529"/>
          <p:cNvSpPr/>
          <p:nvPr/>
        </p:nvSpPr>
        <p:spPr>
          <a:xfrm rot="8793214">
            <a:off x="4603113" y="3070654"/>
            <a:ext cx="62011" cy="93836"/>
          </a:xfrm>
          <a:prstGeom prst="triangle">
            <a:avLst/>
          </a:prstGeom>
          <a:solidFill>
            <a:schemeClr val="tx1"/>
          </a:solidFill>
          <a:ln>
            <a:noFill/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531" name="Group 530"/>
          <p:cNvGrpSpPr/>
          <p:nvPr/>
        </p:nvGrpSpPr>
        <p:grpSpPr>
          <a:xfrm>
            <a:off x="4206898" y="3684666"/>
            <a:ext cx="433824" cy="365564"/>
            <a:chOff x="4106430" y="4449704"/>
            <a:chExt cx="575354" cy="484825"/>
          </a:xfrm>
        </p:grpSpPr>
        <p:sp>
          <p:nvSpPr>
            <p:cNvPr id="532" name="Oval 531"/>
            <p:cNvSpPr/>
            <p:nvPr/>
          </p:nvSpPr>
          <p:spPr>
            <a:xfrm>
              <a:off x="4154857" y="4449704"/>
              <a:ext cx="487836" cy="484825"/>
            </a:xfrm>
            <a:prstGeom prst="ellipse">
              <a:avLst/>
            </a:prstGeom>
            <a:noFill/>
            <a:ln w="57150"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33" name="Arc 532"/>
            <p:cNvSpPr/>
            <p:nvPr/>
          </p:nvSpPr>
          <p:spPr>
            <a:xfrm>
              <a:off x="4106430" y="4449704"/>
              <a:ext cx="536263" cy="347448"/>
            </a:xfrm>
            <a:prstGeom prst="arc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34" name="Arc 533"/>
            <p:cNvSpPr/>
            <p:nvPr/>
          </p:nvSpPr>
          <p:spPr>
            <a:xfrm flipH="1">
              <a:off x="4174184" y="4452078"/>
              <a:ext cx="507600" cy="265820"/>
            </a:xfrm>
            <a:prstGeom prst="arc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535" name="Isosceles Triangle 534"/>
          <p:cNvSpPr/>
          <p:nvPr/>
        </p:nvSpPr>
        <p:spPr>
          <a:xfrm rot="12436484">
            <a:off x="4213865" y="3641226"/>
            <a:ext cx="62011" cy="93836"/>
          </a:xfrm>
          <a:prstGeom prst="triangle">
            <a:avLst/>
          </a:prstGeom>
          <a:solidFill>
            <a:schemeClr val="tx1"/>
          </a:solidFill>
          <a:ln>
            <a:noFill/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36" name="Isosceles Triangle 535"/>
          <p:cNvSpPr/>
          <p:nvPr/>
        </p:nvSpPr>
        <p:spPr>
          <a:xfrm rot="8793214">
            <a:off x="4603113" y="3646718"/>
            <a:ext cx="62011" cy="93836"/>
          </a:xfrm>
          <a:prstGeom prst="triangle">
            <a:avLst/>
          </a:prstGeom>
          <a:solidFill>
            <a:schemeClr val="tx1"/>
          </a:solidFill>
          <a:ln>
            <a:noFill/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07" name="Group 106"/>
          <p:cNvGrpSpPr/>
          <p:nvPr/>
        </p:nvGrpSpPr>
        <p:grpSpPr>
          <a:xfrm>
            <a:off x="5744043" y="2129350"/>
            <a:ext cx="1188000" cy="0"/>
            <a:chOff x="5580112" y="4642866"/>
            <a:chExt cx="1388012" cy="0"/>
          </a:xfrm>
        </p:grpSpPr>
        <p:cxnSp>
          <p:nvCxnSpPr>
            <p:cNvPr id="538" name="Straight Connector 537"/>
            <p:cNvCxnSpPr/>
            <p:nvPr/>
          </p:nvCxnSpPr>
          <p:spPr>
            <a:xfrm>
              <a:off x="5580112" y="4642866"/>
              <a:ext cx="1388012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Straight Connector 105"/>
            <p:cNvCxnSpPr/>
            <p:nvPr/>
          </p:nvCxnSpPr>
          <p:spPr>
            <a:xfrm>
              <a:off x="5796136" y="4642866"/>
              <a:ext cx="972000" cy="0"/>
            </a:xfrm>
            <a:prstGeom prst="line">
              <a:avLst/>
            </a:prstGeom>
            <a:ln w="57150">
              <a:solidFill>
                <a:srgbClr val="92D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39" name="Group 538"/>
          <p:cNvGrpSpPr/>
          <p:nvPr/>
        </p:nvGrpSpPr>
        <p:grpSpPr>
          <a:xfrm>
            <a:off x="5744043" y="2220185"/>
            <a:ext cx="1188000" cy="0"/>
            <a:chOff x="5580112" y="4642866"/>
            <a:chExt cx="1388012" cy="0"/>
          </a:xfrm>
        </p:grpSpPr>
        <p:cxnSp>
          <p:nvCxnSpPr>
            <p:cNvPr id="540" name="Straight Connector 539"/>
            <p:cNvCxnSpPr/>
            <p:nvPr/>
          </p:nvCxnSpPr>
          <p:spPr>
            <a:xfrm>
              <a:off x="5580112" y="4642866"/>
              <a:ext cx="1388012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1" name="Straight Connector 540"/>
            <p:cNvCxnSpPr/>
            <p:nvPr/>
          </p:nvCxnSpPr>
          <p:spPr>
            <a:xfrm>
              <a:off x="5796136" y="4642866"/>
              <a:ext cx="972000" cy="0"/>
            </a:xfrm>
            <a:prstGeom prst="line">
              <a:avLst/>
            </a:prstGeom>
            <a:ln w="57150">
              <a:solidFill>
                <a:srgbClr val="92D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42" name="Group 541"/>
          <p:cNvGrpSpPr/>
          <p:nvPr/>
        </p:nvGrpSpPr>
        <p:grpSpPr>
          <a:xfrm>
            <a:off x="5744043" y="2322038"/>
            <a:ext cx="1188000" cy="0"/>
            <a:chOff x="5580112" y="4642866"/>
            <a:chExt cx="1388012" cy="0"/>
          </a:xfrm>
        </p:grpSpPr>
        <p:cxnSp>
          <p:nvCxnSpPr>
            <p:cNvPr id="543" name="Straight Connector 542"/>
            <p:cNvCxnSpPr/>
            <p:nvPr/>
          </p:nvCxnSpPr>
          <p:spPr>
            <a:xfrm>
              <a:off x="5580112" y="4642866"/>
              <a:ext cx="1388012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4" name="Straight Connector 543"/>
            <p:cNvCxnSpPr/>
            <p:nvPr/>
          </p:nvCxnSpPr>
          <p:spPr>
            <a:xfrm>
              <a:off x="5796136" y="4642866"/>
              <a:ext cx="972000" cy="0"/>
            </a:xfrm>
            <a:prstGeom prst="line">
              <a:avLst/>
            </a:prstGeom>
            <a:ln w="57150">
              <a:solidFill>
                <a:srgbClr val="92D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54" name="Group 553"/>
          <p:cNvGrpSpPr/>
          <p:nvPr/>
        </p:nvGrpSpPr>
        <p:grpSpPr>
          <a:xfrm>
            <a:off x="5744043" y="3120105"/>
            <a:ext cx="1188000" cy="0"/>
            <a:chOff x="5580112" y="4642866"/>
            <a:chExt cx="1388012" cy="0"/>
          </a:xfrm>
        </p:grpSpPr>
        <p:cxnSp>
          <p:nvCxnSpPr>
            <p:cNvPr id="555" name="Straight Connector 554"/>
            <p:cNvCxnSpPr/>
            <p:nvPr/>
          </p:nvCxnSpPr>
          <p:spPr>
            <a:xfrm>
              <a:off x="5580112" y="4642866"/>
              <a:ext cx="1388012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6" name="Straight Connector 555"/>
            <p:cNvCxnSpPr/>
            <p:nvPr/>
          </p:nvCxnSpPr>
          <p:spPr>
            <a:xfrm>
              <a:off x="5796136" y="4642866"/>
              <a:ext cx="972000" cy="0"/>
            </a:xfrm>
            <a:prstGeom prst="line">
              <a:avLst/>
            </a:prstGeom>
            <a:ln w="57150">
              <a:solidFill>
                <a:srgbClr val="92D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57" name="Group 556"/>
          <p:cNvGrpSpPr/>
          <p:nvPr/>
        </p:nvGrpSpPr>
        <p:grpSpPr>
          <a:xfrm>
            <a:off x="5744043" y="3210940"/>
            <a:ext cx="1188000" cy="0"/>
            <a:chOff x="5580112" y="4642866"/>
            <a:chExt cx="1388012" cy="0"/>
          </a:xfrm>
        </p:grpSpPr>
        <p:cxnSp>
          <p:nvCxnSpPr>
            <p:cNvPr id="558" name="Straight Connector 557"/>
            <p:cNvCxnSpPr/>
            <p:nvPr/>
          </p:nvCxnSpPr>
          <p:spPr>
            <a:xfrm>
              <a:off x="5580112" y="4642866"/>
              <a:ext cx="1388012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9" name="Straight Connector 558"/>
            <p:cNvCxnSpPr/>
            <p:nvPr/>
          </p:nvCxnSpPr>
          <p:spPr>
            <a:xfrm>
              <a:off x="5796136" y="4642866"/>
              <a:ext cx="972000" cy="0"/>
            </a:xfrm>
            <a:prstGeom prst="line">
              <a:avLst/>
            </a:prstGeom>
            <a:ln w="57150">
              <a:solidFill>
                <a:srgbClr val="92D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60" name="Group 559"/>
          <p:cNvGrpSpPr/>
          <p:nvPr/>
        </p:nvGrpSpPr>
        <p:grpSpPr>
          <a:xfrm>
            <a:off x="5744043" y="3301776"/>
            <a:ext cx="1188000" cy="0"/>
            <a:chOff x="5580112" y="4642866"/>
            <a:chExt cx="1388012" cy="0"/>
          </a:xfrm>
        </p:grpSpPr>
        <p:cxnSp>
          <p:nvCxnSpPr>
            <p:cNvPr id="561" name="Straight Connector 560"/>
            <p:cNvCxnSpPr/>
            <p:nvPr/>
          </p:nvCxnSpPr>
          <p:spPr>
            <a:xfrm>
              <a:off x="5580112" y="4642866"/>
              <a:ext cx="1388012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2" name="Straight Connector 561"/>
            <p:cNvCxnSpPr/>
            <p:nvPr/>
          </p:nvCxnSpPr>
          <p:spPr>
            <a:xfrm>
              <a:off x="5796136" y="4642866"/>
              <a:ext cx="972000" cy="0"/>
            </a:xfrm>
            <a:prstGeom prst="line">
              <a:avLst/>
            </a:prstGeom>
            <a:ln w="57150">
              <a:solidFill>
                <a:srgbClr val="92D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66" name="Group 565"/>
          <p:cNvGrpSpPr/>
          <p:nvPr/>
        </p:nvGrpSpPr>
        <p:grpSpPr>
          <a:xfrm>
            <a:off x="5744043" y="2621087"/>
            <a:ext cx="1188000" cy="0"/>
            <a:chOff x="5580112" y="4642866"/>
            <a:chExt cx="1388012" cy="0"/>
          </a:xfrm>
        </p:grpSpPr>
        <p:cxnSp>
          <p:nvCxnSpPr>
            <p:cNvPr id="567" name="Straight Connector 566"/>
            <p:cNvCxnSpPr/>
            <p:nvPr/>
          </p:nvCxnSpPr>
          <p:spPr>
            <a:xfrm>
              <a:off x="5580112" y="4642866"/>
              <a:ext cx="1388012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8" name="Straight Connector 567"/>
            <p:cNvCxnSpPr/>
            <p:nvPr/>
          </p:nvCxnSpPr>
          <p:spPr>
            <a:xfrm>
              <a:off x="5796136" y="4642866"/>
              <a:ext cx="972000" cy="0"/>
            </a:xfrm>
            <a:prstGeom prst="line">
              <a:avLst/>
            </a:prstGeom>
            <a:ln w="57150">
              <a:solidFill>
                <a:srgbClr val="92D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69" name="Group 568"/>
          <p:cNvGrpSpPr/>
          <p:nvPr/>
        </p:nvGrpSpPr>
        <p:grpSpPr>
          <a:xfrm>
            <a:off x="5744043" y="2711922"/>
            <a:ext cx="1188000" cy="0"/>
            <a:chOff x="5580112" y="4642866"/>
            <a:chExt cx="1388012" cy="0"/>
          </a:xfrm>
        </p:grpSpPr>
        <p:cxnSp>
          <p:nvCxnSpPr>
            <p:cNvPr id="570" name="Straight Connector 569"/>
            <p:cNvCxnSpPr/>
            <p:nvPr/>
          </p:nvCxnSpPr>
          <p:spPr>
            <a:xfrm>
              <a:off x="5580112" y="4642866"/>
              <a:ext cx="1388012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1" name="Straight Connector 570"/>
            <p:cNvCxnSpPr/>
            <p:nvPr/>
          </p:nvCxnSpPr>
          <p:spPr>
            <a:xfrm>
              <a:off x="5796136" y="4642866"/>
              <a:ext cx="972000" cy="0"/>
            </a:xfrm>
            <a:prstGeom prst="line">
              <a:avLst/>
            </a:prstGeom>
            <a:ln w="57150">
              <a:solidFill>
                <a:srgbClr val="92D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72" name="Group 571"/>
          <p:cNvGrpSpPr/>
          <p:nvPr/>
        </p:nvGrpSpPr>
        <p:grpSpPr>
          <a:xfrm>
            <a:off x="5744043" y="2802758"/>
            <a:ext cx="1188000" cy="0"/>
            <a:chOff x="5580112" y="4642866"/>
            <a:chExt cx="1388012" cy="0"/>
          </a:xfrm>
        </p:grpSpPr>
        <p:cxnSp>
          <p:nvCxnSpPr>
            <p:cNvPr id="573" name="Straight Connector 572"/>
            <p:cNvCxnSpPr/>
            <p:nvPr/>
          </p:nvCxnSpPr>
          <p:spPr>
            <a:xfrm>
              <a:off x="5580112" y="4642866"/>
              <a:ext cx="1388012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4" name="Straight Connector 573"/>
            <p:cNvCxnSpPr/>
            <p:nvPr/>
          </p:nvCxnSpPr>
          <p:spPr>
            <a:xfrm>
              <a:off x="5796136" y="4642866"/>
              <a:ext cx="972000" cy="0"/>
            </a:xfrm>
            <a:prstGeom prst="line">
              <a:avLst/>
            </a:prstGeom>
            <a:ln w="57150">
              <a:solidFill>
                <a:srgbClr val="92D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75" name="Group 574"/>
          <p:cNvGrpSpPr/>
          <p:nvPr/>
        </p:nvGrpSpPr>
        <p:grpSpPr>
          <a:xfrm>
            <a:off x="5744043" y="3622859"/>
            <a:ext cx="1080000" cy="0"/>
            <a:chOff x="5580112" y="4642866"/>
            <a:chExt cx="1388012" cy="0"/>
          </a:xfrm>
        </p:grpSpPr>
        <p:cxnSp>
          <p:nvCxnSpPr>
            <p:cNvPr id="576" name="Straight Connector 575"/>
            <p:cNvCxnSpPr/>
            <p:nvPr/>
          </p:nvCxnSpPr>
          <p:spPr>
            <a:xfrm>
              <a:off x="5580112" y="4642866"/>
              <a:ext cx="1388012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7" name="Straight Connector 576"/>
            <p:cNvCxnSpPr/>
            <p:nvPr/>
          </p:nvCxnSpPr>
          <p:spPr>
            <a:xfrm>
              <a:off x="5796136" y="4642866"/>
              <a:ext cx="972000" cy="0"/>
            </a:xfrm>
            <a:prstGeom prst="line">
              <a:avLst/>
            </a:prstGeom>
            <a:ln w="57150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78" name="Group 577"/>
          <p:cNvGrpSpPr/>
          <p:nvPr/>
        </p:nvGrpSpPr>
        <p:grpSpPr>
          <a:xfrm>
            <a:off x="5744043" y="3713694"/>
            <a:ext cx="1080000" cy="0"/>
            <a:chOff x="5580112" y="4642866"/>
            <a:chExt cx="1388012" cy="0"/>
          </a:xfrm>
        </p:grpSpPr>
        <p:cxnSp>
          <p:nvCxnSpPr>
            <p:cNvPr id="579" name="Straight Connector 578"/>
            <p:cNvCxnSpPr/>
            <p:nvPr/>
          </p:nvCxnSpPr>
          <p:spPr>
            <a:xfrm>
              <a:off x="5580112" y="4642866"/>
              <a:ext cx="1388012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0" name="Straight Connector 579"/>
            <p:cNvCxnSpPr/>
            <p:nvPr/>
          </p:nvCxnSpPr>
          <p:spPr>
            <a:xfrm>
              <a:off x="5796136" y="4642866"/>
              <a:ext cx="972000" cy="0"/>
            </a:xfrm>
            <a:prstGeom prst="line">
              <a:avLst/>
            </a:prstGeom>
            <a:ln w="57150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582" name="Straight Connector 581"/>
          <p:cNvCxnSpPr/>
          <p:nvPr/>
        </p:nvCxnSpPr>
        <p:spPr>
          <a:xfrm>
            <a:off x="5744043" y="3804530"/>
            <a:ext cx="1080000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3" name="Straight Connector 582"/>
          <p:cNvCxnSpPr/>
          <p:nvPr/>
        </p:nvCxnSpPr>
        <p:spPr>
          <a:xfrm>
            <a:off x="5912129" y="3804530"/>
            <a:ext cx="756305" cy="0"/>
          </a:xfrm>
          <a:prstGeom prst="line">
            <a:avLst/>
          </a:prstGeom>
          <a:ln w="5715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84" name="Group 583"/>
          <p:cNvGrpSpPr/>
          <p:nvPr/>
        </p:nvGrpSpPr>
        <p:grpSpPr>
          <a:xfrm>
            <a:off x="5744043" y="3885048"/>
            <a:ext cx="1080000" cy="0"/>
            <a:chOff x="5580112" y="4642866"/>
            <a:chExt cx="1388012" cy="0"/>
          </a:xfrm>
        </p:grpSpPr>
        <p:cxnSp>
          <p:nvCxnSpPr>
            <p:cNvPr id="585" name="Straight Connector 584"/>
            <p:cNvCxnSpPr/>
            <p:nvPr/>
          </p:nvCxnSpPr>
          <p:spPr>
            <a:xfrm>
              <a:off x="5580112" y="4642866"/>
              <a:ext cx="1388012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6" name="Straight Connector 585"/>
            <p:cNvCxnSpPr/>
            <p:nvPr/>
          </p:nvCxnSpPr>
          <p:spPr>
            <a:xfrm>
              <a:off x="5796136" y="4642866"/>
              <a:ext cx="972000" cy="0"/>
            </a:xfrm>
            <a:prstGeom prst="line">
              <a:avLst/>
            </a:prstGeom>
            <a:ln w="57150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87" name="Group 586"/>
          <p:cNvGrpSpPr/>
          <p:nvPr/>
        </p:nvGrpSpPr>
        <p:grpSpPr>
          <a:xfrm>
            <a:off x="5744043" y="3975883"/>
            <a:ext cx="1080000" cy="0"/>
            <a:chOff x="5580112" y="4642866"/>
            <a:chExt cx="1388012" cy="0"/>
          </a:xfrm>
        </p:grpSpPr>
        <p:cxnSp>
          <p:nvCxnSpPr>
            <p:cNvPr id="588" name="Straight Connector 587"/>
            <p:cNvCxnSpPr/>
            <p:nvPr/>
          </p:nvCxnSpPr>
          <p:spPr>
            <a:xfrm>
              <a:off x="5580112" y="4642866"/>
              <a:ext cx="1388012" cy="0"/>
            </a:xfrm>
            <a:prstGeom prst="line">
              <a:avLst/>
            </a:prstGeom>
            <a:ln w="571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9" name="Straight Connector 588"/>
            <p:cNvCxnSpPr/>
            <p:nvPr/>
          </p:nvCxnSpPr>
          <p:spPr>
            <a:xfrm>
              <a:off x="5796136" y="4642866"/>
              <a:ext cx="972000" cy="0"/>
            </a:xfrm>
            <a:prstGeom prst="line">
              <a:avLst/>
            </a:prstGeom>
            <a:ln w="57150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590" name="Straight Connector 589"/>
          <p:cNvCxnSpPr/>
          <p:nvPr/>
        </p:nvCxnSpPr>
        <p:spPr>
          <a:xfrm>
            <a:off x="5744043" y="4066719"/>
            <a:ext cx="1080000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1" name="Straight Connector 590"/>
          <p:cNvCxnSpPr/>
          <p:nvPr/>
        </p:nvCxnSpPr>
        <p:spPr>
          <a:xfrm>
            <a:off x="5912129" y="4066719"/>
            <a:ext cx="756305" cy="0"/>
          </a:xfrm>
          <a:prstGeom prst="line">
            <a:avLst/>
          </a:prstGeom>
          <a:ln w="5715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2" name="Rectangle 97"/>
          <p:cNvSpPr>
            <a:spLocks noChangeArrowheads="1"/>
          </p:cNvSpPr>
          <p:nvPr/>
        </p:nvSpPr>
        <p:spPr bwMode="auto">
          <a:xfrm>
            <a:off x="3960776" y="1529295"/>
            <a:ext cx="112871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kumimoji="0" lang="en-GB" altLang="ja-JP" sz="1400" b="1" dirty="0" smtClean="0">
                <a:latin typeface="Calibri" pitchFamily="127" charset="0"/>
              </a:rPr>
              <a:t>Inverse PCR</a:t>
            </a:r>
          </a:p>
        </p:txBody>
      </p:sp>
      <p:sp>
        <p:nvSpPr>
          <p:cNvPr id="118" name="Rectangle 117"/>
          <p:cNvSpPr/>
          <p:nvPr/>
        </p:nvSpPr>
        <p:spPr>
          <a:xfrm>
            <a:off x="1339255" y="2172328"/>
            <a:ext cx="7199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 smtClean="0">
                <a:solidFill>
                  <a:schemeClr val="accent1"/>
                </a:solidFill>
                <a:latin typeface="Calibri" pitchFamily="127" charset="0"/>
              </a:rPr>
              <a:t>2</a:t>
            </a:r>
            <a:r>
              <a:rPr lang="en-US" altLang="ja-JP" sz="1400" b="1" baseline="30000" dirty="0" smtClean="0">
                <a:solidFill>
                  <a:schemeClr val="accent1"/>
                </a:solidFill>
                <a:latin typeface="Calibri" pitchFamily="127" charset="0"/>
              </a:rPr>
              <a:t>nd</a:t>
            </a:r>
            <a:r>
              <a:rPr lang="en-US" altLang="ja-JP" sz="1400" b="1" dirty="0" smtClean="0">
                <a:solidFill>
                  <a:schemeClr val="accent1"/>
                </a:solidFill>
                <a:latin typeface="Calibri" pitchFamily="127" charset="0"/>
              </a:rPr>
              <a:t> RE</a:t>
            </a:r>
            <a:endParaRPr lang="en-US" altLang="ja-JP" sz="1400" b="1" dirty="0">
              <a:solidFill>
                <a:schemeClr val="accent1"/>
              </a:solidFill>
              <a:latin typeface="Calibri" pitchFamily="127" charset="0"/>
            </a:endParaRPr>
          </a:p>
        </p:txBody>
      </p:sp>
      <p:sp>
        <p:nvSpPr>
          <p:cNvPr id="595" name="Right Bracket 594"/>
          <p:cNvSpPr/>
          <p:nvPr/>
        </p:nvSpPr>
        <p:spPr bwMode="auto">
          <a:xfrm>
            <a:off x="7155326" y="2148410"/>
            <a:ext cx="147280" cy="1211493"/>
          </a:xfrm>
          <a:prstGeom prst="righ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596" name="Rectangle 97"/>
          <p:cNvSpPr>
            <a:spLocks noChangeArrowheads="1"/>
          </p:cNvSpPr>
          <p:nvPr/>
        </p:nvSpPr>
        <p:spPr bwMode="auto">
          <a:xfrm>
            <a:off x="7432397" y="2546043"/>
            <a:ext cx="1563847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kumimoji="0" lang="en-GB" altLang="ja-JP" sz="1600" b="1" dirty="0" smtClean="0">
                <a:solidFill>
                  <a:srgbClr val="002060"/>
                </a:solidFill>
                <a:latin typeface="Calibri" pitchFamily="127" charset="0"/>
              </a:rPr>
              <a:t>1 or more</a:t>
            </a:r>
            <a:endParaRPr kumimoji="0" lang="en-GB" altLang="ja-JP" sz="1600" b="1" dirty="0">
              <a:solidFill>
                <a:srgbClr val="002060"/>
              </a:solidFill>
              <a:latin typeface="Calibri" pitchFamily="127" charset="0"/>
            </a:endParaRPr>
          </a:p>
        </p:txBody>
      </p:sp>
      <p:sp>
        <p:nvSpPr>
          <p:cNvPr id="597" name="Rectangle 97"/>
          <p:cNvSpPr>
            <a:spLocks noChangeArrowheads="1"/>
          </p:cNvSpPr>
          <p:nvPr/>
        </p:nvSpPr>
        <p:spPr bwMode="auto">
          <a:xfrm>
            <a:off x="7432397" y="3632233"/>
            <a:ext cx="1563847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kumimoji="0" lang="en-GB" altLang="ja-JP" sz="1600" b="1" dirty="0" smtClean="0">
                <a:solidFill>
                  <a:srgbClr val="002060"/>
                </a:solidFill>
                <a:latin typeface="Calibri" pitchFamily="127" charset="0"/>
              </a:rPr>
              <a:t>1 or more</a:t>
            </a:r>
            <a:endParaRPr kumimoji="0" lang="en-GB" altLang="ja-JP" sz="1600" b="1" dirty="0">
              <a:solidFill>
                <a:srgbClr val="002060"/>
              </a:solidFill>
              <a:latin typeface="Calibri" pitchFamily="127" charset="0"/>
            </a:endParaRPr>
          </a:p>
        </p:txBody>
      </p:sp>
      <p:sp>
        <p:nvSpPr>
          <p:cNvPr id="598" name="Right Bracket 597"/>
          <p:cNvSpPr/>
          <p:nvPr/>
        </p:nvSpPr>
        <p:spPr bwMode="auto">
          <a:xfrm>
            <a:off x="7166478" y="3535161"/>
            <a:ext cx="136128" cy="569943"/>
          </a:xfrm>
          <a:prstGeom prst="righ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GB"/>
          </a:p>
        </p:txBody>
      </p:sp>
      <p:sp>
        <p:nvSpPr>
          <p:cNvPr id="265" name="Rectangle 264"/>
          <p:cNvSpPr/>
          <p:nvPr/>
        </p:nvSpPr>
        <p:spPr>
          <a:xfrm>
            <a:off x="721199" y="612815"/>
            <a:ext cx="61805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 smtClean="0">
                <a:latin typeface="Calibri" pitchFamily="127" charset="0"/>
              </a:rPr>
              <a:t>1</a:t>
            </a:r>
            <a:r>
              <a:rPr lang="en-US" altLang="ja-JP" sz="1400" b="1" baseline="30000" dirty="0" smtClean="0">
                <a:latin typeface="Calibri" pitchFamily="127" charset="0"/>
              </a:rPr>
              <a:t>st</a:t>
            </a:r>
            <a:r>
              <a:rPr lang="en-US" altLang="ja-JP" sz="1400" b="1" dirty="0" smtClean="0">
                <a:latin typeface="Calibri" pitchFamily="127" charset="0"/>
              </a:rPr>
              <a:t> RE</a:t>
            </a:r>
            <a:endParaRPr lang="en-US" altLang="ja-JP" sz="1400" b="1" dirty="0">
              <a:latin typeface="Calibri" pitchFamily="127" charset="0"/>
            </a:endParaRPr>
          </a:p>
        </p:txBody>
      </p:sp>
      <p:cxnSp>
        <p:nvCxnSpPr>
          <p:cNvPr id="270" name="Straight Arrow Connector 269"/>
          <p:cNvCxnSpPr/>
          <p:nvPr/>
        </p:nvCxnSpPr>
        <p:spPr>
          <a:xfrm>
            <a:off x="3004329" y="3272111"/>
            <a:ext cx="473789" cy="0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7" name="Rectangle 97"/>
          <p:cNvSpPr>
            <a:spLocks noChangeArrowheads="1"/>
          </p:cNvSpPr>
          <p:nvPr/>
        </p:nvSpPr>
        <p:spPr bwMode="auto">
          <a:xfrm>
            <a:off x="5051132" y="6347708"/>
            <a:ext cx="112871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kumimoji="0" lang="en-GB" altLang="ja-JP" sz="1400" b="1" dirty="0" smtClean="0">
                <a:solidFill>
                  <a:srgbClr val="00B0F0"/>
                </a:solidFill>
                <a:latin typeface="Calibri" pitchFamily="127" charset="0"/>
              </a:rPr>
              <a:t>linker</a:t>
            </a:r>
            <a:endParaRPr kumimoji="0" lang="en-GB" altLang="ja-JP" sz="1400" b="1" dirty="0" smtClean="0">
              <a:solidFill>
                <a:srgbClr val="00B0F0"/>
              </a:solidFill>
              <a:latin typeface="Calibri" pitchFamily="127" charset="0"/>
            </a:endParaRPr>
          </a:p>
        </p:txBody>
      </p:sp>
      <p:cxnSp>
        <p:nvCxnSpPr>
          <p:cNvPr id="304" name="Straight Arrow Connector 303"/>
          <p:cNvCxnSpPr/>
          <p:nvPr/>
        </p:nvCxnSpPr>
        <p:spPr>
          <a:xfrm>
            <a:off x="3004329" y="5547033"/>
            <a:ext cx="277057" cy="0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6" name="Title 1"/>
          <p:cNvSpPr txBox="1">
            <a:spLocks/>
          </p:cNvSpPr>
          <p:nvPr/>
        </p:nvSpPr>
        <p:spPr bwMode="auto">
          <a:xfrm>
            <a:off x="3620108" y="286477"/>
            <a:ext cx="1639718" cy="6285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rtl="0" fontAlgn="base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ＭＳ Ｐゴシック" pitchFamily="127" charset="-128"/>
                <a:cs typeface="ＭＳ Ｐゴシック" pitchFamily="127" charset="-128"/>
              </a:defRPr>
            </a:lvl1pPr>
            <a:lvl2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2pPr>
            <a:lvl3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3pPr>
            <a:lvl4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4pPr>
            <a:lvl5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5pPr>
            <a:lvl6pPr marL="4572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6pPr>
            <a:lvl7pPr marL="9144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7pPr>
            <a:lvl8pPr marL="13716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8pPr>
            <a:lvl9pPr marL="18288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9pPr>
          </a:lstStyle>
          <a:p>
            <a:r>
              <a:rPr kumimoji="0" lang="en-GB" sz="1400" b="1" dirty="0" smtClean="0">
                <a:latin typeface="+mn-lt"/>
              </a:rPr>
              <a:t>1 event</a:t>
            </a:r>
            <a:endParaRPr kumimoji="0" lang="en-GB" sz="1400" b="1" dirty="0">
              <a:latin typeface="+mn-lt"/>
            </a:endParaRPr>
          </a:p>
        </p:txBody>
      </p:sp>
      <p:sp>
        <p:nvSpPr>
          <p:cNvPr id="308" name="Title 1"/>
          <p:cNvSpPr txBox="1">
            <a:spLocks/>
          </p:cNvSpPr>
          <p:nvPr/>
        </p:nvSpPr>
        <p:spPr bwMode="auto">
          <a:xfrm>
            <a:off x="2840301" y="1097255"/>
            <a:ext cx="678085" cy="3374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rtl="0" fontAlgn="base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ＭＳ Ｐゴシック" pitchFamily="127" charset="-128"/>
                <a:cs typeface="ＭＳ Ｐゴシック" pitchFamily="127" charset="-128"/>
              </a:defRPr>
            </a:lvl1pPr>
            <a:lvl2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2pPr>
            <a:lvl3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3pPr>
            <a:lvl4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4pPr>
            <a:lvl5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5pPr>
            <a:lvl6pPr marL="4572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6pPr>
            <a:lvl7pPr marL="9144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7pPr>
            <a:lvl8pPr marL="13716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8pPr>
            <a:lvl9pPr marL="18288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9pPr>
          </a:lstStyle>
          <a:p>
            <a:r>
              <a:rPr kumimoji="0" lang="en-GB" sz="1600" b="1" dirty="0" smtClean="0">
                <a:latin typeface="+mn-lt"/>
              </a:rPr>
              <a:t>I</a:t>
            </a:r>
            <a:endParaRPr kumimoji="0" lang="en-GB" sz="1600" b="1" dirty="0">
              <a:latin typeface="+mn-lt"/>
            </a:endParaRPr>
          </a:p>
        </p:txBody>
      </p:sp>
      <p:sp>
        <p:nvSpPr>
          <p:cNvPr id="309" name="Title 1"/>
          <p:cNvSpPr txBox="1">
            <a:spLocks/>
          </p:cNvSpPr>
          <p:nvPr/>
        </p:nvSpPr>
        <p:spPr bwMode="auto">
          <a:xfrm>
            <a:off x="3656581" y="1097255"/>
            <a:ext cx="678085" cy="3374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rtl="0" fontAlgn="base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ＭＳ Ｐゴシック" pitchFamily="127" charset="-128"/>
                <a:cs typeface="ＭＳ Ｐゴシック" pitchFamily="127" charset="-128"/>
              </a:defRPr>
            </a:lvl1pPr>
            <a:lvl2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2pPr>
            <a:lvl3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3pPr>
            <a:lvl4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4pPr>
            <a:lvl5pPr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5pPr>
            <a:lvl6pPr marL="4572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6pPr>
            <a:lvl7pPr marL="9144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7pPr>
            <a:lvl8pPr marL="13716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8pPr>
            <a:lvl9pPr marL="18288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127" charset="0"/>
                <a:ea typeface="ＭＳ Ｐゴシック" pitchFamily="127" charset="-128"/>
                <a:cs typeface="ＭＳ Ｐゴシック" pitchFamily="127" charset="-128"/>
              </a:defRPr>
            </a:lvl9pPr>
          </a:lstStyle>
          <a:p>
            <a:r>
              <a:rPr kumimoji="0" lang="en-GB" sz="1600" b="1" dirty="0" smtClean="0">
                <a:latin typeface="+mn-lt"/>
              </a:rPr>
              <a:t>II</a:t>
            </a:r>
            <a:endParaRPr kumimoji="0" lang="en-GB" sz="1600" b="1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27323433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52</TotalTime>
  <Words>266</Words>
  <Application>Microsoft Office PowerPoint</Application>
  <PresentationFormat>On-screen Show (4:3)</PresentationFormat>
  <Paragraphs>2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mperial Colleg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guchi, Hiroko</dc:creator>
  <cp:lastModifiedBy>Yaguchi, Hiroko</cp:lastModifiedBy>
  <cp:revision>45</cp:revision>
  <cp:lastPrinted>2018-05-04T15:05:27Z</cp:lastPrinted>
  <dcterms:created xsi:type="dcterms:W3CDTF">2018-04-30T14:22:07Z</dcterms:created>
  <dcterms:modified xsi:type="dcterms:W3CDTF">2018-05-08T11:25:02Z</dcterms:modified>
</cp:coreProperties>
</file>